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0" r:id="rId2"/>
    <p:sldId id="281" r:id="rId3"/>
    <p:sldId id="279" r:id="rId4"/>
    <p:sldId id="261" r:id="rId5"/>
    <p:sldId id="283" r:id="rId6"/>
    <p:sldId id="282" r:id="rId7"/>
    <p:sldId id="284" r:id="rId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756" autoAdjust="0"/>
    <p:restoredTop sz="94660"/>
  </p:normalViewPr>
  <p:slideViewPr>
    <p:cSldViewPr snapToGrid="0">
      <p:cViewPr>
        <p:scale>
          <a:sx n="70" d="100"/>
          <a:sy n="70" d="100"/>
        </p:scale>
        <p:origin x="19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chel Lamerton" userId="2a274aa9-6826-4a05-8322-4d00fae19a96" providerId="ADAL" clId="{FC032B4E-A85A-481D-B6DB-3B866703A0B6}"/>
    <pc:docChg chg="undo custSel addSld delSld modSld">
      <pc:chgData name="Rachel Lamerton" userId="2a274aa9-6826-4a05-8322-4d00fae19a96" providerId="ADAL" clId="{FC032B4E-A85A-481D-B6DB-3B866703A0B6}" dt="2025-08-25T10:55:41.240" v="996" actId="478"/>
      <pc:docMkLst>
        <pc:docMk/>
      </pc:docMkLst>
      <pc:sldChg chg="modSp mod">
        <pc:chgData name="Rachel Lamerton" userId="2a274aa9-6826-4a05-8322-4d00fae19a96" providerId="ADAL" clId="{FC032B4E-A85A-481D-B6DB-3B866703A0B6}" dt="2025-08-22T14:48:22.117" v="4" actId="207"/>
        <pc:sldMkLst>
          <pc:docMk/>
          <pc:sldMk cId="2378476000" sldId="261"/>
        </pc:sldMkLst>
        <pc:spChg chg="mod">
          <ac:chgData name="Rachel Lamerton" userId="2a274aa9-6826-4a05-8322-4d00fae19a96" providerId="ADAL" clId="{FC032B4E-A85A-481D-B6DB-3B866703A0B6}" dt="2025-08-22T14:48:22.117" v="4" actId="207"/>
          <ac:spMkLst>
            <pc:docMk/>
            <pc:sldMk cId="2378476000" sldId="261"/>
            <ac:spMk id="6" creationId="{3181E9BC-317F-4B7F-A7D1-A91EEF30F193}"/>
          </ac:spMkLst>
        </pc:spChg>
      </pc:sldChg>
      <pc:sldChg chg="addSp modSp mod">
        <pc:chgData name="Rachel Lamerton" userId="2a274aa9-6826-4a05-8322-4d00fae19a96" providerId="ADAL" clId="{FC032B4E-A85A-481D-B6DB-3B866703A0B6}" dt="2025-08-22T15:33:15.954" v="8"/>
        <pc:sldMkLst>
          <pc:docMk/>
          <pc:sldMk cId="4237503065" sldId="279"/>
        </pc:sldMkLst>
        <pc:spChg chg="mod">
          <ac:chgData name="Rachel Lamerton" userId="2a274aa9-6826-4a05-8322-4d00fae19a96" providerId="ADAL" clId="{FC032B4E-A85A-481D-B6DB-3B866703A0B6}" dt="2025-08-22T14:48:16.251" v="2" actId="207"/>
          <ac:spMkLst>
            <pc:docMk/>
            <pc:sldMk cId="4237503065" sldId="279"/>
            <ac:spMk id="6" creationId="{C55027F6-7DB0-4AD2-B20C-9B9D06DBF450}"/>
          </ac:spMkLst>
        </pc:spChg>
        <pc:graphicFrameChg chg="add mod">
          <ac:chgData name="Rachel Lamerton" userId="2a274aa9-6826-4a05-8322-4d00fae19a96" providerId="ADAL" clId="{FC032B4E-A85A-481D-B6DB-3B866703A0B6}" dt="2025-08-22T15:33:15.954" v="8"/>
          <ac:graphicFrameMkLst>
            <pc:docMk/>
            <pc:sldMk cId="4237503065" sldId="279"/>
            <ac:graphicFrameMk id="12" creationId="{FD414DAA-65AF-46B1-89B8-37FCCB625738}"/>
          </ac:graphicFrameMkLst>
        </pc:graphicFrameChg>
      </pc:sldChg>
      <pc:sldChg chg="modSp mod">
        <pc:chgData name="Rachel Lamerton" userId="2a274aa9-6826-4a05-8322-4d00fae19a96" providerId="ADAL" clId="{FC032B4E-A85A-481D-B6DB-3B866703A0B6}" dt="2025-08-22T14:48:06.247" v="0" actId="207"/>
        <pc:sldMkLst>
          <pc:docMk/>
          <pc:sldMk cId="3353961404" sldId="281"/>
        </pc:sldMkLst>
        <pc:spChg chg="mod">
          <ac:chgData name="Rachel Lamerton" userId="2a274aa9-6826-4a05-8322-4d00fae19a96" providerId="ADAL" clId="{FC032B4E-A85A-481D-B6DB-3B866703A0B6}" dt="2025-08-22T14:48:06.247" v="0" actId="207"/>
          <ac:spMkLst>
            <pc:docMk/>
            <pc:sldMk cId="3353961404" sldId="281"/>
            <ac:spMk id="5" creationId="{BB88883D-AABF-4114-ADB2-05D716058C5D}"/>
          </ac:spMkLst>
        </pc:spChg>
      </pc:sldChg>
      <pc:sldChg chg="modSp mod">
        <pc:chgData name="Rachel Lamerton" userId="2a274aa9-6826-4a05-8322-4d00fae19a96" providerId="ADAL" clId="{FC032B4E-A85A-481D-B6DB-3B866703A0B6}" dt="2025-08-25T10:18:26.275" v="10" actId="14100"/>
        <pc:sldMkLst>
          <pc:docMk/>
          <pc:sldMk cId="629715234" sldId="282"/>
        </pc:sldMkLst>
        <pc:spChg chg="mod">
          <ac:chgData name="Rachel Lamerton" userId="2a274aa9-6826-4a05-8322-4d00fae19a96" providerId="ADAL" clId="{FC032B4E-A85A-481D-B6DB-3B866703A0B6}" dt="2025-08-22T14:48:31.397" v="6" actId="207"/>
          <ac:spMkLst>
            <pc:docMk/>
            <pc:sldMk cId="629715234" sldId="282"/>
            <ac:spMk id="4" creationId="{5CFACC14-902A-4397-98D0-1C93E2424411}"/>
          </ac:spMkLst>
        </pc:spChg>
        <pc:picChg chg="mod">
          <ac:chgData name="Rachel Lamerton" userId="2a274aa9-6826-4a05-8322-4d00fae19a96" providerId="ADAL" clId="{FC032B4E-A85A-481D-B6DB-3B866703A0B6}" dt="2025-08-25T10:18:26.275" v="10" actId="14100"/>
          <ac:picMkLst>
            <pc:docMk/>
            <pc:sldMk cId="629715234" sldId="282"/>
            <ac:picMk id="5" creationId="{115C758F-AF91-4141-9C2A-CB099E0FD9B4}"/>
          </ac:picMkLst>
        </pc:picChg>
      </pc:sldChg>
      <pc:sldChg chg="modSp mod">
        <pc:chgData name="Rachel Lamerton" userId="2a274aa9-6826-4a05-8322-4d00fae19a96" providerId="ADAL" clId="{FC032B4E-A85A-481D-B6DB-3B866703A0B6}" dt="2025-08-22T14:48:26.051" v="5" actId="207"/>
        <pc:sldMkLst>
          <pc:docMk/>
          <pc:sldMk cId="1587096433" sldId="283"/>
        </pc:sldMkLst>
        <pc:spChg chg="mod">
          <ac:chgData name="Rachel Lamerton" userId="2a274aa9-6826-4a05-8322-4d00fae19a96" providerId="ADAL" clId="{FC032B4E-A85A-481D-B6DB-3B866703A0B6}" dt="2025-08-22T14:48:26.051" v="5" actId="207"/>
          <ac:spMkLst>
            <pc:docMk/>
            <pc:sldMk cId="1587096433" sldId="283"/>
            <ac:spMk id="11" creationId="{DC5341B8-C708-4A7F-8B70-D007A9973219}"/>
          </ac:spMkLst>
        </pc:spChg>
      </pc:sldChg>
      <pc:sldChg chg="del">
        <pc:chgData name="Rachel Lamerton" userId="2a274aa9-6826-4a05-8322-4d00fae19a96" providerId="ADAL" clId="{FC032B4E-A85A-481D-B6DB-3B866703A0B6}" dt="2025-08-22T14:48:33.976" v="7" actId="47"/>
        <pc:sldMkLst>
          <pc:docMk/>
          <pc:sldMk cId="590140938" sldId="284"/>
        </pc:sldMkLst>
      </pc:sldChg>
      <pc:sldChg chg="addSp delSp modSp new mod">
        <pc:chgData name="Rachel Lamerton" userId="2a274aa9-6826-4a05-8322-4d00fae19a96" providerId="ADAL" clId="{FC032B4E-A85A-481D-B6DB-3B866703A0B6}" dt="2025-08-25T10:55:41.240" v="996" actId="478"/>
        <pc:sldMkLst>
          <pc:docMk/>
          <pc:sldMk cId="3776733224" sldId="284"/>
        </pc:sldMkLst>
        <pc:spChg chg="del">
          <ac:chgData name="Rachel Lamerton" userId="2a274aa9-6826-4a05-8322-4d00fae19a96" providerId="ADAL" clId="{FC032B4E-A85A-481D-B6DB-3B866703A0B6}" dt="2025-08-25T10:24:08.742" v="12" actId="478"/>
          <ac:spMkLst>
            <pc:docMk/>
            <pc:sldMk cId="3776733224" sldId="284"/>
            <ac:spMk id="2" creationId="{437D43A4-12FB-49AC-8721-CB5124C826F4}"/>
          </ac:spMkLst>
        </pc:spChg>
        <pc:spChg chg="del">
          <ac:chgData name="Rachel Lamerton" userId="2a274aa9-6826-4a05-8322-4d00fae19a96" providerId="ADAL" clId="{FC032B4E-A85A-481D-B6DB-3B866703A0B6}" dt="2025-08-25T10:24:09.620" v="13" actId="478"/>
          <ac:spMkLst>
            <pc:docMk/>
            <pc:sldMk cId="3776733224" sldId="284"/>
            <ac:spMk id="3" creationId="{B0C0F1C3-D45F-448D-94E5-E5ECDCD956A4}"/>
          </ac:spMkLst>
        </pc:spChg>
        <pc:spChg chg="mod">
          <ac:chgData name="Rachel Lamerton" userId="2a274aa9-6826-4a05-8322-4d00fae19a96" providerId="ADAL" clId="{FC032B4E-A85A-481D-B6DB-3B866703A0B6}" dt="2025-08-25T10:24:11.111" v="14"/>
          <ac:spMkLst>
            <pc:docMk/>
            <pc:sldMk cId="3776733224" sldId="284"/>
            <ac:spMk id="6" creationId="{14266E8D-FFAC-4AE1-92A1-A5682EC6432C}"/>
          </ac:spMkLst>
        </pc:spChg>
        <pc:spChg chg="add mod">
          <ac:chgData name="Rachel Lamerton" userId="2a274aa9-6826-4a05-8322-4d00fae19a96" providerId="ADAL" clId="{FC032B4E-A85A-481D-B6DB-3B866703A0B6}" dt="2025-08-25T10:25:02.778" v="18" actId="164"/>
          <ac:spMkLst>
            <pc:docMk/>
            <pc:sldMk cId="3776733224" sldId="284"/>
            <ac:spMk id="7" creationId="{5193AD50-F1BF-466C-888A-A8D82239CBE9}"/>
          </ac:spMkLst>
        </pc:spChg>
        <pc:spChg chg="add mod">
          <ac:chgData name="Rachel Lamerton" userId="2a274aa9-6826-4a05-8322-4d00fae19a96" providerId="ADAL" clId="{FC032B4E-A85A-481D-B6DB-3B866703A0B6}" dt="2025-08-25T10:25:02.778" v="18" actId="164"/>
          <ac:spMkLst>
            <pc:docMk/>
            <pc:sldMk cId="3776733224" sldId="284"/>
            <ac:spMk id="8" creationId="{B21DD22C-F3EE-47D1-94E2-DEB8B8603397}"/>
          </ac:spMkLst>
        </pc:spChg>
        <pc:spChg chg="add mod">
          <ac:chgData name="Rachel Lamerton" userId="2a274aa9-6826-4a05-8322-4d00fae19a96" providerId="ADAL" clId="{FC032B4E-A85A-481D-B6DB-3B866703A0B6}" dt="2025-08-25T10:25:02.778" v="18" actId="164"/>
          <ac:spMkLst>
            <pc:docMk/>
            <pc:sldMk cId="3776733224" sldId="284"/>
            <ac:spMk id="9" creationId="{29E8DB74-C6D3-4BCD-9D39-00ED12E6AB2B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1" creationId="{7AE1E8B6-DC84-4429-91B7-AA055408F951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2" creationId="{5FA082C0-A1BD-4A0F-B55B-100BF3AE2B65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3" creationId="{2695BA6F-CE0C-4A71-9C3F-FC8AD80122E9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4" creationId="{A0C39712-D94B-46F7-A4B0-D3A4E51C2DD4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5" creationId="{C0A8A875-302F-4D21-AE07-EB66A76C6815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6" creationId="{905C6E35-551A-4D83-9692-C8A7B84C8A6B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7" creationId="{86A69C69-EC41-4B6D-959B-053FFC951AA0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8" creationId="{BD00C165-3817-4C4D-8EEE-4875BBD175D3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19" creationId="{A5A12B59-07FB-4CB7-BCF4-C3842332A118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0" creationId="{6B8FD9D0-A73F-418E-A33F-E0056B83DADE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1" creationId="{546DF432-8C57-440D-9D00-562F252D740A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2" creationId="{F1131630-D954-4547-AC34-271B87A0989D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3" creationId="{8D1825B0-AAFB-4DBC-9676-65E3BF485381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4" creationId="{E0D830B7-593D-4465-B99B-3E104DACAF00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5" creationId="{0A766966-BECB-4EE5-99DE-EC6E57CC4B07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6" creationId="{6BE8E67C-DF39-4D3C-BF2B-16ED5F10C4B7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7" creationId="{C31994E1-CCBE-4A12-AED7-79E930B7CEE3}"/>
          </ac:spMkLst>
        </pc:spChg>
        <pc:spChg chg="mod">
          <ac:chgData name="Rachel Lamerton" userId="2a274aa9-6826-4a05-8322-4d00fae19a96" providerId="ADAL" clId="{FC032B4E-A85A-481D-B6DB-3B866703A0B6}" dt="2025-08-25T10:50:59.799" v="974" actId="404"/>
          <ac:spMkLst>
            <pc:docMk/>
            <pc:sldMk cId="3776733224" sldId="284"/>
            <ac:spMk id="28" creationId="{1C4BC089-A624-46AD-9503-E79817F68537}"/>
          </ac:spMkLst>
        </pc:spChg>
        <pc:spChg chg="mod topLvl">
          <ac:chgData name="Rachel Lamerton" userId="2a274aa9-6826-4a05-8322-4d00fae19a96" providerId="ADAL" clId="{FC032B4E-A85A-481D-B6DB-3B866703A0B6}" dt="2025-08-25T10:55:39.284" v="995" actId="14100"/>
          <ac:spMkLst>
            <pc:docMk/>
            <pc:sldMk cId="3776733224" sldId="284"/>
            <ac:spMk id="31" creationId="{FC7CE070-BA91-40A4-BC9B-25D439F8CC8F}"/>
          </ac:spMkLst>
        </pc:spChg>
        <pc:spChg chg="mod topLvl">
          <ac:chgData name="Rachel Lamerton" userId="2a274aa9-6826-4a05-8322-4d00fae19a96" providerId="ADAL" clId="{FC032B4E-A85A-481D-B6DB-3B866703A0B6}" dt="2025-08-25T10:43:04.464" v="470" actId="165"/>
          <ac:spMkLst>
            <pc:docMk/>
            <pc:sldMk cId="3776733224" sldId="284"/>
            <ac:spMk id="32" creationId="{03733C44-508F-4D6B-8EE9-6BDF06891242}"/>
          </ac:spMkLst>
        </pc:spChg>
        <pc:spChg chg="mod topLvl">
          <ac:chgData name="Rachel Lamerton" userId="2a274aa9-6826-4a05-8322-4d00fae19a96" providerId="ADAL" clId="{FC032B4E-A85A-481D-B6DB-3B866703A0B6}" dt="2025-08-25T10:43:04.464" v="470" actId="165"/>
          <ac:spMkLst>
            <pc:docMk/>
            <pc:sldMk cId="3776733224" sldId="284"/>
            <ac:spMk id="33" creationId="{BB0ABE0D-33DF-4B11-90A7-0E3DD974559D}"/>
          </ac:spMkLst>
        </pc:spChg>
        <pc:spChg chg="mod topLvl">
          <ac:chgData name="Rachel Lamerton" userId="2a274aa9-6826-4a05-8322-4d00fae19a96" providerId="ADAL" clId="{FC032B4E-A85A-481D-B6DB-3B866703A0B6}" dt="2025-08-25T10:43:13.741" v="487" actId="1038"/>
          <ac:spMkLst>
            <pc:docMk/>
            <pc:sldMk cId="3776733224" sldId="284"/>
            <ac:spMk id="34" creationId="{2D12C9F8-C51D-41AB-8832-E1F9B2004AD7}"/>
          </ac:spMkLst>
        </pc:spChg>
        <pc:spChg chg="mod topLvl">
          <ac:chgData name="Rachel Lamerton" userId="2a274aa9-6826-4a05-8322-4d00fae19a96" providerId="ADAL" clId="{FC032B4E-A85A-481D-B6DB-3B866703A0B6}" dt="2025-08-25T10:46:40.167" v="581" actId="14100"/>
          <ac:spMkLst>
            <pc:docMk/>
            <pc:sldMk cId="3776733224" sldId="284"/>
            <ac:spMk id="37" creationId="{3FB5D16E-FAA8-4B34-B2B4-0A1BA41E3380}"/>
          </ac:spMkLst>
        </pc:spChg>
        <pc:spChg chg="add mod">
          <ac:chgData name="Rachel Lamerton" userId="2a274aa9-6826-4a05-8322-4d00fae19a96" providerId="ADAL" clId="{FC032B4E-A85A-481D-B6DB-3B866703A0B6}" dt="2025-08-25T10:41:52.537" v="458" actId="1076"/>
          <ac:spMkLst>
            <pc:docMk/>
            <pc:sldMk cId="3776733224" sldId="284"/>
            <ac:spMk id="38" creationId="{384382F6-C92F-4768-996C-D8C77093192E}"/>
          </ac:spMkLst>
        </pc:spChg>
        <pc:spChg chg="add mod">
          <ac:chgData name="Rachel Lamerton" userId="2a274aa9-6826-4a05-8322-4d00fae19a96" providerId="ADAL" clId="{FC032B4E-A85A-481D-B6DB-3B866703A0B6}" dt="2025-08-25T10:42:57.025" v="469" actId="1036"/>
          <ac:spMkLst>
            <pc:docMk/>
            <pc:sldMk cId="3776733224" sldId="284"/>
            <ac:spMk id="39" creationId="{CC283922-ABF0-407C-9670-7A94951F73B5}"/>
          </ac:spMkLst>
        </pc:spChg>
        <pc:spChg chg="add mod">
          <ac:chgData name="Rachel Lamerton" userId="2a274aa9-6826-4a05-8322-4d00fae19a96" providerId="ADAL" clId="{FC032B4E-A85A-481D-B6DB-3B866703A0B6}" dt="2025-08-25T10:43:22.548" v="488" actId="1076"/>
          <ac:spMkLst>
            <pc:docMk/>
            <pc:sldMk cId="3776733224" sldId="284"/>
            <ac:spMk id="40" creationId="{86A7CC2C-D432-4047-83D3-D0B69625C2EB}"/>
          </ac:spMkLst>
        </pc:spChg>
        <pc:spChg chg="add del mod">
          <ac:chgData name="Rachel Lamerton" userId="2a274aa9-6826-4a05-8322-4d00fae19a96" providerId="ADAL" clId="{FC032B4E-A85A-481D-B6DB-3B866703A0B6}" dt="2025-08-25T10:29:41.772" v="207" actId="478"/>
          <ac:spMkLst>
            <pc:docMk/>
            <pc:sldMk cId="3776733224" sldId="284"/>
            <ac:spMk id="41" creationId="{83803C3D-FFD3-4734-9112-274F650E179D}"/>
          </ac:spMkLst>
        </pc:spChg>
        <pc:spChg chg="add del mod">
          <ac:chgData name="Rachel Lamerton" userId="2a274aa9-6826-4a05-8322-4d00fae19a96" providerId="ADAL" clId="{FC032B4E-A85A-481D-B6DB-3B866703A0B6}" dt="2025-08-25T10:31:54.465" v="218"/>
          <ac:spMkLst>
            <pc:docMk/>
            <pc:sldMk cId="3776733224" sldId="284"/>
            <ac:spMk id="43" creationId="{86694666-E035-498E-86D9-7885191F4BE6}"/>
          </ac:spMkLst>
        </pc:spChg>
        <pc:spChg chg="add del mod">
          <ac:chgData name="Rachel Lamerton" userId="2a274aa9-6826-4a05-8322-4d00fae19a96" providerId="ADAL" clId="{FC032B4E-A85A-481D-B6DB-3B866703A0B6}" dt="2025-08-25T10:31:54.465" v="218"/>
          <ac:spMkLst>
            <pc:docMk/>
            <pc:sldMk cId="3776733224" sldId="284"/>
            <ac:spMk id="44" creationId="{BF0B7D20-799E-44AB-BFA9-7A3E2FBD04E3}"/>
          </ac:spMkLst>
        </pc:spChg>
        <pc:spChg chg="add del mod">
          <ac:chgData name="Rachel Lamerton" userId="2a274aa9-6826-4a05-8322-4d00fae19a96" providerId="ADAL" clId="{FC032B4E-A85A-481D-B6DB-3B866703A0B6}" dt="2025-08-25T10:31:54.465" v="218"/>
          <ac:spMkLst>
            <pc:docMk/>
            <pc:sldMk cId="3776733224" sldId="284"/>
            <ac:spMk id="45" creationId="{3E6036C0-AF96-4886-955A-013815465D04}"/>
          </ac:spMkLst>
        </pc:spChg>
        <pc:spChg chg="add del mod">
          <ac:chgData name="Rachel Lamerton" userId="2a274aa9-6826-4a05-8322-4d00fae19a96" providerId="ADAL" clId="{FC032B4E-A85A-481D-B6DB-3B866703A0B6}" dt="2025-08-25T10:31:54.465" v="218"/>
          <ac:spMkLst>
            <pc:docMk/>
            <pc:sldMk cId="3776733224" sldId="284"/>
            <ac:spMk id="46" creationId="{CD11C78B-CCF6-4F3C-9FE3-65B69C6194A4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49" creationId="{FE9CBC6B-DFC3-45C2-811E-F2FE25DB384E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0" creationId="{FEC4A59D-1ACD-4DA3-B787-A6A2EF80F6B8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1" creationId="{EC633D35-7417-4A76-B7B6-F18039313371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2" creationId="{45A7AF9A-5D8E-4B51-81D7-868A7C10BC7D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3" creationId="{83FE106D-A45C-4065-A21E-BE04F47992A8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6" creationId="{533E3368-994D-4823-9AA0-C590F5AD0DCF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7" creationId="{58F21BAD-40C0-4B1B-A3A5-BB47FEC3EBE5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8" creationId="{F4768DD5-64A1-48E4-988E-31C9FB5C891B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59" creationId="{0C5D5C42-9243-4332-9C00-7D866EE22D7B}"/>
          </ac:spMkLst>
        </pc:spChg>
        <pc:spChg chg="mod">
          <ac:chgData name="Rachel Lamerton" userId="2a274aa9-6826-4a05-8322-4d00fae19a96" providerId="ADAL" clId="{FC032B4E-A85A-481D-B6DB-3B866703A0B6}" dt="2025-08-25T10:31:50.270" v="217"/>
          <ac:spMkLst>
            <pc:docMk/>
            <pc:sldMk cId="3776733224" sldId="284"/>
            <ac:spMk id="60" creationId="{9EB99676-CD90-4983-909A-B8BF67BE2FAB}"/>
          </ac:spMkLst>
        </pc:spChg>
        <pc:spChg chg="add mod topLvl">
          <ac:chgData name="Rachel Lamerton" userId="2a274aa9-6826-4a05-8322-4d00fae19a96" providerId="ADAL" clId="{FC032B4E-A85A-481D-B6DB-3B866703A0B6}" dt="2025-08-25T10:34:55.672" v="276" actId="164"/>
          <ac:spMkLst>
            <pc:docMk/>
            <pc:sldMk cId="3776733224" sldId="284"/>
            <ac:spMk id="62" creationId="{4F1B3A2F-C115-46FF-BDB2-2A5D788EBE1D}"/>
          </ac:spMkLst>
        </pc:spChg>
        <pc:spChg chg="add del mod">
          <ac:chgData name="Rachel Lamerton" userId="2a274aa9-6826-4a05-8322-4d00fae19a96" providerId="ADAL" clId="{FC032B4E-A85A-481D-B6DB-3B866703A0B6}" dt="2025-08-25T10:32:37.397" v="228" actId="478"/>
          <ac:spMkLst>
            <pc:docMk/>
            <pc:sldMk cId="3776733224" sldId="284"/>
            <ac:spMk id="63" creationId="{507BB4B5-6273-448C-AC1B-4A1CB6010A54}"/>
          </ac:spMkLst>
        </pc:spChg>
        <pc:spChg chg="add mod">
          <ac:chgData name="Rachel Lamerton" userId="2a274aa9-6826-4a05-8322-4d00fae19a96" providerId="ADAL" clId="{FC032B4E-A85A-481D-B6DB-3B866703A0B6}" dt="2025-08-25T10:36:11.866" v="316" actId="1076"/>
          <ac:spMkLst>
            <pc:docMk/>
            <pc:sldMk cId="3776733224" sldId="284"/>
            <ac:spMk id="64" creationId="{95C73AD0-EB24-427F-9889-DD3E9D29D939}"/>
          </ac:spMkLst>
        </pc:spChg>
        <pc:spChg chg="add mod">
          <ac:chgData name="Rachel Lamerton" userId="2a274aa9-6826-4a05-8322-4d00fae19a96" providerId="ADAL" clId="{FC032B4E-A85A-481D-B6DB-3B866703A0B6}" dt="2025-08-25T10:36:21.729" v="336" actId="1076"/>
          <ac:spMkLst>
            <pc:docMk/>
            <pc:sldMk cId="3776733224" sldId="284"/>
            <ac:spMk id="65" creationId="{FC91D41E-787B-41D7-91EE-6C6C53578A95}"/>
          </ac:spMkLst>
        </pc:spChg>
        <pc:spChg chg="mod">
          <ac:chgData name="Rachel Lamerton" userId="2a274aa9-6826-4a05-8322-4d00fae19a96" providerId="ADAL" clId="{FC032B4E-A85A-481D-B6DB-3B866703A0B6}" dt="2025-08-25T10:32:00.360" v="219"/>
          <ac:spMkLst>
            <pc:docMk/>
            <pc:sldMk cId="3776733224" sldId="284"/>
            <ac:spMk id="68" creationId="{28DFDDAB-F0ED-4D12-B3B6-CBB948C9B9A1}"/>
          </ac:spMkLst>
        </pc:spChg>
        <pc:spChg chg="mod">
          <ac:chgData name="Rachel Lamerton" userId="2a274aa9-6826-4a05-8322-4d00fae19a96" providerId="ADAL" clId="{FC032B4E-A85A-481D-B6DB-3B866703A0B6}" dt="2025-08-25T10:32:00.360" v="219"/>
          <ac:spMkLst>
            <pc:docMk/>
            <pc:sldMk cId="3776733224" sldId="284"/>
            <ac:spMk id="69" creationId="{F90EFF25-7E05-45A3-9E3F-EE5D35BCE529}"/>
          </ac:spMkLst>
        </pc:spChg>
        <pc:spChg chg="mod">
          <ac:chgData name="Rachel Lamerton" userId="2a274aa9-6826-4a05-8322-4d00fae19a96" providerId="ADAL" clId="{FC032B4E-A85A-481D-B6DB-3B866703A0B6}" dt="2025-08-25T10:32:00.360" v="219"/>
          <ac:spMkLst>
            <pc:docMk/>
            <pc:sldMk cId="3776733224" sldId="284"/>
            <ac:spMk id="70" creationId="{103D4E17-A950-4547-9D24-52AF1EBA5767}"/>
          </ac:spMkLst>
        </pc:spChg>
        <pc:spChg chg="mod">
          <ac:chgData name="Rachel Lamerton" userId="2a274aa9-6826-4a05-8322-4d00fae19a96" providerId="ADAL" clId="{FC032B4E-A85A-481D-B6DB-3B866703A0B6}" dt="2025-08-25T10:32:00.360" v="219"/>
          <ac:spMkLst>
            <pc:docMk/>
            <pc:sldMk cId="3776733224" sldId="284"/>
            <ac:spMk id="71" creationId="{352A3CB4-C2FA-43B2-AB0A-378AA8B697F7}"/>
          </ac:spMkLst>
        </pc:spChg>
        <pc:spChg chg="mod">
          <ac:chgData name="Rachel Lamerton" userId="2a274aa9-6826-4a05-8322-4d00fae19a96" providerId="ADAL" clId="{FC032B4E-A85A-481D-B6DB-3B866703A0B6}" dt="2025-08-25T10:32:00.360" v="219"/>
          <ac:spMkLst>
            <pc:docMk/>
            <pc:sldMk cId="3776733224" sldId="284"/>
            <ac:spMk id="72" creationId="{D5EE0F0B-8BCE-4C6B-9461-0B771A895282}"/>
          </ac:spMkLst>
        </pc:spChg>
        <pc:spChg chg="mod">
          <ac:chgData name="Rachel Lamerton" userId="2a274aa9-6826-4a05-8322-4d00fae19a96" providerId="ADAL" clId="{FC032B4E-A85A-481D-B6DB-3B866703A0B6}" dt="2025-08-25T10:34:30.925" v="252" actId="165"/>
          <ac:spMkLst>
            <pc:docMk/>
            <pc:sldMk cId="3776733224" sldId="284"/>
            <ac:spMk id="75" creationId="{69D7056D-B5CC-481D-9269-737E68A573A2}"/>
          </ac:spMkLst>
        </pc:spChg>
        <pc:spChg chg="mod">
          <ac:chgData name="Rachel Lamerton" userId="2a274aa9-6826-4a05-8322-4d00fae19a96" providerId="ADAL" clId="{FC032B4E-A85A-481D-B6DB-3B866703A0B6}" dt="2025-08-25T10:34:30.925" v="252" actId="165"/>
          <ac:spMkLst>
            <pc:docMk/>
            <pc:sldMk cId="3776733224" sldId="284"/>
            <ac:spMk id="76" creationId="{C37CFF1D-02C4-4773-97CD-38E8F3369995}"/>
          </ac:spMkLst>
        </pc:spChg>
        <pc:spChg chg="mod">
          <ac:chgData name="Rachel Lamerton" userId="2a274aa9-6826-4a05-8322-4d00fae19a96" providerId="ADAL" clId="{FC032B4E-A85A-481D-B6DB-3B866703A0B6}" dt="2025-08-25T10:34:30.925" v="252" actId="165"/>
          <ac:spMkLst>
            <pc:docMk/>
            <pc:sldMk cId="3776733224" sldId="284"/>
            <ac:spMk id="77" creationId="{06D711A0-132E-44F0-ADBC-86B0CE71AE53}"/>
          </ac:spMkLst>
        </pc:spChg>
        <pc:spChg chg="mod">
          <ac:chgData name="Rachel Lamerton" userId="2a274aa9-6826-4a05-8322-4d00fae19a96" providerId="ADAL" clId="{FC032B4E-A85A-481D-B6DB-3B866703A0B6}" dt="2025-08-25T10:34:30.925" v="252" actId="165"/>
          <ac:spMkLst>
            <pc:docMk/>
            <pc:sldMk cId="3776733224" sldId="284"/>
            <ac:spMk id="78" creationId="{1F2AD55F-82EE-4C00-991F-0EE8AD7C0981}"/>
          </ac:spMkLst>
        </pc:spChg>
        <pc:spChg chg="mod">
          <ac:chgData name="Rachel Lamerton" userId="2a274aa9-6826-4a05-8322-4d00fae19a96" providerId="ADAL" clId="{FC032B4E-A85A-481D-B6DB-3B866703A0B6}" dt="2025-08-25T10:34:30.925" v="252" actId="165"/>
          <ac:spMkLst>
            <pc:docMk/>
            <pc:sldMk cId="3776733224" sldId="284"/>
            <ac:spMk id="79" creationId="{ED0E6F92-0852-4E17-B9E8-AE2180A785C2}"/>
          </ac:spMkLst>
        </pc:spChg>
        <pc:spChg chg="add mod">
          <ac:chgData name="Rachel Lamerton" userId="2a274aa9-6826-4a05-8322-4d00fae19a96" providerId="ADAL" clId="{FC032B4E-A85A-481D-B6DB-3B866703A0B6}" dt="2025-08-25T10:43:58.937" v="507" actId="1035"/>
          <ac:spMkLst>
            <pc:docMk/>
            <pc:sldMk cId="3776733224" sldId="284"/>
            <ac:spMk id="80" creationId="{05CF8715-6D5D-4D7A-924E-D9608BF3A154}"/>
          </ac:spMkLst>
        </pc:spChg>
        <pc:spChg chg="mod topLvl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85" creationId="{97682021-A277-4EA5-9B4E-21FB561A5D25}"/>
          </ac:spMkLst>
        </pc:spChg>
        <pc:spChg chg="del mod topLvl">
          <ac:chgData name="Rachel Lamerton" userId="2a274aa9-6826-4a05-8322-4d00fae19a96" providerId="ADAL" clId="{FC032B4E-A85A-481D-B6DB-3B866703A0B6}" dt="2025-08-25T10:37:39.781" v="355" actId="478"/>
          <ac:spMkLst>
            <pc:docMk/>
            <pc:sldMk cId="3776733224" sldId="284"/>
            <ac:spMk id="86" creationId="{910D044D-2C0D-4C25-9023-F922EAC81821}"/>
          </ac:spMkLst>
        </pc:spChg>
        <pc:spChg chg="mod topLvl">
          <ac:chgData name="Rachel Lamerton" userId="2a274aa9-6826-4a05-8322-4d00fae19a96" providerId="ADAL" clId="{FC032B4E-A85A-481D-B6DB-3B866703A0B6}" dt="2025-08-25T10:45:49.925" v="562" actId="1037"/>
          <ac:spMkLst>
            <pc:docMk/>
            <pc:sldMk cId="3776733224" sldId="284"/>
            <ac:spMk id="87" creationId="{A117BD47-F87A-4E24-B369-A84C6B971276}"/>
          </ac:spMkLst>
        </pc:spChg>
        <pc:spChg chg="mod topLvl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88" creationId="{B890F220-9A9D-4641-BD0C-3E436867C43A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4" creationId="{EBCC8713-3C5E-4A06-B769-DC4AD85A48C2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5" creationId="{54F20F95-A777-4D72-B1BB-046384858877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6" creationId="{B6140242-50C6-4D93-80A5-0F29AA1C595A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7" creationId="{8B7BBD52-BAE7-4E79-8B96-DE114164BDA5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8" creationId="{5CEB3561-7650-4BB9-A992-3E2A0E0E39E6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99" creationId="{5791652A-8683-480A-B6BF-00FA01D7C23A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0" creationId="{9DDA101A-779A-4215-9328-8D045C8A7D2A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1" creationId="{8DB17C03-DF0F-4482-BD54-EF32E8DE5031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2" creationId="{7C7AFB26-C52D-40C3-A44C-5B1DB99FE71F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3" creationId="{6A7F2F89-3B1F-4E80-9786-37D1E1A3E6B3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4" creationId="{31E64A28-80AA-4DA2-85D9-BC0A486BE1B0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5" creationId="{16BEFBCC-03A1-4273-9566-CE22053D3747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6" creationId="{1D4E48AE-E555-4F78-B172-C87F98C7D419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7" creationId="{D6116D93-C468-4D15-B60C-591447466192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8" creationId="{5AF103D4-87CA-4D1E-8CDD-1B06B5EBA476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09" creationId="{E444F823-65D4-44B1-B737-79CC5D75862C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10" creationId="{0CF8DC56-200D-480A-8168-BE498A324088}"/>
          </ac:spMkLst>
        </pc:spChg>
        <pc:spChg chg="mod">
          <ac:chgData name="Rachel Lamerton" userId="2a274aa9-6826-4a05-8322-4d00fae19a96" providerId="ADAL" clId="{FC032B4E-A85A-481D-B6DB-3B866703A0B6}" dt="2025-08-25T10:37:05.195" v="346" actId="165"/>
          <ac:spMkLst>
            <pc:docMk/>
            <pc:sldMk cId="3776733224" sldId="284"/>
            <ac:spMk id="111" creationId="{51C8F5B5-B99B-4F66-B28C-D8942947C50B}"/>
          </ac:spMkLst>
        </pc:spChg>
        <pc:spChg chg="mod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12" creationId="{3EFFC468-F531-481F-9D23-51D1FF8643BF}"/>
          </ac:spMkLst>
        </pc:spChg>
        <pc:spChg chg="mod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13" creationId="{A95A55BD-6247-4D64-9CA1-5DA1ADD5F33B}"/>
          </ac:spMkLst>
        </pc:spChg>
        <pc:spChg chg="mod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14" creationId="{8A41B6EB-255D-4C66-B85C-EC13D1B5AEAB}"/>
          </ac:spMkLst>
        </pc:spChg>
        <pc:spChg chg="mod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15" creationId="{498386A7-1515-42C8-8F67-953BCC950F67}"/>
          </ac:spMkLst>
        </pc:spChg>
        <pc:spChg chg="mod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16" creationId="{1164B836-7520-409C-A827-AB0597092A13}"/>
          </ac:spMkLst>
        </pc:spChg>
        <pc:spChg chg="mod">
          <ac:chgData name="Rachel Lamerton" userId="2a274aa9-6826-4a05-8322-4d00fae19a96" providerId="ADAL" clId="{FC032B4E-A85A-481D-B6DB-3B866703A0B6}" dt="2025-08-25T10:37:20.046" v="348" actId="115"/>
          <ac:spMkLst>
            <pc:docMk/>
            <pc:sldMk cId="3776733224" sldId="284"/>
            <ac:spMk id="117" creationId="{06F2D71C-4ADC-40ED-81A3-3EC7A8746288}"/>
          </ac:spMkLst>
        </pc:spChg>
        <pc:spChg chg="mod">
          <ac:chgData name="Rachel Lamerton" userId="2a274aa9-6826-4a05-8322-4d00fae19a96" providerId="ADAL" clId="{FC032B4E-A85A-481D-B6DB-3B866703A0B6}" dt="2025-08-25T10:37:20.046" v="348" actId="115"/>
          <ac:spMkLst>
            <pc:docMk/>
            <pc:sldMk cId="3776733224" sldId="284"/>
            <ac:spMk id="118" creationId="{4546DF63-69F2-4B22-9CA9-A1FA5D3F7B0D}"/>
          </ac:spMkLst>
        </pc:spChg>
        <pc:spChg chg="mod">
          <ac:chgData name="Rachel Lamerton" userId="2a274aa9-6826-4a05-8322-4d00fae19a96" providerId="ADAL" clId="{FC032B4E-A85A-481D-B6DB-3B866703A0B6}" dt="2025-08-25T10:37:20.046" v="348" actId="115"/>
          <ac:spMkLst>
            <pc:docMk/>
            <pc:sldMk cId="3776733224" sldId="284"/>
            <ac:spMk id="119" creationId="{0E8132FE-317D-4FEC-A626-B51A8DB05E6A}"/>
          </ac:spMkLst>
        </pc:spChg>
        <pc:spChg chg="mod">
          <ac:chgData name="Rachel Lamerton" userId="2a274aa9-6826-4a05-8322-4d00fae19a96" providerId="ADAL" clId="{FC032B4E-A85A-481D-B6DB-3B866703A0B6}" dt="2025-08-25T10:37:20.046" v="348" actId="115"/>
          <ac:spMkLst>
            <pc:docMk/>
            <pc:sldMk cId="3776733224" sldId="284"/>
            <ac:spMk id="120" creationId="{352DE2F2-97F8-40AE-9F2C-E9BD8010B074}"/>
          </ac:spMkLst>
        </pc:spChg>
        <pc:spChg chg="mod">
          <ac:chgData name="Rachel Lamerton" userId="2a274aa9-6826-4a05-8322-4d00fae19a96" providerId="ADAL" clId="{FC032B4E-A85A-481D-B6DB-3B866703A0B6}" dt="2025-08-25T10:37:20.046" v="348" actId="115"/>
          <ac:spMkLst>
            <pc:docMk/>
            <pc:sldMk cId="3776733224" sldId="284"/>
            <ac:spMk id="121" creationId="{59A74775-FDEC-4168-8D60-25527BE4F02A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24" creationId="{7915ED1D-CCAF-4085-BABD-8D080ACE63CE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25" creationId="{A1B8A386-5F65-4963-A0C8-5B22A7A43E42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26" creationId="{7997A8B4-D51C-4273-8775-033358A674FD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27" creationId="{D55F40D0-3047-491C-8A3E-4F3285BCC7FB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3" creationId="{C281789C-CA1C-4B1C-AAD4-869DB41BAA95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4" creationId="{3AF249F8-1DC7-4C2D-AF79-20FEA29AE399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5" creationId="{B6740F6A-C575-4A94-B234-1295CABEBEE7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6" creationId="{FAC91B14-4CF3-436D-A05C-E785516D76E9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7" creationId="{EC010B14-2C79-4945-861C-CE01CC8B5B71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8" creationId="{94901F17-686B-43C2-8CDB-4329847EF6A7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39" creationId="{5FCF1284-B589-4610-9925-67D6CDBC6A05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0" creationId="{67BF97FB-36EE-4CE3-BD49-FAB00DC01E86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1" creationId="{904F4177-9E35-414F-8E1D-6FD64BC02915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2" creationId="{F792DD5F-A019-4D76-83E2-1D6F0821ECDD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3" creationId="{2E3C9778-AC76-4767-B4FD-52C4D47D7A79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4" creationId="{707E52B0-11D4-41EE-BFD0-CE88DCFDA132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5" creationId="{CE4DFCCB-2824-45FC-A7FB-6C0B4B46069F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6" creationId="{6D498FF3-3FD5-4807-9D48-EB269FF4C3E7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7" creationId="{04898363-DC56-4519-A82D-F081BF41485E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8" creationId="{79550148-5461-435F-96ED-0F14F4D4E5D1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49" creationId="{33F4067B-5C4D-4CD7-9E21-56C4FD6EE4A5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0" creationId="{C93EA5C1-5BF6-4762-A27E-72F61BB407C4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1" creationId="{9DB60576-F22B-4934-A604-35DAEF0C8108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2" creationId="{109A9100-209E-42DD-9D1B-52679C85C35D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3" creationId="{D6DCECD2-994D-4FFD-8DE8-146AD9360110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4" creationId="{764C8F07-B38A-4311-BB15-9C69AD472761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5" creationId="{090BED15-0BFA-43FB-8A9A-290BD7B1352C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6" creationId="{FF5CFAD1-A8DF-4279-A43B-DFE20540784A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7" creationId="{B9354730-E632-4927-84BC-213E99D1F349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8" creationId="{C88725F7-1DBB-483E-B5C7-6A95AF8A61BB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59" creationId="{93C80F26-4DA2-4301-9490-4EA87EBA9B7B}"/>
          </ac:spMkLst>
        </pc:spChg>
        <pc:spChg chg="mod">
          <ac:chgData name="Rachel Lamerton" userId="2a274aa9-6826-4a05-8322-4d00fae19a96" providerId="ADAL" clId="{FC032B4E-A85A-481D-B6DB-3B866703A0B6}" dt="2025-08-25T10:37:31.636" v="351"/>
          <ac:spMkLst>
            <pc:docMk/>
            <pc:sldMk cId="3776733224" sldId="284"/>
            <ac:spMk id="160" creationId="{41E383FA-4296-45E5-92FA-19C59A563A23}"/>
          </ac:spMkLst>
        </pc:spChg>
        <pc:spChg chg="add mod topLvl">
          <ac:chgData name="Rachel Lamerton" userId="2a274aa9-6826-4a05-8322-4d00fae19a96" providerId="ADAL" clId="{FC032B4E-A85A-481D-B6DB-3B866703A0B6}" dt="2025-08-25T10:45:39.915" v="559" actId="165"/>
          <ac:spMkLst>
            <pc:docMk/>
            <pc:sldMk cId="3776733224" sldId="284"/>
            <ac:spMk id="161" creationId="{A5C0BDC3-FA36-47BB-A318-2BB2D8C5D841}"/>
          </ac:spMkLst>
        </pc:spChg>
        <pc:spChg chg="mod topLvl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67" creationId="{5B5693A7-3F6D-48E6-9623-18D295A17E05}"/>
          </ac:spMkLst>
        </pc:spChg>
        <pc:spChg chg="del mod topLvl">
          <ac:chgData name="Rachel Lamerton" userId="2a274aa9-6826-4a05-8322-4d00fae19a96" providerId="ADAL" clId="{FC032B4E-A85A-481D-B6DB-3B866703A0B6}" dt="2025-08-25T10:39:43.387" v="401" actId="478"/>
          <ac:spMkLst>
            <pc:docMk/>
            <pc:sldMk cId="3776733224" sldId="284"/>
            <ac:spMk id="168" creationId="{1BE880C9-F644-46D3-BA7F-46342708A18E}"/>
          </ac:spMkLst>
        </pc:spChg>
        <pc:spChg chg="del mod topLvl">
          <ac:chgData name="Rachel Lamerton" userId="2a274aa9-6826-4a05-8322-4d00fae19a96" providerId="ADAL" clId="{FC032B4E-A85A-481D-B6DB-3B866703A0B6}" dt="2025-08-25T10:45:17.491" v="556" actId="478"/>
          <ac:spMkLst>
            <pc:docMk/>
            <pc:sldMk cId="3776733224" sldId="284"/>
            <ac:spMk id="169" creationId="{A10BA7B4-2E6B-4CE2-BB2A-1DC4F751477E}"/>
          </ac:spMkLst>
        </pc:spChg>
        <pc:spChg chg="mod topLvl">
          <ac:chgData name="Rachel Lamerton" userId="2a274aa9-6826-4a05-8322-4d00fae19a96" providerId="ADAL" clId="{FC032B4E-A85A-481D-B6DB-3B866703A0B6}" dt="2025-08-25T10:44:26.757" v="534" actId="20577"/>
          <ac:spMkLst>
            <pc:docMk/>
            <pc:sldMk cId="3776733224" sldId="284"/>
            <ac:spMk id="170" creationId="{2A28EC59-6540-4602-BD60-03FBCCCF0D02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76" creationId="{EA881C10-9F9D-4613-9640-F511FAF85955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77" creationId="{B1D9408E-3602-4FA8-9B89-6974E30ED3FD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78" creationId="{F1D035E1-4FA1-474D-9552-8740E20A2269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79" creationId="{BDFFFD50-F46D-4542-A52E-51A6AEB53EE0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0" creationId="{50EB8D31-5053-4970-8CBB-80847CF3E0E9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1" creationId="{CC5882A4-01D0-4CB4-80A3-94540881B09A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2" creationId="{BB06AA42-971C-4EF2-9281-F7F2A9344DFD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3" creationId="{F2F97D1A-7619-4CA6-AF86-F1B620A34B9D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4" creationId="{59677042-19D6-4181-91AA-8D8291DF3F65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5" creationId="{3BA86B3D-3718-49AD-ACD5-4E5E08146460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6" creationId="{890C1347-9C7A-4F55-A271-52C6DAFA82AE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7" creationId="{7C9F61A6-CD61-4922-B79C-8B9D224264EF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8" creationId="{21B1AA1F-0F2D-444D-AF80-48B845D06B90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89" creationId="{6ECF04F1-83E5-42D7-9767-815366321D4A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90" creationId="{C099A036-13A1-41C6-9950-0565DB677426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91" creationId="{C6515769-7253-4857-85C1-185AD8E69932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92" creationId="{7003287D-C72C-48AA-9030-9343890F1D59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93" creationId="{847CAB9E-FF47-45A7-8023-E2A0AD6DEFC7}"/>
          </ac:spMkLst>
        </pc:spChg>
        <pc:spChg chg="mod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94" creationId="{59326437-87CC-46F0-B85E-598359813664}"/>
          </ac:spMkLst>
        </pc:spChg>
        <pc:spChg chg="mod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95" creationId="{3466F1B9-3888-4514-A94A-40CD6DD745D8}"/>
          </ac:spMkLst>
        </pc:spChg>
        <pc:spChg chg="mod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96" creationId="{7D07786F-F04D-4D17-8C81-CBC431E1C76E}"/>
          </ac:spMkLst>
        </pc:spChg>
        <pc:spChg chg="mod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97" creationId="{24BF0DF5-8434-4CCF-8D3A-BF677DD11F47}"/>
          </ac:spMkLst>
        </pc:spChg>
        <pc:spChg chg="mod">
          <ac:chgData name="Rachel Lamerton" userId="2a274aa9-6826-4a05-8322-4d00fae19a96" providerId="ADAL" clId="{FC032B4E-A85A-481D-B6DB-3B866703A0B6}" dt="2025-08-25T10:44:42.386" v="537" actId="165"/>
          <ac:spMkLst>
            <pc:docMk/>
            <pc:sldMk cId="3776733224" sldId="284"/>
            <ac:spMk id="198" creationId="{BED917B2-B100-4980-A16B-6185E9EEBB12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199" creationId="{36A0D793-A622-4325-89B7-004E59AF90FA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200" creationId="{AC344D46-19B3-40C8-8A14-608F4C8E4EAF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201" creationId="{ED12E887-1DC0-4300-9DD6-3C9971426CDB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202" creationId="{807F8211-0E3B-41F2-9B5D-D9DA4A3BC553}"/>
          </ac:spMkLst>
        </pc:spChg>
        <pc:spChg chg="mod">
          <ac:chgData name="Rachel Lamerton" userId="2a274aa9-6826-4a05-8322-4d00fae19a96" providerId="ADAL" clId="{FC032B4E-A85A-481D-B6DB-3B866703A0B6}" dt="2025-08-25T10:39:26.788" v="397" actId="165"/>
          <ac:spMkLst>
            <pc:docMk/>
            <pc:sldMk cId="3776733224" sldId="284"/>
            <ac:spMk id="203" creationId="{B06491E0-3B54-46D7-970A-6B01CF9E7324}"/>
          </ac:spMkLst>
        </pc:spChg>
        <pc:spChg chg="add mod">
          <ac:chgData name="Rachel Lamerton" userId="2a274aa9-6826-4a05-8322-4d00fae19a96" providerId="ADAL" clId="{FC032B4E-A85A-481D-B6DB-3B866703A0B6}" dt="2025-08-25T10:44:06.066" v="518" actId="1035"/>
          <ac:spMkLst>
            <pc:docMk/>
            <pc:sldMk cId="3776733224" sldId="284"/>
            <ac:spMk id="204" creationId="{83C4B18C-60ED-4F16-A52C-EA9BF6D57758}"/>
          </ac:spMkLst>
        </pc:spChg>
        <pc:spChg chg="add mod">
          <ac:chgData name="Rachel Lamerton" userId="2a274aa9-6826-4a05-8322-4d00fae19a96" providerId="ADAL" clId="{FC032B4E-A85A-481D-B6DB-3B866703A0B6}" dt="2025-08-25T10:45:35.710" v="558" actId="1076"/>
          <ac:spMkLst>
            <pc:docMk/>
            <pc:sldMk cId="3776733224" sldId="284"/>
            <ac:spMk id="209" creationId="{D6A0BD6A-EB63-4C91-BAAE-58FC18308E65}"/>
          </ac:spMkLst>
        </pc:spChg>
        <pc:spChg chg="add mod">
          <ac:chgData name="Rachel Lamerton" userId="2a274aa9-6826-4a05-8322-4d00fae19a96" providerId="ADAL" clId="{FC032B4E-A85A-481D-B6DB-3B866703A0B6}" dt="2025-08-25T10:52:38.911" v="985" actId="20577"/>
          <ac:spMkLst>
            <pc:docMk/>
            <pc:sldMk cId="3776733224" sldId="284"/>
            <ac:spMk id="211" creationId="{90C01DE0-D020-4F7C-B661-295A2F52B659}"/>
          </ac:spMkLst>
        </pc:spChg>
        <pc:grpChg chg="add mod">
          <ac:chgData name="Rachel Lamerton" userId="2a274aa9-6826-4a05-8322-4d00fae19a96" providerId="ADAL" clId="{FC032B4E-A85A-481D-B6DB-3B866703A0B6}" dt="2025-08-25T10:25:02.778" v="18" actId="164"/>
          <ac:grpSpMkLst>
            <pc:docMk/>
            <pc:sldMk cId="3776733224" sldId="284"/>
            <ac:grpSpMk id="4" creationId="{41846AF2-8D4C-47C5-95E8-E60171BA18B8}"/>
          </ac:grpSpMkLst>
        </pc:grpChg>
        <pc:grpChg chg="add mod">
          <ac:chgData name="Rachel Lamerton" userId="2a274aa9-6826-4a05-8322-4d00fae19a96" providerId="ADAL" clId="{FC032B4E-A85A-481D-B6DB-3B866703A0B6}" dt="2025-08-25T10:51:12.510" v="977" actId="1076"/>
          <ac:grpSpMkLst>
            <pc:docMk/>
            <pc:sldMk cId="3776733224" sldId="284"/>
            <ac:grpSpMk id="10" creationId="{7D8F2A3D-FF4B-4F61-A4F5-DC3E5996F999}"/>
          </ac:grpSpMkLst>
        </pc:grpChg>
        <pc:grpChg chg="add del mod">
          <ac:chgData name="Rachel Lamerton" userId="2a274aa9-6826-4a05-8322-4d00fae19a96" providerId="ADAL" clId="{FC032B4E-A85A-481D-B6DB-3B866703A0B6}" dt="2025-08-25T10:43:04.464" v="470" actId="165"/>
          <ac:grpSpMkLst>
            <pc:docMk/>
            <pc:sldMk cId="3776733224" sldId="284"/>
            <ac:grpSpMk id="29" creationId="{822158B9-AE3C-4F24-B94E-7649802E4EFD}"/>
          </ac:grpSpMkLst>
        </pc:grpChg>
        <pc:grpChg chg="add del mod">
          <ac:chgData name="Rachel Lamerton" userId="2a274aa9-6826-4a05-8322-4d00fae19a96" providerId="ADAL" clId="{FC032B4E-A85A-481D-B6DB-3B866703A0B6}" dt="2025-08-25T10:28:56.840" v="54" actId="165"/>
          <ac:grpSpMkLst>
            <pc:docMk/>
            <pc:sldMk cId="3776733224" sldId="284"/>
            <ac:grpSpMk id="35" creationId="{9637244E-09A3-4636-AECC-C047695B8E21}"/>
          </ac:grpSpMkLst>
        </pc:grpChg>
        <pc:grpChg chg="add mod">
          <ac:chgData name="Rachel Lamerton" userId="2a274aa9-6826-4a05-8322-4d00fae19a96" providerId="ADAL" clId="{FC032B4E-A85A-481D-B6DB-3B866703A0B6}" dt="2025-08-25T10:46:18.190" v="577" actId="1038"/>
          <ac:grpSpMkLst>
            <pc:docMk/>
            <pc:sldMk cId="3776733224" sldId="284"/>
            <ac:grpSpMk id="42" creationId="{44CCF177-DB1F-4E1A-950C-6E105DC57651}"/>
          </ac:grpSpMkLst>
        </pc:grpChg>
        <pc:grpChg chg="add del mod">
          <ac:chgData name="Rachel Lamerton" userId="2a274aa9-6826-4a05-8322-4d00fae19a96" providerId="ADAL" clId="{FC032B4E-A85A-481D-B6DB-3B866703A0B6}" dt="2025-08-25T10:31:54.465" v="218"/>
          <ac:grpSpMkLst>
            <pc:docMk/>
            <pc:sldMk cId="3776733224" sldId="284"/>
            <ac:grpSpMk id="48" creationId="{DB53909F-BBA6-4553-A7F7-885468B1A7FB}"/>
          </ac:grpSpMkLst>
        </pc:grpChg>
        <pc:grpChg chg="add del mod">
          <ac:chgData name="Rachel Lamerton" userId="2a274aa9-6826-4a05-8322-4d00fae19a96" providerId="ADAL" clId="{FC032B4E-A85A-481D-B6DB-3B866703A0B6}" dt="2025-08-25T10:31:54.465" v="218"/>
          <ac:grpSpMkLst>
            <pc:docMk/>
            <pc:sldMk cId="3776733224" sldId="284"/>
            <ac:grpSpMk id="55" creationId="{5ACA6966-1A78-4A97-BAF1-D14412FF73A8}"/>
          </ac:grpSpMkLst>
        </pc:grpChg>
        <pc:grpChg chg="add del mod">
          <ac:chgData name="Rachel Lamerton" userId="2a274aa9-6826-4a05-8322-4d00fae19a96" providerId="ADAL" clId="{FC032B4E-A85A-481D-B6DB-3B866703A0B6}" dt="2025-08-25T10:32:27.514" v="224" actId="478"/>
          <ac:grpSpMkLst>
            <pc:docMk/>
            <pc:sldMk cId="3776733224" sldId="284"/>
            <ac:grpSpMk id="67" creationId="{9CD65713-D651-49FA-8282-2827AD5F6DC7}"/>
          </ac:grpSpMkLst>
        </pc:grpChg>
        <pc:grpChg chg="add mod topLvl">
          <ac:chgData name="Rachel Lamerton" userId="2a274aa9-6826-4a05-8322-4d00fae19a96" providerId="ADAL" clId="{FC032B4E-A85A-481D-B6DB-3B866703A0B6}" dt="2025-08-25T10:34:55.672" v="276" actId="164"/>
          <ac:grpSpMkLst>
            <pc:docMk/>
            <pc:sldMk cId="3776733224" sldId="284"/>
            <ac:grpSpMk id="74" creationId="{94C0C3B5-D733-4840-B168-96C3EFC8AE38}"/>
          </ac:grpSpMkLst>
        </pc:grpChg>
        <pc:grpChg chg="add del mod">
          <ac:chgData name="Rachel Lamerton" userId="2a274aa9-6826-4a05-8322-4d00fae19a96" providerId="ADAL" clId="{FC032B4E-A85A-481D-B6DB-3B866703A0B6}" dt="2025-08-25T10:34:30.925" v="252" actId="165"/>
          <ac:grpSpMkLst>
            <pc:docMk/>
            <pc:sldMk cId="3776733224" sldId="284"/>
            <ac:grpSpMk id="81" creationId="{2DF19B3C-58F5-4F88-91A9-EBBF31D2003D}"/>
          </ac:grpSpMkLst>
        </pc:grpChg>
        <pc:grpChg chg="add mod">
          <ac:chgData name="Rachel Lamerton" userId="2a274aa9-6826-4a05-8322-4d00fae19a96" providerId="ADAL" clId="{FC032B4E-A85A-481D-B6DB-3B866703A0B6}" dt="2025-08-25T10:36:09.070" v="315" actId="1038"/>
          <ac:grpSpMkLst>
            <pc:docMk/>
            <pc:sldMk cId="3776733224" sldId="284"/>
            <ac:grpSpMk id="82" creationId="{1E0CD2D5-39B5-48C0-A4F5-7600D5DC6CF2}"/>
          </ac:grpSpMkLst>
        </pc:grpChg>
        <pc:grpChg chg="add del mod">
          <ac:chgData name="Rachel Lamerton" userId="2a274aa9-6826-4a05-8322-4d00fae19a96" providerId="ADAL" clId="{FC032B4E-A85A-481D-B6DB-3B866703A0B6}" dt="2025-08-25T10:37:05.195" v="346" actId="165"/>
          <ac:grpSpMkLst>
            <pc:docMk/>
            <pc:sldMk cId="3776733224" sldId="284"/>
            <ac:grpSpMk id="83" creationId="{9E6A56D1-F0FA-4B44-8025-C9B2520026CA}"/>
          </ac:grpSpMkLst>
        </pc:grpChg>
        <pc:grpChg chg="del mod topLvl">
          <ac:chgData name="Rachel Lamerton" userId="2a274aa9-6826-4a05-8322-4d00fae19a96" providerId="ADAL" clId="{FC032B4E-A85A-481D-B6DB-3B866703A0B6}" dt="2025-08-25T10:37:27.406" v="349" actId="478"/>
          <ac:grpSpMkLst>
            <pc:docMk/>
            <pc:sldMk cId="3776733224" sldId="284"/>
            <ac:grpSpMk id="90" creationId="{890DA192-2C8B-4E61-9FEE-202AEDA02DFB}"/>
          </ac:grpSpMkLst>
        </pc:grpChg>
        <pc:grpChg chg="mod topLvl">
          <ac:chgData name="Rachel Lamerton" userId="2a274aa9-6826-4a05-8322-4d00fae19a96" providerId="ADAL" clId="{FC032B4E-A85A-481D-B6DB-3B866703A0B6}" dt="2025-08-25T10:45:39.915" v="559" actId="165"/>
          <ac:grpSpMkLst>
            <pc:docMk/>
            <pc:sldMk cId="3776733224" sldId="284"/>
            <ac:grpSpMk id="92" creationId="{B606B993-E030-4D2D-972B-0CD5346B9890}"/>
          </ac:grpSpMkLst>
        </pc:grpChg>
        <pc:grpChg chg="del mod topLvl">
          <ac:chgData name="Rachel Lamerton" userId="2a274aa9-6826-4a05-8322-4d00fae19a96" providerId="ADAL" clId="{FC032B4E-A85A-481D-B6DB-3B866703A0B6}" dt="2025-08-25T10:37:07.374" v="347" actId="478"/>
          <ac:grpSpMkLst>
            <pc:docMk/>
            <pc:sldMk cId="3776733224" sldId="284"/>
            <ac:grpSpMk id="93" creationId="{770D2BBB-DF7E-41D0-B0AB-4CFE01088204}"/>
          </ac:grpSpMkLst>
        </pc:grpChg>
        <pc:grpChg chg="add del mod">
          <ac:chgData name="Rachel Lamerton" userId="2a274aa9-6826-4a05-8322-4d00fae19a96" providerId="ADAL" clId="{FC032B4E-A85A-481D-B6DB-3B866703A0B6}" dt="2025-08-25T10:37:33.088" v="352" actId="478"/>
          <ac:grpSpMkLst>
            <pc:docMk/>
            <pc:sldMk cId="3776733224" sldId="284"/>
            <ac:grpSpMk id="122" creationId="{98AFDBAB-BBCF-4DD2-9D0A-E7096013A6D5}"/>
          </ac:grpSpMkLst>
        </pc:grpChg>
        <pc:grpChg chg="mod">
          <ac:chgData name="Rachel Lamerton" userId="2a274aa9-6826-4a05-8322-4d00fae19a96" providerId="ADAL" clId="{FC032B4E-A85A-481D-B6DB-3B866703A0B6}" dt="2025-08-25T10:37:31.636" v="351"/>
          <ac:grpSpMkLst>
            <pc:docMk/>
            <pc:sldMk cId="3776733224" sldId="284"/>
            <ac:grpSpMk id="129" creationId="{21CCDB68-EB0F-4470-8A5F-DCDE55CD3422}"/>
          </ac:grpSpMkLst>
        </pc:grpChg>
        <pc:grpChg chg="mod">
          <ac:chgData name="Rachel Lamerton" userId="2a274aa9-6826-4a05-8322-4d00fae19a96" providerId="ADAL" clId="{FC032B4E-A85A-481D-B6DB-3B866703A0B6}" dt="2025-08-25T10:37:31.636" v="351"/>
          <ac:grpSpMkLst>
            <pc:docMk/>
            <pc:sldMk cId="3776733224" sldId="284"/>
            <ac:grpSpMk id="131" creationId="{6935280D-D33E-43FE-A74F-10923CDBADAE}"/>
          </ac:grpSpMkLst>
        </pc:grpChg>
        <pc:grpChg chg="mod">
          <ac:chgData name="Rachel Lamerton" userId="2a274aa9-6826-4a05-8322-4d00fae19a96" providerId="ADAL" clId="{FC032B4E-A85A-481D-B6DB-3B866703A0B6}" dt="2025-08-25T10:37:31.636" v="351"/>
          <ac:grpSpMkLst>
            <pc:docMk/>
            <pc:sldMk cId="3776733224" sldId="284"/>
            <ac:grpSpMk id="132" creationId="{CB2EE941-4459-46F1-AA56-871EF313AE69}"/>
          </ac:grpSpMkLst>
        </pc:grpChg>
        <pc:grpChg chg="add mod">
          <ac:chgData name="Rachel Lamerton" userId="2a274aa9-6826-4a05-8322-4d00fae19a96" providerId="ADAL" clId="{FC032B4E-A85A-481D-B6DB-3B866703A0B6}" dt="2025-08-25T10:38:05.474" v="360" actId="164"/>
          <ac:grpSpMkLst>
            <pc:docMk/>
            <pc:sldMk cId="3776733224" sldId="284"/>
            <ac:grpSpMk id="162" creationId="{93571A2A-71DC-40B3-B5FB-6BE249F48283}"/>
          </ac:grpSpMkLst>
        </pc:grpChg>
        <pc:grpChg chg="add del mod">
          <ac:chgData name="Rachel Lamerton" userId="2a274aa9-6826-4a05-8322-4d00fae19a96" providerId="ADAL" clId="{FC032B4E-A85A-481D-B6DB-3B866703A0B6}" dt="2025-08-25T10:38:44.110" v="369" actId="165"/>
          <ac:grpSpMkLst>
            <pc:docMk/>
            <pc:sldMk cId="3776733224" sldId="284"/>
            <ac:grpSpMk id="163" creationId="{C2C495C3-3F89-4873-8D76-E6E1B721EF37}"/>
          </ac:grpSpMkLst>
        </pc:grpChg>
        <pc:grpChg chg="add del mod">
          <ac:chgData name="Rachel Lamerton" userId="2a274aa9-6826-4a05-8322-4d00fae19a96" providerId="ADAL" clId="{FC032B4E-A85A-481D-B6DB-3B866703A0B6}" dt="2025-08-25T10:45:39.915" v="559" actId="165"/>
          <ac:grpSpMkLst>
            <pc:docMk/>
            <pc:sldMk cId="3776733224" sldId="284"/>
            <ac:grpSpMk id="164" creationId="{075A3406-7FB9-4B5B-9403-E5FEC4DAF950}"/>
          </ac:grpSpMkLst>
        </pc:grpChg>
        <pc:grpChg chg="add del mod">
          <ac:chgData name="Rachel Lamerton" userId="2a274aa9-6826-4a05-8322-4d00fae19a96" providerId="ADAL" clId="{FC032B4E-A85A-481D-B6DB-3B866703A0B6}" dt="2025-08-25T10:39:26.788" v="397" actId="165"/>
          <ac:grpSpMkLst>
            <pc:docMk/>
            <pc:sldMk cId="3776733224" sldId="284"/>
            <ac:grpSpMk id="165" creationId="{89894528-6BE9-4A99-9002-469235D0D945}"/>
          </ac:grpSpMkLst>
        </pc:grpChg>
        <pc:grpChg chg="del mod topLvl">
          <ac:chgData name="Rachel Lamerton" userId="2a274aa9-6826-4a05-8322-4d00fae19a96" providerId="ADAL" clId="{FC032B4E-A85A-481D-B6DB-3B866703A0B6}" dt="2025-08-25T10:39:37.286" v="399" actId="478"/>
          <ac:grpSpMkLst>
            <pc:docMk/>
            <pc:sldMk cId="3776733224" sldId="284"/>
            <ac:grpSpMk id="172" creationId="{D7E44807-A634-4C61-A398-64F4DF9301D9}"/>
          </ac:grpSpMkLst>
        </pc:grpChg>
        <pc:grpChg chg="mod topLvl">
          <ac:chgData name="Rachel Lamerton" userId="2a274aa9-6826-4a05-8322-4d00fae19a96" providerId="ADAL" clId="{FC032B4E-A85A-481D-B6DB-3B866703A0B6}" dt="2025-08-25T10:44:48.278" v="547" actId="1035"/>
          <ac:grpSpMkLst>
            <pc:docMk/>
            <pc:sldMk cId="3776733224" sldId="284"/>
            <ac:grpSpMk id="174" creationId="{E41C1660-62EE-4350-8F24-ABCD27404BB4}"/>
          </ac:grpSpMkLst>
        </pc:grpChg>
        <pc:grpChg chg="del mod topLvl">
          <ac:chgData name="Rachel Lamerton" userId="2a274aa9-6826-4a05-8322-4d00fae19a96" providerId="ADAL" clId="{FC032B4E-A85A-481D-B6DB-3B866703A0B6}" dt="2025-08-25T10:39:32.730" v="398" actId="478"/>
          <ac:grpSpMkLst>
            <pc:docMk/>
            <pc:sldMk cId="3776733224" sldId="284"/>
            <ac:grpSpMk id="175" creationId="{DF9E501E-C085-476C-8809-9E539A9D8D4A}"/>
          </ac:grpSpMkLst>
        </pc:grpChg>
        <pc:grpChg chg="add del mod">
          <ac:chgData name="Rachel Lamerton" userId="2a274aa9-6826-4a05-8322-4d00fae19a96" providerId="ADAL" clId="{FC032B4E-A85A-481D-B6DB-3B866703A0B6}" dt="2025-08-25T10:44:42.386" v="537" actId="165"/>
          <ac:grpSpMkLst>
            <pc:docMk/>
            <pc:sldMk cId="3776733224" sldId="284"/>
            <ac:grpSpMk id="205" creationId="{94F30CD1-5EEE-4B84-95B3-4745EDA15DCC}"/>
          </ac:grpSpMkLst>
        </pc:grpChg>
        <pc:grpChg chg="add mod">
          <ac:chgData name="Rachel Lamerton" userId="2a274aa9-6826-4a05-8322-4d00fae19a96" providerId="ADAL" clId="{FC032B4E-A85A-481D-B6DB-3B866703A0B6}" dt="2025-08-25T10:46:10.626" v="568" actId="1037"/>
          <ac:grpSpMkLst>
            <pc:docMk/>
            <pc:sldMk cId="3776733224" sldId="284"/>
            <ac:grpSpMk id="206" creationId="{D9DB1ED6-521E-43F1-8CB8-B69E67D72877}"/>
          </ac:grpSpMkLst>
        </pc:grpChg>
        <pc:picChg chg="mod">
          <ac:chgData name="Rachel Lamerton" userId="2a274aa9-6826-4a05-8322-4d00fae19a96" providerId="ADAL" clId="{FC032B4E-A85A-481D-B6DB-3B866703A0B6}" dt="2025-08-25T10:24:11.111" v="14"/>
          <ac:picMkLst>
            <pc:docMk/>
            <pc:sldMk cId="3776733224" sldId="284"/>
            <ac:picMk id="5" creationId="{DFC4357A-7C8B-486E-AA1A-9DDE29E5188B}"/>
          </ac:picMkLst>
        </pc:picChg>
        <pc:picChg chg="mod topLvl">
          <ac:chgData name="Rachel Lamerton" userId="2a274aa9-6826-4a05-8322-4d00fae19a96" providerId="ADAL" clId="{FC032B4E-A85A-481D-B6DB-3B866703A0B6}" dt="2025-08-25T10:43:04.464" v="470" actId="165"/>
          <ac:picMkLst>
            <pc:docMk/>
            <pc:sldMk cId="3776733224" sldId="284"/>
            <ac:picMk id="30" creationId="{76915F4F-B134-476E-8064-83C89231304A}"/>
          </ac:picMkLst>
        </pc:picChg>
        <pc:picChg chg="mod topLvl">
          <ac:chgData name="Rachel Lamerton" userId="2a274aa9-6826-4a05-8322-4d00fae19a96" providerId="ADAL" clId="{FC032B4E-A85A-481D-B6DB-3B866703A0B6}" dt="2025-08-25T10:46:36.856" v="580" actId="14100"/>
          <ac:picMkLst>
            <pc:docMk/>
            <pc:sldMk cId="3776733224" sldId="284"/>
            <ac:picMk id="36" creationId="{ED7DF5EE-C52D-4CF4-9ED7-4C16B8EED318}"/>
          </ac:picMkLst>
        </pc:picChg>
        <pc:picChg chg="add del mod">
          <ac:chgData name="Rachel Lamerton" userId="2a274aa9-6826-4a05-8322-4d00fae19a96" providerId="ADAL" clId="{FC032B4E-A85A-481D-B6DB-3B866703A0B6}" dt="2025-08-25T10:31:54.465" v="218"/>
          <ac:picMkLst>
            <pc:docMk/>
            <pc:sldMk cId="3776733224" sldId="284"/>
            <ac:picMk id="47" creationId="{26AE58E3-0251-43F8-A523-A96FF01C493F}"/>
          </ac:picMkLst>
        </pc:picChg>
        <pc:picChg chg="add del mod">
          <ac:chgData name="Rachel Lamerton" userId="2a274aa9-6826-4a05-8322-4d00fae19a96" providerId="ADAL" clId="{FC032B4E-A85A-481D-B6DB-3B866703A0B6}" dt="2025-08-25T10:31:54.465" v="218"/>
          <ac:picMkLst>
            <pc:docMk/>
            <pc:sldMk cId="3776733224" sldId="284"/>
            <ac:picMk id="54" creationId="{9912D6E1-764D-4969-9016-B055D6EF8B26}"/>
          </ac:picMkLst>
        </pc:picChg>
        <pc:picChg chg="add mod topLvl modCrop">
          <ac:chgData name="Rachel Lamerton" userId="2a274aa9-6826-4a05-8322-4d00fae19a96" providerId="ADAL" clId="{FC032B4E-A85A-481D-B6DB-3B866703A0B6}" dt="2025-08-25T10:34:55.672" v="276" actId="164"/>
          <ac:picMkLst>
            <pc:docMk/>
            <pc:sldMk cId="3776733224" sldId="284"/>
            <ac:picMk id="61" creationId="{E0AAB73C-D1F5-4407-843C-752C8ED43B9A}"/>
          </ac:picMkLst>
        </pc:picChg>
        <pc:picChg chg="add del mod">
          <ac:chgData name="Rachel Lamerton" userId="2a274aa9-6826-4a05-8322-4d00fae19a96" providerId="ADAL" clId="{FC032B4E-A85A-481D-B6DB-3B866703A0B6}" dt="2025-08-25T10:32:29.048" v="225" actId="478"/>
          <ac:picMkLst>
            <pc:docMk/>
            <pc:sldMk cId="3776733224" sldId="284"/>
            <ac:picMk id="66" creationId="{D6AC9BDB-4FB0-47E5-9473-76F03C8544AD}"/>
          </ac:picMkLst>
        </pc:picChg>
        <pc:picChg chg="add mod topLvl">
          <ac:chgData name="Rachel Lamerton" userId="2a274aa9-6826-4a05-8322-4d00fae19a96" providerId="ADAL" clId="{FC032B4E-A85A-481D-B6DB-3B866703A0B6}" dt="2025-08-25T10:34:55.672" v="276" actId="164"/>
          <ac:picMkLst>
            <pc:docMk/>
            <pc:sldMk cId="3776733224" sldId="284"/>
            <ac:picMk id="73" creationId="{C1D15058-63FA-41DF-8200-A81253EDCD38}"/>
          </ac:picMkLst>
        </pc:picChg>
        <pc:picChg chg="mod topLvl modCrop">
          <ac:chgData name="Rachel Lamerton" userId="2a274aa9-6826-4a05-8322-4d00fae19a96" providerId="ADAL" clId="{FC032B4E-A85A-481D-B6DB-3B866703A0B6}" dt="2025-08-25T10:45:39.915" v="559" actId="165"/>
          <ac:picMkLst>
            <pc:docMk/>
            <pc:sldMk cId="3776733224" sldId="284"/>
            <ac:picMk id="84" creationId="{B5AAF220-5121-4C4F-A5B4-06989DDFF6A1}"/>
          </ac:picMkLst>
        </pc:picChg>
        <pc:picChg chg="del mod topLvl">
          <ac:chgData name="Rachel Lamerton" userId="2a274aa9-6826-4a05-8322-4d00fae19a96" providerId="ADAL" clId="{FC032B4E-A85A-481D-B6DB-3B866703A0B6}" dt="2025-08-25T10:37:28.421" v="350" actId="478"/>
          <ac:picMkLst>
            <pc:docMk/>
            <pc:sldMk cId="3776733224" sldId="284"/>
            <ac:picMk id="89" creationId="{CEE7BAD9-F40A-4270-8AD6-E87144C3ABC6}"/>
          </ac:picMkLst>
        </pc:picChg>
        <pc:picChg chg="mod topLvl">
          <ac:chgData name="Rachel Lamerton" userId="2a274aa9-6826-4a05-8322-4d00fae19a96" providerId="ADAL" clId="{FC032B4E-A85A-481D-B6DB-3B866703A0B6}" dt="2025-08-25T10:45:39.915" v="559" actId="165"/>
          <ac:picMkLst>
            <pc:docMk/>
            <pc:sldMk cId="3776733224" sldId="284"/>
            <ac:picMk id="91" creationId="{49BF961F-0B9B-4371-856D-098FC2ECEBB1}"/>
          </ac:picMkLst>
        </pc:picChg>
        <pc:picChg chg="mod">
          <ac:chgData name="Rachel Lamerton" userId="2a274aa9-6826-4a05-8322-4d00fae19a96" providerId="ADAL" clId="{FC032B4E-A85A-481D-B6DB-3B866703A0B6}" dt="2025-08-25T10:37:31.636" v="351"/>
          <ac:picMkLst>
            <pc:docMk/>
            <pc:sldMk cId="3776733224" sldId="284"/>
            <ac:picMk id="123" creationId="{EBD1606E-C6A1-4DB6-A11D-574DE775AA42}"/>
          </ac:picMkLst>
        </pc:picChg>
        <pc:picChg chg="mod">
          <ac:chgData name="Rachel Lamerton" userId="2a274aa9-6826-4a05-8322-4d00fae19a96" providerId="ADAL" clId="{FC032B4E-A85A-481D-B6DB-3B866703A0B6}" dt="2025-08-25T10:37:31.636" v="351"/>
          <ac:picMkLst>
            <pc:docMk/>
            <pc:sldMk cId="3776733224" sldId="284"/>
            <ac:picMk id="128" creationId="{E676C2AD-F10A-4F42-B098-F313970C6D13}"/>
          </ac:picMkLst>
        </pc:picChg>
        <pc:picChg chg="mod">
          <ac:chgData name="Rachel Lamerton" userId="2a274aa9-6826-4a05-8322-4d00fae19a96" providerId="ADAL" clId="{FC032B4E-A85A-481D-B6DB-3B866703A0B6}" dt="2025-08-25T10:37:31.636" v="351"/>
          <ac:picMkLst>
            <pc:docMk/>
            <pc:sldMk cId="3776733224" sldId="284"/>
            <ac:picMk id="130" creationId="{814AE94D-9364-42A2-BF41-CB66AB19652F}"/>
          </ac:picMkLst>
        </pc:picChg>
        <pc:picChg chg="mod topLvl modCrop">
          <ac:chgData name="Rachel Lamerton" userId="2a274aa9-6826-4a05-8322-4d00fae19a96" providerId="ADAL" clId="{FC032B4E-A85A-481D-B6DB-3B866703A0B6}" dt="2025-08-25T10:44:42.386" v="537" actId="165"/>
          <ac:picMkLst>
            <pc:docMk/>
            <pc:sldMk cId="3776733224" sldId="284"/>
            <ac:picMk id="166" creationId="{AB0C7D57-303E-4D77-8092-FC0703A71CA1}"/>
          </ac:picMkLst>
        </pc:picChg>
        <pc:picChg chg="del mod topLvl">
          <ac:chgData name="Rachel Lamerton" userId="2a274aa9-6826-4a05-8322-4d00fae19a96" providerId="ADAL" clId="{FC032B4E-A85A-481D-B6DB-3B866703A0B6}" dt="2025-08-25T10:39:38.231" v="400" actId="478"/>
          <ac:picMkLst>
            <pc:docMk/>
            <pc:sldMk cId="3776733224" sldId="284"/>
            <ac:picMk id="171" creationId="{EB65CBC4-4348-421C-B303-F8D8F626F287}"/>
          </ac:picMkLst>
        </pc:picChg>
        <pc:picChg chg="mod topLvl">
          <ac:chgData name="Rachel Lamerton" userId="2a274aa9-6826-4a05-8322-4d00fae19a96" providerId="ADAL" clId="{FC032B4E-A85A-481D-B6DB-3B866703A0B6}" dt="2025-08-25T10:44:42.386" v="537" actId="165"/>
          <ac:picMkLst>
            <pc:docMk/>
            <pc:sldMk cId="3776733224" sldId="284"/>
            <ac:picMk id="173" creationId="{90A86EA0-7AC7-4A17-8B62-2DA0F84245CA}"/>
          </ac:picMkLst>
        </pc:picChg>
        <pc:cxnChg chg="add del mod">
          <ac:chgData name="Rachel Lamerton" userId="2a274aa9-6826-4a05-8322-4d00fae19a96" providerId="ADAL" clId="{FC032B4E-A85A-481D-B6DB-3B866703A0B6}" dt="2025-08-25T10:46:19.681" v="578" actId="478"/>
          <ac:cxnSpMkLst>
            <pc:docMk/>
            <pc:sldMk cId="3776733224" sldId="284"/>
            <ac:cxnSpMk id="208" creationId="{7B4AC5DF-5057-44E3-81BB-5C4D839E2B13}"/>
          </ac:cxnSpMkLst>
        </pc:cxnChg>
        <pc:cxnChg chg="add del mod">
          <ac:chgData name="Rachel Lamerton" userId="2a274aa9-6826-4a05-8322-4d00fae19a96" providerId="ADAL" clId="{FC032B4E-A85A-481D-B6DB-3B866703A0B6}" dt="2025-08-25T10:55:41.240" v="996" actId="478"/>
          <ac:cxnSpMkLst>
            <pc:docMk/>
            <pc:sldMk cId="3776733224" sldId="284"/>
            <ac:cxnSpMk id="213" creationId="{F4BD3EE9-AECD-4B18-B8A8-14CC581989D2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7342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670574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072528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55079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57722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33606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2488000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17840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546395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68820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21163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88C4E-365C-465B-81E5-F7F415F9E744}" type="datetimeFigureOut">
              <a:rPr lang="en-IE" smtClean="0"/>
              <a:t>25/08/2025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A832B1-03A3-4D2E-9C2B-92A179F53C47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231737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oleObject" Target="../embeddings/oleObject7.bin"/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12" Type="http://schemas.openxmlformats.org/officeDocument/2006/relationships/image" Target="../media/image7.png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6.emf"/><Relationship Id="rId5" Type="http://schemas.openxmlformats.org/officeDocument/2006/relationships/image" Target="../media/image3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5.emf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image" Target="../media/image9.emf"/><Relationship Id="rId7" Type="http://schemas.openxmlformats.org/officeDocument/2006/relationships/image" Target="../media/image11.emf"/><Relationship Id="rId12" Type="http://schemas.openxmlformats.org/officeDocument/2006/relationships/image" Target="../media/image7.png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3.emf"/><Relationship Id="rId5" Type="http://schemas.openxmlformats.org/officeDocument/2006/relationships/image" Target="../media/image10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6.emf"/><Relationship Id="rId12" Type="http://schemas.openxmlformats.org/officeDocument/2006/relationships/oleObject" Target="../embeddings/oleObject18.bin"/><Relationship Id="rId2" Type="http://schemas.openxmlformats.org/officeDocument/2006/relationships/oleObject" Target="../embeddings/oleObject1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18.emf"/><Relationship Id="rId5" Type="http://schemas.openxmlformats.org/officeDocument/2006/relationships/image" Target="../media/image15.emf"/><Relationship Id="rId10" Type="http://schemas.openxmlformats.org/officeDocument/2006/relationships/oleObject" Target="../embeddings/oleObject17.bin"/><Relationship Id="rId4" Type="http://schemas.openxmlformats.org/officeDocument/2006/relationships/oleObject" Target="../embeddings/oleObject14.bin"/><Relationship Id="rId9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png"/><Relationship Id="rId13" Type="http://schemas.openxmlformats.org/officeDocument/2006/relationships/image" Target="../media/image31.png"/><Relationship Id="rId18" Type="http://schemas.openxmlformats.org/officeDocument/2006/relationships/image" Target="../media/image36.png"/><Relationship Id="rId3" Type="http://schemas.openxmlformats.org/officeDocument/2006/relationships/image" Target="../media/image21.emf"/><Relationship Id="rId7" Type="http://schemas.openxmlformats.org/officeDocument/2006/relationships/image" Target="../media/image25.png"/><Relationship Id="rId12" Type="http://schemas.openxmlformats.org/officeDocument/2006/relationships/image" Target="../media/image30.png"/><Relationship Id="rId17" Type="http://schemas.openxmlformats.org/officeDocument/2006/relationships/image" Target="../media/image35.png"/><Relationship Id="rId2" Type="http://schemas.openxmlformats.org/officeDocument/2006/relationships/image" Target="../media/image20.png"/><Relationship Id="rId16" Type="http://schemas.openxmlformats.org/officeDocument/2006/relationships/image" Target="../media/image3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11" Type="http://schemas.openxmlformats.org/officeDocument/2006/relationships/image" Target="../media/image29.png"/><Relationship Id="rId5" Type="http://schemas.openxmlformats.org/officeDocument/2006/relationships/image" Target="../media/image23.png"/><Relationship Id="rId15" Type="http://schemas.openxmlformats.org/officeDocument/2006/relationships/image" Target="../media/image33.png"/><Relationship Id="rId10" Type="http://schemas.openxmlformats.org/officeDocument/2006/relationships/image" Target="../media/image28.png"/><Relationship Id="rId4" Type="http://schemas.openxmlformats.org/officeDocument/2006/relationships/image" Target="../media/image22.png"/><Relationship Id="rId9" Type="http://schemas.openxmlformats.org/officeDocument/2006/relationships/image" Target="../media/image27.png"/><Relationship Id="rId1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7E7BB67F-5233-4E76-9815-9D88CFA07F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1191336"/>
              </p:ext>
            </p:extLst>
          </p:nvPr>
        </p:nvGraphicFramePr>
        <p:xfrm>
          <a:off x="566420" y="826149"/>
          <a:ext cx="5725160" cy="2849880"/>
        </p:xfrm>
        <a:graphic>
          <a:graphicData uri="http://schemas.openxmlformats.org/drawingml/2006/table">
            <a:tbl>
              <a:tblPr firstRow="1" firstCol="1" bandRow="1"/>
              <a:tblGrid>
                <a:gridCol w="795655">
                  <a:extLst>
                    <a:ext uri="{9D8B030D-6E8A-4147-A177-3AD203B41FA5}">
                      <a16:colId xmlns:a16="http://schemas.microsoft.com/office/drawing/2014/main" val="1446048403"/>
                    </a:ext>
                  </a:extLst>
                </a:gridCol>
                <a:gridCol w="1050925">
                  <a:extLst>
                    <a:ext uri="{9D8B030D-6E8A-4147-A177-3AD203B41FA5}">
                      <a16:colId xmlns:a16="http://schemas.microsoft.com/office/drawing/2014/main" val="3640651685"/>
                    </a:ext>
                  </a:extLst>
                </a:gridCol>
                <a:gridCol w="1315085">
                  <a:extLst>
                    <a:ext uri="{9D8B030D-6E8A-4147-A177-3AD203B41FA5}">
                      <a16:colId xmlns:a16="http://schemas.microsoft.com/office/drawing/2014/main" val="703077377"/>
                    </a:ext>
                  </a:extLst>
                </a:gridCol>
                <a:gridCol w="1311275">
                  <a:extLst>
                    <a:ext uri="{9D8B030D-6E8A-4147-A177-3AD203B41FA5}">
                      <a16:colId xmlns:a16="http://schemas.microsoft.com/office/drawing/2014/main" val="1140544848"/>
                    </a:ext>
                  </a:extLst>
                </a:gridCol>
                <a:gridCol w="1252220">
                  <a:extLst>
                    <a:ext uri="{9D8B030D-6E8A-4147-A177-3AD203B41FA5}">
                      <a16:colId xmlns:a16="http://schemas.microsoft.com/office/drawing/2014/main" val="287416818"/>
                    </a:ext>
                  </a:extLst>
                </a:gridCol>
              </a:tblGrid>
              <a:tr h="107950">
                <a:tc>
                  <a:txBody>
                    <a:bodyPr/>
                    <a:lstStyle/>
                    <a:p>
                      <a:pPr algn="just"/>
                      <a:r>
                        <a:rPr lang="en-US" sz="11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rker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one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orophore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endor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#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76573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6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UU-PL7F1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718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205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58526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42a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MA.16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5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43728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30588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CD36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B38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605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63518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2709959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9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F10B29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PC/Cy7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2917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360646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GPVI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Y10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1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43945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9739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M59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85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3148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7487137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3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C4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rCP/eFluor 71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hermo Fisher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6-0329-4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15187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LT-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842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2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8812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578148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62P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K-4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48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46444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71876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07a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4A3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5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580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97321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63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5C6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Cy7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6198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45182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D154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-2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/Dazzle 594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Legend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084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64791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3b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E7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V75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2741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63341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brinogen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exa Fluor 647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sher Scientific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-35200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802769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nexin V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/A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TC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D Bioscience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56419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44333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LR9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C593.2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E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vus Biologicals</a:t>
                      </a:r>
                      <a:endParaRPr lang="en-IE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/>
                      <a:r>
                        <a:rPr lang="en-US" sz="11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BP2-24729</a:t>
                      </a:r>
                      <a:endParaRPr lang="en-IE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435869"/>
                  </a:ext>
                </a:extLst>
              </a:tr>
            </a:tbl>
          </a:graphicData>
        </a:graphic>
      </p:graphicFrame>
      <p:sp>
        <p:nvSpPr>
          <p:cNvPr id="8" name="Rectangle 2">
            <a:extLst>
              <a:ext uri="{FF2B5EF4-FFF2-40B4-BE49-F238E27FC236}">
                <a16:creationId xmlns:a16="http://schemas.microsoft.com/office/drawing/2014/main" id="{C55A3107-C0C9-431B-8B97-BD7AAC8917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933" y="364484"/>
            <a:ext cx="592213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Table 1: Details of antibodies used for multispectral flow cytometry assays</a:t>
            </a:r>
            <a:endParaRPr kumimoji="0" lang="en-IE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Open Sans" panose="020B0606030504020204" pitchFamily="34" charset="0"/>
              </a:rPr>
              <a:t>*Antibodies were used in secondary stain (after fixation).</a:t>
            </a:r>
            <a:endParaRPr kumimoji="0" lang="en-GB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4190863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021FE4D-2154-4B69-AD06-7FB46B5F02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2636376"/>
              </p:ext>
            </p:extLst>
          </p:nvPr>
        </p:nvGraphicFramePr>
        <p:xfrm>
          <a:off x="1145165" y="720436"/>
          <a:ext cx="3308026" cy="38348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209169" imgH="3720727" progId="Prism10.Document">
                  <p:embed/>
                </p:oleObj>
              </mc:Choice>
              <mc:Fallback>
                <p:oleObj name="Prism 10" r:id="rId2" imgW="3209169" imgH="3720727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E021FE4D-2154-4B69-AD06-7FB46B5F02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45165" y="720436"/>
                        <a:ext cx="3308026" cy="38348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B88883D-AABF-4114-ADB2-05D716058C5D}"/>
              </a:ext>
            </a:extLst>
          </p:cNvPr>
          <p:cNvSpPr txBox="1"/>
          <p:nvPr/>
        </p:nvSpPr>
        <p:spPr>
          <a:xfrm>
            <a:off x="558752" y="4609553"/>
            <a:ext cx="596188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1: Whole blood (WB) and washed platelet (WP) responses to 3µg/ml CRP. </a:t>
            </a:r>
          </a:p>
          <a:p>
            <a:r>
              <a:rPr lang="en-GB" sz="1200" dirty="0"/>
              <a:t>Whole blood diluted 1 in 10 or washed platelets at 2x10</a:t>
            </a:r>
            <a:r>
              <a:rPr lang="en-GB" sz="1200" baseline="30000" dirty="0"/>
              <a:t>7 </a:t>
            </a:r>
            <a:r>
              <a:rPr lang="en-GB" sz="1200" dirty="0"/>
              <a:t>/ml were incubated either with 1 µM indomethacin and 10 µM ticagrelor, or vehicle control, before being stimulated with the positive control CRP at 3 µg/ml for 30 minutes. P-selectin expression was assessed using flow cytometry and results are expressed as median fluorescence intensity (MFI) or P-selectin antibody. n ≥ 6, bars represent SEM. </a:t>
            </a:r>
          </a:p>
        </p:txBody>
      </p:sp>
    </p:spTree>
    <p:extLst>
      <p:ext uri="{BB962C8B-B14F-4D97-AF65-F5344CB8AC3E}">
        <p14:creationId xmlns:p14="http://schemas.microsoft.com/office/powerpoint/2010/main" val="33539614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55027F6-7DB0-4AD2-B20C-9B9D06DBF450}"/>
              </a:ext>
            </a:extLst>
          </p:cNvPr>
          <p:cNvSpPr txBox="1"/>
          <p:nvPr/>
        </p:nvSpPr>
        <p:spPr>
          <a:xfrm>
            <a:off x="517973" y="7431533"/>
            <a:ext cx="5961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2: Multispectral flow cytometry can be used to assess multiple platelet markers in response to tetravalent nanobodies. </a:t>
            </a:r>
          </a:p>
          <a:p>
            <a:r>
              <a:rPr lang="en-GB" sz="1200" dirty="0"/>
              <a:t>Whole blood was diluted 1 in 10 in antibody cocktail and agonist and incubated for 30 minutes. Curves were fitted with non-linear regressions ([agonist] vs response – variable slope). n = 6, bars represent SEM. Black circles = Nb2-2-Fc stimulated; Teal squares = LUAS-2-Fc stimulated. </a:t>
            </a:r>
            <a:endParaRPr lang="en-IE" sz="1200" b="1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CE22D47-14F7-4EEF-AE6D-41D081E8C38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20685" y="308819"/>
          <a:ext cx="3344571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930521" imgH="2690272" progId="Prism10.Document">
                  <p:embed/>
                </p:oleObj>
              </mc:Choice>
              <mc:Fallback>
                <p:oleObj name="Prism 10" r:id="rId2" imgW="3930521" imgH="269027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CE22D47-14F7-4EEF-AE6D-41D081E8C3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20685" y="308819"/>
                        <a:ext cx="3344571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38595C4-6C91-4AED-9BDE-2BC162B6CA4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62985" y="2473368"/>
          <a:ext cx="3341870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927280" imgH="2690272" progId="Prism10.Document">
                  <p:embed/>
                </p:oleObj>
              </mc:Choice>
              <mc:Fallback>
                <p:oleObj name="Prism 10" r:id="rId4" imgW="3927280" imgH="269027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38595C4-6C91-4AED-9BDE-2BC162B6CA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2985" y="2473368"/>
                        <a:ext cx="3341870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5A6699C2-C22D-4D28-95FB-F4557C0254E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88813" y="2474467"/>
          <a:ext cx="3282435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857054" imgH="2690272" progId="Prism10.Document">
                  <p:embed/>
                </p:oleObj>
              </mc:Choice>
              <mc:Fallback>
                <p:oleObj name="Prism 10" r:id="rId6" imgW="3857054" imgH="2690272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5A6699C2-C22D-4D28-95FB-F4557C0254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88813" y="2474467"/>
                        <a:ext cx="3282435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134E3B64-FA66-48BD-94CB-80D3539880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972142"/>
              </p:ext>
            </p:extLst>
          </p:nvPr>
        </p:nvGraphicFramePr>
        <p:xfrm>
          <a:off x="163055" y="4636830"/>
          <a:ext cx="3344571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930521" imgH="2690272" progId="Prism10.Document">
                  <p:embed/>
                </p:oleObj>
              </mc:Choice>
              <mc:Fallback>
                <p:oleObj name="Prism 10" r:id="rId8" imgW="3930521" imgH="2690272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134E3B64-FA66-48BD-94CB-80D3539880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63055" y="4636830"/>
                        <a:ext cx="3344571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3B1BDDB8-7919-44E4-BE73-5AC5EC57ED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84196832"/>
              </p:ext>
            </p:extLst>
          </p:nvPr>
        </p:nvGraphicFramePr>
        <p:xfrm>
          <a:off x="171624" y="307720"/>
          <a:ext cx="3341870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927280" imgH="2690272" progId="Prism10.Document">
                  <p:embed/>
                </p:oleObj>
              </mc:Choice>
              <mc:Fallback>
                <p:oleObj name="Prism 10" r:id="rId10" imgW="3927280" imgH="2690272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3B1BDDB8-7919-44E4-BE73-5AC5EC57ED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1624" y="307720"/>
                        <a:ext cx="3341870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8C06EA3F-DBCD-40D9-9039-F4D27111FE6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56955" y="6905013"/>
            <a:ext cx="1263715" cy="482625"/>
          </a:xfrm>
          <a:prstGeom prst="rect">
            <a:avLst/>
          </a:prstGeom>
        </p:spPr>
      </p:pic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D414DAA-65AF-46B1-89B8-37FCCB6257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420607"/>
              </p:ext>
            </p:extLst>
          </p:nvPr>
        </p:nvGraphicFramePr>
        <p:xfrm>
          <a:off x="3638883" y="4641485"/>
          <a:ext cx="3095817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3693912" imgH="2731318" progId="Prism10.Document">
                  <p:embed/>
                </p:oleObj>
              </mc:Choice>
              <mc:Fallback>
                <p:oleObj name="Prism 10" r:id="rId13" imgW="3693912" imgH="2731318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D414DAA-65AF-46B1-89B8-37FCCB6257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638883" y="4641485"/>
                        <a:ext cx="3095817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375030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181E9BC-317F-4B7F-A7D1-A91EEF30F193}"/>
              </a:ext>
            </a:extLst>
          </p:cNvPr>
          <p:cNvSpPr txBox="1"/>
          <p:nvPr/>
        </p:nvSpPr>
        <p:spPr>
          <a:xfrm>
            <a:off x="479132" y="7022874"/>
            <a:ext cx="5961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3: Multispectral flow cytometry can be used to assess multiple platelet markers in response to tetravalent nanobodies </a:t>
            </a:r>
          </a:p>
          <a:p>
            <a:r>
              <a:rPr lang="en-GB" sz="1200" dirty="0"/>
              <a:t>Whole blood was diluted 1 in 10 in antibody cocktail and agonist and incubated for 30 minutes. Curves were fitted with non-linear regression ([agonist] vs response – variable slope). n = 6, bars represent SEM. Black circles = Nb2-2-Fc stimulated; Teal squares = LUAS-2-Fc stimulated. </a:t>
            </a:r>
            <a:endParaRPr lang="en-IE" sz="1200" b="1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15798AB-227E-48F6-8A5E-C589F395B01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376" y="306296"/>
          <a:ext cx="3344571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930521" imgH="2690272" progId="Prism10.Document">
                  <p:embed/>
                </p:oleObj>
              </mc:Choice>
              <mc:Fallback>
                <p:oleObj name="Prism 10" r:id="rId2" imgW="3930521" imgH="2690272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15798AB-227E-48F6-8A5E-C589F395B01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7376" y="306296"/>
                        <a:ext cx="3344571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9DCCB4C2-CC2F-4679-9F14-0A413ECF7F7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311854" y="310147"/>
          <a:ext cx="3409410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006510" imgH="2690272" progId="Prism10.Document">
                  <p:embed/>
                </p:oleObj>
              </mc:Choice>
              <mc:Fallback>
                <p:oleObj name="Prism 10" r:id="rId4" imgW="4006510" imgH="2690272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9DCCB4C2-CC2F-4679-9F14-0A413ECF7F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11854" y="310147"/>
                        <a:ext cx="3409410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75B8CDD-BE09-4976-BE0E-A46685E87E2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08" y="2467560"/>
          <a:ext cx="3410760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007950" imgH="2690272" progId="Prism10.Document">
                  <p:embed/>
                </p:oleObj>
              </mc:Choice>
              <mc:Fallback>
                <p:oleObj name="Prism 10" r:id="rId6" imgW="4007950" imgH="2690272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475B8CDD-BE09-4976-BE0E-A46685E87E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08" y="2467560"/>
                        <a:ext cx="3410760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390020B7-C0DF-4B3D-B48E-7A964FD43EB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29000" y="2467560"/>
          <a:ext cx="3282435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857054" imgH="2690272" progId="Prism10.Document">
                  <p:embed/>
                </p:oleObj>
              </mc:Choice>
              <mc:Fallback>
                <p:oleObj name="Prism 10" r:id="rId8" imgW="3857054" imgH="2690272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390020B7-C0DF-4B3D-B48E-7A964FD43E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429000" y="2467560"/>
                        <a:ext cx="3282435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3BD31DC-93AF-4BED-B84B-57EF048B1E5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2246" y="4644866"/>
          <a:ext cx="3275680" cy="2289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849491" imgH="2690272" progId="Prism10.Document">
                  <p:embed/>
                </p:oleObj>
              </mc:Choice>
              <mc:Fallback>
                <p:oleObj name="Prism 10" r:id="rId10" imgW="3849491" imgH="2690272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3BD31DC-93AF-4BED-B84B-57EF048B1E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22246" y="4644866"/>
                        <a:ext cx="3275680" cy="2289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50839176-A044-4FF5-AF7B-D8EBEBA41F2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71340" y="5104305"/>
            <a:ext cx="1263715" cy="4826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84760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41D25CD-0F16-4B26-8B15-EF5845FB65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7819803"/>
              </p:ext>
            </p:extLst>
          </p:nvPr>
        </p:nvGraphicFramePr>
        <p:xfrm>
          <a:off x="524894" y="2104665"/>
          <a:ext cx="3121200" cy="1366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265808" imgH="1867204" progId="Prism10.Document">
                  <p:embed/>
                </p:oleObj>
              </mc:Choice>
              <mc:Fallback>
                <p:oleObj name="Prism 10" r:id="rId2" imgW="4265808" imgH="1867204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41D25CD-0F16-4B26-8B15-EF5845FB65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4894" y="2104665"/>
                        <a:ext cx="3121200" cy="1366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3AFA7911-97DD-4BEB-82D4-D0878D80B46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6160507"/>
              </p:ext>
            </p:extLst>
          </p:nvPr>
        </p:nvGraphicFramePr>
        <p:xfrm>
          <a:off x="3531193" y="2127657"/>
          <a:ext cx="3121200" cy="1343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4338915" imgH="1867204" progId="Prism10.Document">
                  <p:embed/>
                </p:oleObj>
              </mc:Choice>
              <mc:Fallback>
                <p:oleObj name="Prism 10" r:id="rId4" imgW="4338915" imgH="1867204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3AFA7911-97DD-4BEB-82D4-D0878D80B46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531193" y="2127657"/>
                        <a:ext cx="3121200" cy="1343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FA0DEFA9-CBAA-4D80-BBE4-C16AA62216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81252"/>
              </p:ext>
            </p:extLst>
          </p:nvPr>
        </p:nvGraphicFramePr>
        <p:xfrm>
          <a:off x="524894" y="3458282"/>
          <a:ext cx="3121200" cy="1343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338915" imgH="1867204" progId="Prism10.Document">
                  <p:embed/>
                </p:oleObj>
              </mc:Choice>
              <mc:Fallback>
                <p:oleObj name="Prism 10" r:id="rId6" imgW="4338915" imgH="1867204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FA0DEFA9-CBAA-4D80-BBE4-C16AA62216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4894" y="3458282"/>
                        <a:ext cx="3121200" cy="1343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6ADCE15-C4BD-480E-B8BB-8DCBC2B33E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8765699"/>
              </p:ext>
            </p:extLst>
          </p:nvPr>
        </p:nvGraphicFramePr>
        <p:xfrm>
          <a:off x="3646094" y="3447277"/>
          <a:ext cx="3121200" cy="13660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265808" imgH="1867204" progId="Prism10.Document">
                  <p:embed/>
                </p:oleObj>
              </mc:Choice>
              <mc:Fallback>
                <p:oleObj name="Prism 10" r:id="rId8" imgW="4265808" imgH="1867204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6ADCE15-C4BD-480E-B8BB-8DCBC2B33E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46094" y="3447277"/>
                        <a:ext cx="3121200" cy="13660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64D18419-0FD0-4CD7-A0B9-3FB80D3A923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9222745"/>
              </p:ext>
            </p:extLst>
          </p:nvPr>
        </p:nvGraphicFramePr>
        <p:xfrm>
          <a:off x="542162" y="4823886"/>
          <a:ext cx="3121200" cy="13430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4338915" imgH="1867204" progId="Prism10.Document">
                  <p:embed/>
                </p:oleObj>
              </mc:Choice>
              <mc:Fallback>
                <p:oleObj name="Prism 10" r:id="rId10" imgW="4338915" imgH="1867204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64D18419-0FD0-4CD7-A0B9-3FB80D3A923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42162" y="4823886"/>
                        <a:ext cx="3121200" cy="13430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02FA06B1-25AA-45C2-90A9-9EF9F82ECC53}"/>
              </a:ext>
            </a:extLst>
          </p:cNvPr>
          <p:cNvSpPr txBox="1"/>
          <p:nvPr/>
        </p:nvSpPr>
        <p:spPr>
          <a:xfrm>
            <a:off x="3646094" y="5092691"/>
            <a:ext cx="33333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p. 04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/CD62P-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63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TLT-1-/Ann V-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p. 06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62P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CD63-/TLT-1-/Ann V-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p. 07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62P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CD63-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LT-1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Ann V-</a:t>
            </a:r>
          </a:p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op. 08 </a:t>
            </a:r>
            <a:r>
              <a:rPr lang="en-GB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62P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D63+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/TLT-1-/Ann V-</a:t>
            </a:r>
            <a:endParaRPr lang="en-I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C5341B8-C708-4A7F-8B70-D007A9973219}"/>
              </a:ext>
            </a:extLst>
          </p:cNvPr>
          <p:cNvSpPr txBox="1"/>
          <p:nvPr/>
        </p:nvSpPr>
        <p:spPr>
          <a:xfrm>
            <a:off x="550249" y="6579353"/>
            <a:ext cx="5961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4:  Analysis of the minor FAUST populations.</a:t>
            </a:r>
          </a:p>
          <a:p>
            <a:r>
              <a:rPr lang="en-GB" sz="1200" dirty="0"/>
              <a:t>A) Approximately 20% of the platelets stimulated by Nb2-2-Fc and LUAS-2-Fc, and 40% of the platelets stimulated by Nb138-2-Fc did not fall into the 8 categories identified by the FAUST analysis. B) Further population analysis was carried out to identify 4 additional subpopulations present at significant levels. Graphs presented as abundance of total platelet population. N = 6. Bars represent SEM.</a:t>
            </a:r>
            <a:endParaRPr lang="en-IE" sz="1200" dirty="0"/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4941BA28-D392-4525-893C-21B289669D2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7771703"/>
              </p:ext>
            </p:extLst>
          </p:nvPr>
        </p:nvGraphicFramePr>
        <p:xfrm>
          <a:off x="1371055" y="234532"/>
          <a:ext cx="3683862" cy="16365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6621095" imgH="2941585" progId="Prism10.Document">
                  <p:embed/>
                </p:oleObj>
              </mc:Choice>
              <mc:Fallback>
                <p:oleObj name="Prism 10" r:id="rId12" imgW="6621095" imgH="2941585" progId="Prism10.Document">
                  <p:embed/>
                  <p:pic>
                    <p:nvPicPr>
                      <p:cNvPr id="13" name="Object 12">
                        <a:extLst>
                          <a:ext uri="{FF2B5EF4-FFF2-40B4-BE49-F238E27FC236}">
                            <a16:creationId xmlns:a16="http://schemas.microsoft.com/office/drawing/2014/main" id="{4941BA28-D392-4525-893C-21B289669D2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371055" y="234532"/>
                        <a:ext cx="3683862" cy="16365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450E9E0F-0DF8-4152-93DD-C9B708C060E1}"/>
              </a:ext>
            </a:extLst>
          </p:cNvPr>
          <p:cNvSpPr txBox="1"/>
          <p:nvPr/>
        </p:nvSpPr>
        <p:spPr>
          <a:xfrm>
            <a:off x="920679" y="159430"/>
            <a:ext cx="450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)</a:t>
            </a:r>
            <a:endParaRPr lang="en-IE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DB0238-935A-45BC-895E-16D8BC34DE62}"/>
              </a:ext>
            </a:extLst>
          </p:cNvPr>
          <p:cNvSpPr txBox="1"/>
          <p:nvPr/>
        </p:nvSpPr>
        <p:spPr>
          <a:xfrm>
            <a:off x="91786" y="1856116"/>
            <a:ext cx="4503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)</a:t>
            </a:r>
            <a:endParaRPr lang="en-IE" dirty="0"/>
          </a:p>
        </p:txBody>
      </p:sp>
    </p:spTree>
    <p:extLst>
      <p:ext uri="{BB962C8B-B14F-4D97-AF65-F5344CB8AC3E}">
        <p14:creationId xmlns:p14="http://schemas.microsoft.com/office/powerpoint/2010/main" val="15870964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CFACC14-902A-4397-98D0-1C93E2424411}"/>
              </a:ext>
            </a:extLst>
          </p:cNvPr>
          <p:cNvSpPr txBox="1"/>
          <p:nvPr/>
        </p:nvSpPr>
        <p:spPr>
          <a:xfrm>
            <a:off x="181464" y="7777045"/>
            <a:ext cx="5961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5: Trajectory analysis of the multispectral flow cytometry data from platelets stimulated with tetramer nanobodies to GPVI (Nb2-2-Fc), CLEC-2 (LUAS-2-Fc) and PEAR-1 (Nb138-2-Fc). </a:t>
            </a:r>
          </a:p>
          <a:p>
            <a:r>
              <a:rPr lang="en-GB" sz="1200" dirty="0"/>
              <a:t>The single cell mapping algorithm PHATE was used to visualize the progression of platelet activation marker exposure. N=5. </a:t>
            </a:r>
            <a:endParaRPr lang="en-IE" sz="1200" b="1" dirty="0"/>
          </a:p>
        </p:txBody>
      </p:sp>
      <p:pic>
        <p:nvPicPr>
          <p:cNvPr id="5" name="Picture 4" descr="image.png">
            <a:extLst>
              <a:ext uri="{FF2B5EF4-FFF2-40B4-BE49-F238E27FC236}">
                <a16:creationId xmlns:a16="http://schemas.microsoft.com/office/drawing/2014/main" id="{115C758F-AF91-4141-9C2A-CB099E0FD9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6311" y="407050"/>
            <a:ext cx="1562882" cy="1648754"/>
          </a:xfrm>
          <a:prstGeom prst="rect">
            <a:avLst/>
          </a:prstGeom>
        </p:spPr>
      </p:pic>
      <p:sp>
        <p:nvSpPr>
          <p:cNvPr id="6" name="Freeform 123">
            <a:extLst>
              <a:ext uri="{FF2B5EF4-FFF2-40B4-BE49-F238E27FC236}">
                <a16:creationId xmlns:a16="http://schemas.microsoft.com/office/drawing/2014/main" id="{21C242C6-1D6E-4B4D-842C-E8B5ABF6D2CE}"/>
              </a:ext>
            </a:extLst>
          </p:cNvPr>
          <p:cNvSpPr/>
          <p:nvPr/>
        </p:nvSpPr>
        <p:spPr>
          <a:xfrm>
            <a:off x="1338901" y="520831"/>
            <a:ext cx="1292384" cy="1292384"/>
          </a:xfrm>
          <a:custGeom>
            <a:avLst/>
            <a:gdLst/>
            <a:ahLst/>
            <a:cxnLst/>
            <a:rect l="l" t="t" r="r" b="b"/>
            <a:pathLst>
              <a:path w="1615479" h="1615479">
                <a:moveTo>
                  <a:pt x="0" y="0"/>
                </a:moveTo>
                <a:lnTo>
                  <a:pt x="1615479" y="0"/>
                </a:lnTo>
                <a:lnTo>
                  <a:pt x="1615479" y="1615479"/>
                </a:lnTo>
                <a:lnTo>
                  <a:pt x="0" y="1615479"/>
                </a:lnTo>
                <a:close/>
              </a:path>
            </a:pathLst>
          </a:custGeom>
          <a:noFill/>
          <a:ln w="5366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sz="9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FD36B4-E847-490D-BE7D-3107970BF55D}"/>
              </a:ext>
            </a:extLst>
          </p:cNvPr>
          <p:cNvSpPr txBox="1"/>
          <p:nvPr/>
        </p:nvSpPr>
        <p:spPr>
          <a:xfrm>
            <a:off x="1775510" y="1899010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84EEED6-7760-421E-92D5-DB690A40A99D}"/>
              </a:ext>
            </a:extLst>
          </p:cNvPr>
          <p:cNvSpPr txBox="1"/>
          <p:nvPr/>
        </p:nvSpPr>
        <p:spPr>
          <a:xfrm rot="16200000">
            <a:off x="987597" y="109491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505E39C-DF22-4854-870A-3F42A48F6A7F}"/>
              </a:ext>
            </a:extLst>
          </p:cNvPr>
          <p:cNvSpPr txBox="1"/>
          <p:nvPr/>
        </p:nvSpPr>
        <p:spPr>
          <a:xfrm>
            <a:off x="1646789" y="216343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asal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ADD0B17B-DDBD-4E7B-AE4A-DC28FA339B6D}"/>
              </a:ext>
            </a:extLst>
          </p:cNvPr>
          <p:cNvGrpSpPr>
            <a:grpSpLocks noChangeAspect="1"/>
          </p:cNvGrpSpPr>
          <p:nvPr/>
        </p:nvGrpSpPr>
        <p:grpSpPr>
          <a:xfrm>
            <a:off x="2924665" y="529069"/>
            <a:ext cx="2791614" cy="1215573"/>
            <a:chOff x="455629" y="3512251"/>
            <a:chExt cx="2427490" cy="1057020"/>
          </a:xfrm>
        </p:grpSpPr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FDEEBEAF-504E-4D39-800D-07C45F5DEC0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3557074"/>
              <a:ext cx="114143" cy="61828"/>
            </a:xfrm>
            <a:prstGeom prst="rect">
              <a:avLst/>
            </a:prstGeom>
            <a:solidFill>
              <a:srgbClr val="1F77B3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F5BD4021-5415-4785-BD07-441D422EFE9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3648958"/>
              <a:ext cx="114143" cy="61828"/>
            </a:xfrm>
            <a:prstGeom prst="rect">
              <a:avLst/>
            </a:prstGeom>
            <a:solidFill>
              <a:srgbClr val="D62628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87BCAB7B-2A62-4C2C-AE46-1EBDEF39E2C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3740842"/>
              <a:ext cx="114143" cy="61828"/>
            </a:xfrm>
            <a:prstGeom prst="rect">
              <a:avLst/>
            </a:prstGeom>
            <a:solidFill>
              <a:srgbClr val="9C27D8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EC91B532-1E12-4FE5-92CC-3E235178B9C5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3832726"/>
              <a:ext cx="114143" cy="61828"/>
            </a:xfrm>
            <a:prstGeom prst="rect">
              <a:avLst/>
            </a:prstGeom>
            <a:solidFill>
              <a:srgbClr val="FAFB6B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0461AFED-6861-4F50-9244-1A7870A9FC1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3924610"/>
              <a:ext cx="114143" cy="61828"/>
            </a:xfrm>
            <a:prstGeom prst="rect">
              <a:avLst/>
            </a:prstGeom>
            <a:solidFill>
              <a:srgbClr val="B3B0B4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4132573F-07D8-4E3B-AB08-FDD3810FDD2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016494"/>
              <a:ext cx="114143" cy="61828"/>
            </a:xfrm>
            <a:prstGeom prst="rect">
              <a:avLst/>
            </a:prstGeom>
            <a:solidFill>
              <a:srgbClr val="FEAC64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88C71A06-8BC8-4DB1-A7A8-02FCDEDCC7B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108378"/>
              <a:ext cx="114143" cy="61828"/>
            </a:xfrm>
            <a:prstGeom prst="rect">
              <a:avLst/>
            </a:prstGeom>
            <a:solidFill>
              <a:srgbClr val="E67F26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4A147553-6BFA-4736-BC5F-485AB8F79FB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200262"/>
              <a:ext cx="114143" cy="61828"/>
            </a:xfrm>
            <a:prstGeom prst="rect">
              <a:avLst/>
            </a:prstGeom>
            <a:solidFill>
              <a:srgbClr val="27F11B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3" name="Rectangle 32">
              <a:extLst>
                <a:ext uri="{FF2B5EF4-FFF2-40B4-BE49-F238E27FC236}">
                  <a16:creationId xmlns:a16="http://schemas.microsoft.com/office/drawing/2014/main" id="{6749FE8C-7081-4615-8E2C-27076D0A569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292146"/>
              <a:ext cx="114143" cy="61828"/>
            </a:xfrm>
            <a:prstGeom prst="rect">
              <a:avLst/>
            </a:prstGeom>
            <a:solidFill>
              <a:srgbClr val="010101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BADFAB03-8725-4D0E-8C4E-FAC927CDA271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384030"/>
              <a:ext cx="114143" cy="61828"/>
            </a:xfrm>
            <a:prstGeom prst="rect">
              <a:avLst/>
            </a:prstGeom>
            <a:solidFill>
              <a:srgbClr val="A57449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327E3D13-F58D-4ADD-8432-B93BF9EF309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55629" y="4475918"/>
              <a:ext cx="114143" cy="61828"/>
            </a:xfrm>
            <a:prstGeom prst="rect">
              <a:avLst/>
            </a:prstGeom>
            <a:solidFill>
              <a:srgbClr val="2B0BC9"/>
            </a:solidFill>
            <a:ln w="1641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2797E7AF-E727-4812-84C6-3B48D9E3C54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9312"/>
            <a:stretch>
              <a:fillRect/>
            </a:stretch>
          </p:blipFill>
          <p:spPr>
            <a:xfrm>
              <a:off x="587056" y="3512251"/>
              <a:ext cx="2296063" cy="1057020"/>
            </a:xfrm>
            <a:prstGeom prst="rect">
              <a:avLst/>
            </a:prstGeom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E7789F7D-8831-41C8-8E48-09E894F099EB}"/>
              </a:ext>
            </a:extLst>
          </p:cNvPr>
          <p:cNvGrpSpPr>
            <a:grpSpLocks noChangeAspect="1"/>
          </p:cNvGrpSpPr>
          <p:nvPr/>
        </p:nvGrpSpPr>
        <p:grpSpPr>
          <a:xfrm>
            <a:off x="81351" y="2518884"/>
            <a:ext cx="1279689" cy="1350000"/>
            <a:chOff x="2155070" y="2821195"/>
            <a:chExt cx="1953601" cy="2060942"/>
          </a:xfrm>
        </p:grpSpPr>
        <p:pic>
          <p:nvPicPr>
            <p:cNvPr id="38" name="Picture 37" descr="image.png">
              <a:extLst>
                <a:ext uri="{FF2B5EF4-FFF2-40B4-BE49-F238E27FC236}">
                  <a16:creationId xmlns:a16="http://schemas.microsoft.com/office/drawing/2014/main" id="{5688D31F-4F03-48C5-9799-B89556BE670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55070" y="2821195"/>
              <a:ext cx="1953601" cy="2060942"/>
            </a:xfrm>
            <a:prstGeom prst="rect">
              <a:avLst/>
            </a:prstGeom>
          </p:spPr>
        </p:pic>
        <p:sp>
          <p:nvSpPr>
            <p:cNvPr id="39" name="Freeform 23">
              <a:extLst>
                <a:ext uri="{FF2B5EF4-FFF2-40B4-BE49-F238E27FC236}">
                  <a16:creationId xmlns:a16="http://schemas.microsoft.com/office/drawing/2014/main" id="{7608DB50-A86C-4222-BDE1-E523EDD037E5}"/>
                </a:ext>
              </a:extLst>
            </p:cNvPr>
            <p:cNvSpPr/>
            <p:nvPr/>
          </p:nvSpPr>
          <p:spPr>
            <a:xfrm>
              <a:off x="245830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56" name="Group 55">
            <a:extLst>
              <a:ext uri="{FF2B5EF4-FFF2-40B4-BE49-F238E27FC236}">
                <a16:creationId xmlns:a16="http://schemas.microsoft.com/office/drawing/2014/main" id="{4CB1B944-9375-4C7B-9EC8-E2490ED0FA46}"/>
              </a:ext>
            </a:extLst>
          </p:cNvPr>
          <p:cNvGrpSpPr>
            <a:grpSpLocks noChangeAspect="1"/>
          </p:cNvGrpSpPr>
          <p:nvPr/>
        </p:nvGrpSpPr>
        <p:grpSpPr>
          <a:xfrm>
            <a:off x="1451316" y="2518884"/>
            <a:ext cx="1279689" cy="1350000"/>
            <a:chOff x="4130139" y="2821194"/>
            <a:chExt cx="1953602" cy="2060941"/>
          </a:xfrm>
        </p:grpSpPr>
        <p:pic>
          <p:nvPicPr>
            <p:cNvPr id="57" name="Picture 56" descr="image.png">
              <a:extLst>
                <a:ext uri="{FF2B5EF4-FFF2-40B4-BE49-F238E27FC236}">
                  <a16:creationId xmlns:a16="http://schemas.microsoft.com/office/drawing/2014/main" id="{9F3FABC6-C6C9-40BF-A905-73BE542EC1A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30139" y="2821194"/>
              <a:ext cx="1953602" cy="2060941"/>
            </a:xfrm>
            <a:prstGeom prst="rect">
              <a:avLst/>
            </a:prstGeom>
          </p:spPr>
        </p:pic>
        <p:sp>
          <p:nvSpPr>
            <p:cNvPr id="58" name="Freeform 43">
              <a:extLst>
                <a:ext uri="{FF2B5EF4-FFF2-40B4-BE49-F238E27FC236}">
                  <a16:creationId xmlns:a16="http://schemas.microsoft.com/office/drawing/2014/main" id="{5228404B-5CD4-4D8D-B17C-ED73DCDB6CE1}"/>
                </a:ext>
              </a:extLst>
            </p:cNvPr>
            <p:cNvSpPr/>
            <p:nvPr/>
          </p:nvSpPr>
          <p:spPr>
            <a:xfrm>
              <a:off x="443337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96B3FC98-567F-4309-87CE-3E32502B4FDA}"/>
              </a:ext>
            </a:extLst>
          </p:cNvPr>
          <p:cNvGrpSpPr>
            <a:grpSpLocks noChangeAspect="1"/>
          </p:cNvGrpSpPr>
          <p:nvPr/>
        </p:nvGrpSpPr>
        <p:grpSpPr>
          <a:xfrm>
            <a:off x="2760408" y="2518884"/>
            <a:ext cx="1279689" cy="1350000"/>
            <a:chOff x="6105210" y="2821195"/>
            <a:chExt cx="1953601" cy="2060942"/>
          </a:xfrm>
        </p:grpSpPr>
        <p:pic>
          <p:nvPicPr>
            <p:cNvPr id="76" name="Picture 75" descr="image.png">
              <a:extLst>
                <a:ext uri="{FF2B5EF4-FFF2-40B4-BE49-F238E27FC236}">
                  <a16:creationId xmlns:a16="http://schemas.microsoft.com/office/drawing/2014/main" id="{E9114DAD-0CF3-4FE5-9AC8-534E973C9CD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05210" y="2821195"/>
              <a:ext cx="1953601" cy="2060942"/>
            </a:xfrm>
            <a:prstGeom prst="rect">
              <a:avLst/>
            </a:prstGeom>
          </p:spPr>
        </p:pic>
        <p:sp>
          <p:nvSpPr>
            <p:cNvPr id="77" name="Freeform 63">
              <a:extLst>
                <a:ext uri="{FF2B5EF4-FFF2-40B4-BE49-F238E27FC236}">
                  <a16:creationId xmlns:a16="http://schemas.microsoft.com/office/drawing/2014/main" id="{76131C7B-1858-439E-8517-C8E7473434B1}"/>
                </a:ext>
              </a:extLst>
            </p:cNvPr>
            <p:cNvSpPr/>
            <p:nvPr/>
          </p:nvSpPr>
          <p:spPr>
            <a:xfrm>
              <a:off x="640844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94" name="Group 93">
            <a:extLst>
              <a:ext uri="{FF2B5EF4-FFF2-40B4-BE49-F238E27FC236}">
                <a16:creationId xmlns:a16="http://schemas.microsoft.com/office/drawing/2014/main" id="{69F28FA3-505B-4626-96C1-B2204357A26C}"/>
              </a:ext>
            </a:extLst>
          </p:cNvPr>
          <p:cNvGrpSpPr>
            <a:grpSpLocks noChangeAspect="1"/>
          </p:cNvGrpSpPr>
          <p:nvPr/>
        </p:nvGrpSpPr>
        <p:grpSpPr>
          <a:xfrm>
            <a:off x="4069255" y="2518884"/>
            <a:ext cx="1279689" cy="1350000"/>
            <a:chOff x="8080280" y="2821195"/>
            <a:chExt cx="1953601" cy="2060942"/>
          </a:xfrm>
        </p:grpSpPr>
        <p:pic>
          <p:nvPicPr>
            <p:cNvPr id="95" name="Picture 94" descr="image.png">
              <a:extLst>
                <a:ext uri="{FF2B5EF4-FFF2-40B4-BE49-F238E27FC236}">
                  <a16:creationId xmlns:a16="http://schemas.microsoft.com/office/drawing/2014/main" id="{4A0BF5C8-D5DA-4AB5-AB73-E2E16DF4307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080280" y="2821195"/>
              <a:ext cx="1953601" cy="2060942"/>
            </a:xfrm>
            <a:prstGeom prst="rect">
              <a:avLst/>
            </a:prstGeom>
          </p:spPr>
        </p:pic>
        <p:sp>
          <p:nvSpPr>
            <p:cNvPr id="96" name="Freeform 83">
              <a:extLst>
                <a:ext uri="{FF2B5EF4-FFF2-40B4-BE49-F238E27FC236}">
                  <a16:creationId xmlns:a16="http://schemas.microsoft.com/office/drawing/2014/main" id="{BEE58B6C-28AC-41FA-80FF-EC43978F6B68}"/>
                </a:ext>
              </a:extLst>
            </p:cNvPr>
            <p:cNvSpPr/>
            <p:nvPr/>
          </p:nvSpPr>
          <p:spPr>
            <a:xfrm>
              <a:off x="838351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113" name="Group 112">
            <a:extLst>
              <a:ext uri="{FF2B5EF4-FFF2-40B4-BE49-F238E27FC236}">
                <a16:creationId xmlns:a16="http://schemas.microsoft.com/office/drawing/2014/main" id="{FB1B54EB-F3BB-4C36-BBD4-8973FB8E3DF3}"/>
              </a:ext>
            </a:extLst>
          </p:cNvPr>
          <p:cNvGrpSpPr>
            <a:grpSpLocks noChangeAspect="1"/>
          </p:cNvGrpSpPr>
          <p:nvPr/>
        </p:nvGrpSpPr>
        <p:grpSpPr>
          <a:xfrm>
            <a:off x="5350393" y="2518884"/>
            <a:ext cx="1279690" cy="1350000"/>
            <a:chOff x="10055350" y="2821195"/>
            <a:chExt cx="1953601" cy="2060942"/>
          </a:xfrm>
        </p:grpSpPr>
        <p:pic>
          <p:nvPicPr>
            <p:cNvPr id="114" name="Picture 113" descr="image.png">
              <a:extLst>
                <a:ext uri="{FF2B5EF4-FFF2-40B4-BE49-F238E27FC236}">
                  <a16:creationId xmlns:a16="http://schemas.microsoft.com/office/drawing/2014/main" id="{D5F0978C-8C7E-4379-8EE3-86938ABF8D9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10055350" y="2821195"/>
              <a:ext cx="1953601" cy="2060942"/>
            </a:xfrm>
            <a:prstGeom prst="rect">
              <a:avLst/>
            </a:prstGeom>
          </p:spPr>
        </p:pic>
        <p:sp>
          <p:nvSpPr>
            <p:cNvPr id="115" name="Freeform 103">
              <a:extLst>
                <a:ext uri="{FF2B5EF4-FFF2-40B4-BE49-F238E27FC236}">
                  <a16:creationId xmlns:a16="http://schemas.microsoft.com/office/drawing/2014/main" id="{E14A4786-A484-4287-B88C-8BA8DEB181A7}"/>
                </a:ext>
              </a:extLst>
            </p:cNvPr>
            <p:cNvSpPr/>
            <p:nvPr/>
          </p:nvSpPr>
          <p:spPr>
            <a:xfrm>
              <a:off x="10358588" y="2963421"/>
              <a:ext cx="1615478" cy="1615479"/>
            </a:xfrm>
            <a:custGeom>
              <a:avLst/>
              <a:gdLst/>
              <a:ahLst/>
              <a:cxnLst/>
              <a:rect l="l" t="t" r="r" b="b"/>
              <a:pathLst>
                <a:path w="1615478" h="1615479">
                  <a:moveTo>
                    <a:pt x="0" y="0"/>
                  </a:moveTo>
                  <a:lnTo>
                    <a:pt x="1615478" y="0"/>
                  </a:lnTo>
                  <a:lnTo>
                    <a:pt x="1615478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sp>
        <p:nvSpPr>
          <p:cNvPr id="132" name="TextBox 131">
            <a:extLst>
              <a:ext uri="{FF2B5EF4-FFF2-40B4-BE49-F238E27FC236}">
                <a16:creationId xmlns:a16="http://schemas.microsoft.com/office/drawing/2014/main" id="{F8235F55-8985-4C28-B08B-D40CE4C5D100}"/>
              </a:ext>
            </a:extLst>
          </p:cNvPr>
          <p:cNvSpPr txBox="1"/>
          <p:nvPr/>
        </p:nvSpPr>
        <p:spPr>
          <a:xfrm>
            <a:off x="-71576" y="2043582"/>
            <a:ext cx="1031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Nb2-2-Fc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9CD2B69-EB34-484B-8295-BB2FAA5202D7}"/>
              </a:ext>
            </a:extLst>
          </p:cNvPr>
          <p:cNvSpPr txBox="1"/>
          <p:nvPr/>
        </p:nvSpPr>
        <p:spPr>
          <a:xfrm>
            <a:off x="5496290" y="2285690"/>
            <a:ext cx="1041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3.75 nM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4231B532-EF15-48AB-A7A0-8817B32906B3}"/>
              </a:ext>
            </a:extLst>
          </p:cNvPr>
          <p:cNvSpPr txBox="1"/>
          <p:nvPr/>
        </p:nvSpPr>
        <p:spPr>
          <a:xfrm>
            <a:off x="4203318" y="2295742"/>
            <a:ext cx="1041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75 nM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D2CA5FE0-7ECB-4626-9433-54408C6C55EF}"/>
              </a:ext>
            </a:extLst>
          </p:cNvPr>
          <p:cNvSpPr txBox="1"/>
          <p:nvPr/>
        </p:nvSpPr>
        <p:spPr>
          <a:xfrm>
            <a:off x="2966950" y="2295742"/>
            <a:ext cx="9384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15 nM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E49FDA62-1E2E-4234-AEEC-1E151AF0D31D}"/>
              </a:ext>
            </a:extLst>
          </p:cNvPr>
          <p:cNvSpPr txBox="1"/>
          <p:nvPr/>
        </p:nvSpPr>
        <p:spPr>
          <a:xfrm>
            <a:off x="1716320" y="2295742"/>
            <a:ext cx="813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03 nM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7B9F07C4-0AAA-4CD0-8DB4-05F30665614F}"/>
              </a:ext>
            </a:extLst>
          </p:cNvPr>
          <p:cNvSpPr txBox="1"/>
          <p:nvPr/>
        </p:nvSpPr>
        <p:spPr>
          <a:xfrm>
            <a:off x="205235" y="2295742"/>
            <a:ext cx="1056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006 nM</a:t>
            </a:r>
          </a:p>
        </p:txBody>
      </p: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C7A948CC-FFE1-42BD-868A-E920EEF85032}"/>
              </a:ext>
            </a:extLst>
          </p:cNvPr>
          <p:cNvGrpSpPr>
            <a:grpSpLocks noChangeAspect="1"/>
          </p:cNvGrpSpPr>
          <p:nvPr/>
        </p:nvGrpSpPr>
        <p:grpSpPr>
          <a:xfrm>
            <a:off x="81351" y="4411856"/>
            <a:ext cx="1279688" cy="1350000"/>
            <a:chOff x="2155070" y="2821195"/>
            <a:chExt cx="1953601" cy="2060942"/>
          </a:xfrm>
        </p:grpSpPr>
        <p:pic>
          <p:nvPicPr>
            <p:cNvPr id="139" name="Picture 138" descr="image.png">
              <a:extLst>
                <a:ext uri="{FF2B5EF4-FFF2-40B4-BE49-F238E27FC236}">
                  <a16:creationId xmlns:a16="http://schemas.microsoft.com/office/drawing/2014/main" id="{8D011FA3-1B14-458C-B6B5-2AEE003913E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155070" y="2821195"/>
              <a:ext cx="1953601" cy="2060942"/>
            </a:xfrm>
            <a:prstGeom prst="rect">
              <a:avLst/>
            </a:prstGeom>
          </p:spPr>
        </p:pic>
        <p:sp>
          <p:nvSpPr>
            <p:cNvPr id="140" name="Freeform 143">
              <a:extLst>
                <a:ext uri="{FF2B5EF4-FFF2-40B4-BE49-F238E27FC236}">
                  <a16:creationId xmlns:a16="http://schemas.microsoft.com/office/drawing/2014/main" id="{0585501D-BF24-4F11-9C39-7B4DB6EA272D}"/>
                </a:ext>
              </a:extLst>
            </p:cNvPr>
            <p:cNvSpPr/>
            <p:nvPr/>
          </p:nvSpPr>
          <p:spPr>
            <a:xfrm>
              <a:off x="245830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157" name="Group 156">
            <a:extLst>
              <a:ext uri="{FF2B5EF4-FFF2-40B4-BE49-F238E27FC236}">
                <a16:creationId xmlns:a16="http://schemas.microsoft.com/office/drawing/2014/main" id="{E6E30498-B678-4EB7-9325-24EE27779964}"/>
              </a:ext>
            </a:extLst>
          </p:cNvPr>
          <p:cNvGrpSpPr>
            <a:grpSpLocks noChangeAspect="1"/>
          </p:cNvGrpSpPr>
          <p:nvPr/>
        </p:nvGrpSpPr>
        <p:grpSpPr>
          <a:xfrm>
            <a:off x="1451317" y="4411856"/>
            <a:ext cx="1279687" cy="1350000"/>
            <a:chOff x="4130140" y="2821195"/>
            <a:chExt cx="1953601" cy="2060942"/>
          </a:xfrm>
        </p:grpSpPr>
        <p:pic>
          <p:nvPicPr>
            <p:cNvPr id="158" name="Picture 157" descr="image.png">
              <a:extLst>
                <a:ext uri="{FF2B5EF4-FFF2-40B4-BE49-F238E27FC236}">
                  <a16:creationId xmlns:a16="http://schemas.microsoft.com/office/drawing/2014/main" id="{E6220081-C754-442D-90AC-EF3632FAF48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130140" y="2821195"/>
              <a:ext cx="1953601" cy="2060942"/>
            </a:xfrm>
            <a:prstGeom prst="rect">
              <a:avLst/>
            </a:prstGeom>
          </p:spPr>
        </p:pic>
        <p:sp>
          <p:nvSpPr>
            <p:cNvPr id="159" name="Freeform 163">
              <a:extLst>
                <a:ext uri="{FF2B5EF4-FFF2-40B4-BE49-F238E27FC236}">
                  <a16:creationId xmlns:a16="http://schemas.microsoft.com/office/drawing/2014/main" id="{001D56F1-E952-4ACA-9895-6B8A6B9ED2A5}"/>
                </a:ext>
              </a:extLst>
            </p:cNvPr>
            <p:cNvSpPr/>
            <p:nvPr/>
          </p:nvSpPr>
          <p:spPr>
            <a:xfrm>
              <a:off x="443337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176" name="Group 175">
            <a:extLst>
              <a:ext uri="{FF2B5EF4-FFF2-40B4-BE49-F238E27FC236}">
                <a16:creationId xmlns:a16="http://schemas.microsoft.com/office/drawing/2014/main" id="{7B95A606-9186-4669-A5BD-7A97B06CFB81}"/>
              </a:ext>
            </a:extLst>
          </p:cNvPr>
          <p:cNvGrpSpPr>
            <a:grpSpLocks noChangeAspect="1"/>
          </p:cNvGrpSpPr>
          <p:nvPr/>
        </p:nvGrpSpPr>
        <p:grpSpPr>
          <a:xfrm>
            <a:off x="2760409" y="4411856"/>
            <a:ext cx="1279687" cy="1350000"/>
            <a:chOff x="6105210" y="2821195"/>
            <a:chExt cx="1953601" cy="2060942"/>
          </a:xfrm>
        </p:grpSpPr>
        <p:pic>
          <p:nvPicPr>
            <p:cNvPr id="177" name="Picture 176" descr="image.png">
              <a:extLst>
                <a:ext uri="{FF2B5EF4-FFF2-40B4-BE49-F238E27FC236}">
                  <a16:creationId xmlns:a16="http://schemas.microsoft.com/office/drawing/2014/main" id="{518B7A07-6B46-4F5D-B662-EC70FE907DDF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105210" y="2821195"/>
              <a:ext cx="1953601" cy="2060942"/>
            </a:xfrm>
            <a:prstGeom prst="rect">
              <a:avLst/>
            </a:prstGeom>
          </p:spPr>
        </p:pic>
        <p:sp>
          <p:nvSpPr>
            <p:cNvPr id="178" name="Freeform 183">
              <a:extLst>
                <a:ext uri="{FF2B5EF4-FFF2-40B4-BE49-F238E27FC236}">
                  <a16:creationId xmlns:a16="http://schemas.microsoft.com/office/drawing/2014/main" id="{CF4E1CAF-A0D5-47A1-94AA-E7207CDB9D9D}"/>
                </a:ext>
              </a:extLst>
            </p:cNvPr>
            <p:cNvSpPr/>
            <p:nvPr/>
          </p:nvSpPr>
          <p:spPr>
            <a:xfrm>
              <a:off x="640844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195" name="Group 194">
            <a:extLst>
              <a:ext uri="{FF2B5EF4-FFF2-40B4-BE49-F238E27FC236}">
                <a16:creationId xmlns:a16="http://schemas.microsoft.com/office/drawing/2014/main" id="{B11F6117-2FF7-44E7-8916-349EF0940426}"/>
              </a:ext>
            </a:extLst>
          </p:cNvPr>
          <p:cNvGrpSpPr>
            <a:grpSpLocks noChangeAspect="1"/>
          </p:cNvGrpSpPr>
          <p:nvPr/>
        </p:nvGrpSpPr>
        <p:grpSpPr>
          <a:xfrm>
            <a:off x="4069256" y="4411856"/>
            <a:ext cx="1279687" cy="1350000"/>
            <a:chOff x="8080280" y="2821195"/>
            <a:chExt cx="1953601" cy="2060942"/>
          </a:xfrm>
        </p:grpSpPr>
        <p:pic>
          <p:nvPicPr>
            <p:cNvPr id="196" name="Picture 195" descr="image.png">
              <a:extLst>
                <a:ext uri="{FF2B5EF4-FFF2-40B4-BE49-F238E27FC236}">
                  <a16:creationId xmlns:a16="http://schemas.microsoft.com/office/drawing/2014/main" id="{63771AAF-BF77-4297-BCB0-D7C4727FC998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080280" y="2821195"/>
              <a:ext cx="1953601" cy="2060942"/>
            </a:xfrm>
            <a:prstGeom prst="rect">
              <a:avLst/>
            </a:prstGeom>
          </p:spPr>
        </p:pic>
        <p:sp>
          <p:nvSpPr>
            <p:cNvPr id="197" name="Freeform 203">
              <a:extLst>
                <a:ext uri="{FF2B5EF4-FFF2-40B4-BE49-F238E27FC236}">
                  <a16:creationId xmlns:a16="http://schemas.microsoft.com/office/drawing/2014/main" id="{1421A8DC-A7A1-4493-9208-1B4B19738665}"/>
                </a:ext>
              </a:extLst>
            </p:cNvPr>
            <p:cNvSpPr/>
            <p:nvPr/>
          </p:nvSpPr>
          <p:spPr>
            <a:xfrm>
              <a:off x="838351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214" name="Group 213">
            <a:extLst>
              <a:ext uri="{FF2B5EF4-FFF2-40B4-BE49-F238E27FC236}">
                <a16:creationId xmlns:a16="http://schemas.microsoft.com/office/drawing/2014/main" id="{8D7A25D4-5DCF-41ED-8985-0B04FA8088EE}"/>
              </a:ext>
            </a:extLst>
          </p:cNvPr>
          <p:cNvGrpSpPr>
            <a:grpSpLocks noChangeAspect="1"/>
          </p:cNvGrpSpPr>
          <p:nvPr/>
        </p:nvGrpSpPr>
        <p:grpSpPr>
          <a:xfrm>
            <a:off x="5350395" y="4411856"/>
            <a:ext cx="1279687" cy="1350000"/>
            <a:chOff x="10055350" y="2821195"/>
            <a:chExt cx="1953601" cy="2060942"/>
          </a:xfrm>
        </p:grpSpPr>
        <p:pic>
          <p:nvPicPr>
            <p:cNvPr id="215" name="Picture 214" descr="image.png">
              <a:extLst>
                <a:ext uri="{FF2B5EF4-FFF2-40B4-BE49-F238E27FC236}">
                  <a16:creationId xmlns:a16="http://schemas.microsoft.com/office/drawing/2014/main" id="{82488617-0188-4923-B7DE-880BB52BB3F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0055350" y="2821195"/>
              <a:ext cx="1953601" cy="2060942"/>
            </a:xfrm>
            <a:prstGeom prst="rect">
              <a:avLst/>
            </a:prstGeom>
          </p:spPr>
        </p:pic>
        <p:sp>
          <p:nvSpPr>
            <p:cNvPr id="216" name="Freeform 223">
              <a:extLst>
                <a:ext uri="{FF2B5EF4-FFF2-40B4-BE49-F238E27FC236}">
                  <a16:creationId xmlns:a16="http://schemas.microsoft.com/office/drawing/2014/main" id="{34B087E9-7169-4282-9013-2D5184BD560A}"/>
                </a:ext>
              </a:extLst>
            </p:cNvPr>
            <p:cNvSpPr/>
            <p:nvPr/>
          </p:nvSpPr>
          <p:spPr>
            <a:xfrm>
              <a:off x="10358588" y="2963421"/>
              <a:ext cx="1615478" cy="1615479"/>
            </a:xfrm>
            <a:custGeom>
              <a:avLst/>
              <a:gdLst/>
              <a:ahLst/>
              <a:cxnLst/>
              <a:rect l="l" t="t" r="r" b="b"/>
              <a:pathLst>
                <a:path w="1615478" h="1615479">
                  <a:moveTo>
                    <a:pt x="0" y="0"/>
                  </a:moveTo>
                  <a:lnTo>
                    <a:pt x="1615478" y="0"/>
                  </a:lnTo>
                  <a:lnTo>
                    <a:pt x="1615478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sp>
        <p:nvSpPr>
          <p:cNvPr id="233" name="TextBox 232">
            <a:extLst>
              <a:ext uri="{FF2B5EF4-FFF2-40B4-BE49-F238E27FC236}">
                <a16:creationId xmlns:a16="http://schemas.microsoft.com/office/drawing/2014/main" id="{0F53441C-8BD2-40F1-B7A9-A76012515EB1}"/>
              </a:ext>
            </a:extLst>
          </p:cNvPr>
          <p:cNvSpPr txBox="1"/>
          <p:nvPr/>
        </p:nvSpPr>
        <p:spPr>
          <a:xfrm>
            <a:off x="5471751" y="4181205"/>
            <a:ext cx="10908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2.65 nM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EB3FF26C-1BBE-47D3-8A8F-DF1A8B612C86}"/>
              </a:ext>
            </a:extLst>
          </p:cNvPr>
          <p:cNvSpPr txBox="1"/>
          <p:nvPr/>
        </p:nvSpPr>
        <p:spPr>
          <a:xfrm>
            <a:off x="4281843" y="4181205"/>
            <a:ext cx="9919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53 nM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484CCC51-49FE-467A-A0B7-3990A8FDAE0B}"/>
              </a:ext>
            </a:extLst>
          </p:cNvPr>
          <p:cNvSpPr txBox="1"/>
          <p:nvPr/>
        </p:nvSpPr>
        <p:spPr>
          <a:xfrm>
            <a:off x="2904778" y="4181204"/>
            <a:ext cx="10484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106 nM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11561555-FE51-4C2F-A230-1A465F1FAE7D}"/>
              </a:ext>
            </a:extLst>
          </p:cNvPr>
          <p:cNvSpPr txBox="1"/>
          <p:nvPr/>
        </p:nvSpPr>
        <p:spPr>
          <a:xfrm>
            <a:off x="1530383" y="4187816"/>
            <a:ext cx="11850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021 nM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AE1F3220-429A-42D2-ABFC-5DA113130422}"/>
              </a:ext>
            </a:extLst>
          </p:cNvPr>
          <p:cNvSpPr txBox="1"/>
          <p:nvPr/>
        </p:nvSpPr>
        <p:spPr>
          <a:xfrm>
            <a:off x="206487" y="4181205"/>
            <a:ext cx="10535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0.004 nM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22A3247E-613A-4D78-AED3-C8B68D1FAE68}"/>
              </a:ext>
            </a:extLst>
          </p:cNvPr>
          <p:cNvSpPr txBox="1"/>
          <p:nvPr/>
        </p:nvSpPr>
        <p:spPr>
          <a:xfrm>
            <a:off x="-25739" y="3960390"/>
            <a:ext cx="11162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LUAS-2-Fc</a:t>
            </a:r>
          </a:p>
        </p:txBody>
      </p:sp>
      <p:grpSp>
        <p:nvGrpSpPr>
          <p:cNvPr id="239" name="Group 238">
            <a:extLst>
              <a:ext uri="{FF2B5EF4-FFF2-40B4-BE49-F238E27FC236}">
                <a16:creationId xmlns:a16="http://schemas.microsoft.com/office/drawing/2014/main" id="{1626A8A6-D159-4992-8C35-2B55BC82B590}"/>
              </a:ext>
            </a:extLst>
          </p:cNvPr>
          <p:cNvGrpSpPr>
            <a:grpSpLocks noChangeAspect="1"/>
          </p:cNvGrpSpPr>
          <p:nvPr/>
        </p:nvGrpSpPr>
        <p:grpSpPr>
          <a:xfrm>
            <a:off x="81352" y="6223033"/>
            <a:ext cx="1279687" cy="1350000"/>
            <a:chOff x="2155070" y="2821195"/>
            <a:chExt cx="1953601" cy="2060942"/>
          </a:xfrm>
        </p:grpSpPr>
        <p:pic>
          <p:nvPicPr>
            <p:cNvPr id="240" name="Picture 239" descr="image.png">
              <a:extLst>
                <a:ext uri="{FF2B5EF4-FFF2-40B4-BE49-F238E27FC236}">
                  <a16:creationId xmlns:a16="http://schemas.microsoft.com/office/drawing/2014/main" id="{113A1ABF-54AD-4C21-A648-B91810BADF4C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2155070" y="2821195"/>
              <a:ext cx="1953601" cy="2060942"/>
            </a:xfrm>
            <a:prstGeom prst="rect">
              <a:avLst/>
            </a:prstGeom>
          </p:spPr>
        </p:pic>
        <p:sp>
          <p:nvSpPr>
            <p:cNvPr id="241" name="Freeform 263">
              <a:extLst>
                <a:ext uri="{FF2B5EF4-FFF2-40B4-BE49-F238E27FC236}">
                  <a16:creationId xmlns:a16="http://schemas.microsoft.com/office/drawing/2014/main" id="{9D290A80-6C4D-43D9-8F49-126814A20B95}"/>
                </a:ext>
              </a:extLst>
            </p:cNvPr>
            <p:cNvSpPr/>
            <p:nvPr/>
          </p:nvSpPr>
          <p:spPr>
            <a:xfrm>
              <a:off x="245830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258" name="Group 257">
            <a:extLst>
              <a:ext uri="{FF2B5EF4-FFF2-40B4-BE49-F238E27FC236}">
                <a16:creationId xmlns:a16="http://schemas.microsoft.com/office/drawing/2014/main" id="{35D0CFA5-876F-413A-A199-BCECFB0D3996}"/>
              </a:ext>
            </a:extLst>
          </p:cNvPr>
          <p:cNvGrpSpPr>
            <a:grpSpLocks noChangeAspect="1"/>
          </p:cNvGrpSpPr>
          <p:nvPr/>
        </p:nvGrpSpPr>
        <p:grpSpPr>
          <a:xfrm>
            <a:off x="1451316" y="6223033"/>
            <a:ext cx="1279688" cy="1350000"/>
            <a:chOff x="4130140" y="2821195"/>
            <a:chExt cx="1953601" cy="2060942"/>
          </a:xfrm>
        </p:grpSpPr>
        <p:pic>
          <p:nvPicPr>
            <p:cNvPr id="259" name="Picture 258" descr="image.png">
              <a:extLst>
                <a:ext uri="{FF2B5EF4-FFF2-40B4-BE49-F238E27FC236}">
                  <a16:creationId xmlns:a16="http://schemas.microsoft.com/office/drawing/2014/main" id="{4B774D96-DC60-4A92-8AFA-5C7CF49BEB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130140" y="2821195"/>
              <a:ext cx="1953601" cy="2060942"/>
            </a:xfrm>
            <a:prstGeom prst="rect">
              <a:avLst/>
            </a:prstGeom>
          </p:spPr>
        </p:pic>
        <p:sp>
          <p:nvSpPr>
            <p:cNvPr id="260" name="Freeform 283">
              <a:extLst>
                <a:ext uri="{FF2B5EF4-FFF2-40B4-BE49-F238E27FC236}">
                  <a16:creationId xmlns:a16="http://schemas.microsoft.com/office/drawing/2014/main" id="{89CAAD7C-6F86-4D3C-B6D3-BE86C851AB28}"/>
                </a:ext>
              </a:extLst>
            </p:cNvPr>
            <p:cNvSpPr/>
            <p:nvPr/>
          </p:nvSpPr>
          <p:spPr>
            <a:xfrm>
              <a:off x="4433378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277" name="Group 276">
            <a:extLst>
              <a:ext uri="{FF2B5EF4-FFF2-40B4-BE49-F238E27FC236}">
                <a16:creationId xmlns:a16="http://schemas.microsoft.com/office/drawing/2014/main" id="{B33A443E-2D15-4B2B-AEB1-2466EECDE5F8}"/>
              </a:ext>
            </a:extLst>
          </p:cNvPr>
          <p:cNvGrpSpPr>
            <a:grpSpLocks noChangeAspect="1"/>
          </p:cNvGrpSpPr>
          <p:nvPr/>
        </p:nvGrpSpPr>
        <p:grpSpPr>
          <a:xfrm>
            <a:off x="2760408" y="6223033"/>
            <a:ext cx="1279688" cy="1350000"/>
            <a:chOff x="6105209" y="2821195"/>
            <a:chExt cx="1953601" cy="2060942"/>
          </a:xfrm>
        </p:grpSpPr>
        <p:pic>
          <p:nvPicPr>
            <p:cNvPr id="278" name="Picture 277" descr="image.png">
              <a:extLst>
                <a:ext uri="{FF2B5EF4-FFF2-40B4-BE49-F238E27FC236}">
                  <a16:creationId xmlns:a16="http://schemas.microsoft.com/office/drawing/2014/main" id="{CD1E46C6-298D-409B-8A4F-077F77B14EA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105209" y="2821195"/>
              <a:ext cx="1953601" cy="2060942"/>
            </a:xfrm>
            <a:prstGeom prst="rect">
              <a:avLst/>
            </a:prstGeom>
          </p:spPr>
        </p:pic>
        <p:sp>
          <p:nvSpPr>
            <p:cNvPr id="279" name="Freeform 303">
              <a:extLst>
                <a:ext uri="{FF2B5EF4-FFF2-40B4-BE49-F238E27FC236}">
                  <a16:creationId xmlns:a16="http://schemas.microsoft.com/office/drawing/2014/main" id="{E90A7C03-E254-49B3-8EDA-080C385295CE}"/>
                </a:ext>
              </a:extLst>
            </p:cNvPr>
            <p:cNvSpPr/>
            <p:nvPr/>
          </p:nvSpPr>
          <p:spPr>
            <a:xfrm>
              <a:off x="640844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A936EE02-061C-47F4-89D0-57EA82E3F0CE}"/>
              </a:ext>
            </a:extLst>
          </p:cNvPr>
          <p:cNvGrpSpPr>
            <a:grpSpLocks noChangeAspect="1"/>
          </p:cNvGrpSpPr>
          <p:nvPr/>
        </p:nvGrpSpPr>
        <p:grpSpPr>
          <a:xfrm>
            <a:off x="4069255" y="6223033"/>
            <a:ext cx="1279688" cy="1350000"/>
            <a:chOff x="8080280" y="2821195"/>
            <a:chExt cx="1953601" cy="2060942"/>
          </a:xfrm>
        </p:grpSpPr>
        <p:pic>
          <p:nvPicPr>
            <p:cNvPr id="297" name="Picture 296" descr="image.png">
              <a:extLst>
                <a:ext uri="{FF2B5EF4-FFF2-40B4-BE49-F238E27FC236}">
                  <a16:creationId xmlns:a16="http://schemas.microsoft.com/office/drawing/2014/main" id="{5007F223-1619-42DD-B1E1-BA07C2F6CAD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8080280" y="2821195"/>
              <a:ext cx="1953601" cy="2060942"/>
            </a:xfrm>
            <a:prstGeom prst="rect">
              <a:avLst/>
            </a:prstGeom>
          </p:spPr>
        </p:pic>
        <p:sp>
          <p:nvSpPr>
            <p:cNvPr id="298" name="Freeform 323">
              <a:extLst>
                <a:ext uri="{FF2B5EF4-FFF2-40B4-BE49-F238E27FC236}">
                  <a16:creationId xmlns:a16="http://schemas.microsoft.com/office/drawing/2014/main" id="{AB5549B4-0646-45A3-8FF4-B22B90562CB2}"/>
                </a:ext>
              </a:extLst>
            </p:cNvPr>
            <p:cNvSpPr/>
            <p:nvPr/>
          </p:nvSpPr>
          <p:spPr>
            <a:xfrm>
              <a:off x="838351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grpSp>
        <p:nvGrpSpPr>
          <p:cNvPr id="315" name="Group 314">
            <a:extLst>
              <a:ext uri="{FF2B5EF4-FFF2-40B4-BE49-F238E27FC236}">
                <a16:creationId xmlns:a16="http://schemas.microsoft.com/office/drawing/2014/main" id="{599666E3-7DF2-4ACE-B87C-FA32A30B6BD6}"/>
              </a:ext>
            </a:extLst>
          </p:cNvPr>
          <p:cNvGrpSpPr>
            <a:grpSpLocks noChangeAspect="1"/>
          </p:cNvGrpSpPr>
          <p:nvPr/>
        </p:nvGrpSpPr>
        <p:grpSpPr>
          <a:xfrm>
            <a:off x="5350394" y="6223033"/>
            <a:ext cx="1279688" cy="1350000"/>
            <a:chOff x="10055350" y="2821195"/>
            <a:chExt cx="1953601" cy="2060942"/>
          </a:xfrm>
        </p:grpSpPr>
        <p:pic>
          <p:nvPicPr>
            <p:cNvPr id="316" name="Picture 315" descr="image.png">
              <a:extLst>
                <a:ext uri="{FF2B5EF4-FFF2-40B4-BE49-F238E27FC236}">
                  <a16:creationId xmlns:a16="http://schemas.microsoft.com/office/drawing/2014/main" id="{1B04E845-A25F-4A47-8696-1526E0EE0416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10055350" y="2821195"/>
              <a:ext cx="1953601" cy="2060942"/>
            </a:xfrm>
            <a:prstGeom prst="rect">
              <a:avLst/>
            </a:prstGeom>
          </p:spPr>
        </p:pic>
        <p:sp>
          <p:nvSpPr>
            <p:cNvPr id="317" name="Freeform 343">
              <a:extLst>
                <a:ext uri="{FF2B5EF4-FFF2-40B4-BE49-F238E27FC236}">
                  <a16:creationId xmlns:a16="http://schemas.microsoft.com/office/drawing/2014/main" id="{1C9C127F-8989-490D-9D55-7F5C403AE0FE}"/>
                </a:ext>
              </a:extLst>
            </p:cNvPr>
            <p:cNvSpPr/>
            <p:nvPr/>
          </p:nvSpPr>
          <p:spPr>
            <a:xfrm>
              <a:off x="10358587" y="2963421"/>
              <a:ext cx="1615479" cy="1615479"/>
            </a:xfrm>
            <a:custGeom>
              <a:avLst/>
              <a:gdLst/>
              <a:ahLst/>
              <a:cxnLst/>
              <a:rect l="l" t="t" r="r" b="b"/>
              <a:pathLst>
                <a:path w="1615479" h="1615479">
                  <a:moveTo>
                    <a:pt x="0" y="0"/>
                  </a:moveTo>
                  <a:lnTo>
                    <a:pt x="1615479" y="0"/>
                  </a:lnTo>
                  <a:lnTo>
                    <a:pt x="1615479" y="1615479"/>
                  </a:lnTo>
                  <a:lnTo>
                    <a:pt x="0" y="1615479"/>
                  </a:lnTo>
                  <a:close/>
                </a:path>
              </a:pathLst>
            </a:custGeom>
            <a:noFill/>
            <a:ln w="5366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900"/>
            </a:p>
          </p:txBody>
        </p:sp>
      </p:grpSp>
      <p:sp>
        <p:nvSpPr>
          <p:cNvPr id="334" name="TextBox 333">
            <a:extLst>
              <a:ext uri="{FF2B5EF4-FFF2-40B4-BE49-F238E27FC236}">
                <a16:creationId xmlns:a16="http://schemas.microsoft.com/office/drawing/2014/main" id="{FB24045F-DA56-486F-8DDB-48DAB8191817}"/>
              </a:ext>
            </a:extLst>
          </p:cNvPr>
          <p:cNvSpPr txBox="1"/>
          <p:nvPr/>
        </p:nvSpPr>
        <p:spPr>
          <a:xfrm>
            <a:off x="5535341" y="6003078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7.75 nM</a:t>
            </a:r>
          </a:p>
        </p:txBody>
      </p:sp>
      <p:sp>
        <p:nvSpPr>
          <p:cNvPr id="335" name="TextBox 334">
            <a:extLst>
              <a:ext uri="{FF2B5EF4-FFF2-40B4-BE49-F238E27FC236}">
                <a16:creationId xmlns:a16="http://schemas.microsoft.com/office/drawing/2014/main" id="{55E1D2BD-1C41-4E47-ACFE-B891BDDEC537}"/>
              </a:ext>
            </a:extLst>
          </p:cNvPr>
          <p:cNvSpPr txBox="1"/>
          <p:nvPr/>
        </p:nvSpPr>
        <p:spPr>
          <a:xfrm>
            <a:off x="4345273" y="6003078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3.55 nM</a:t>
            </a:r>
          </a:p>
        </p:txBody>
      </p:sp>
      <p:sp>
        <p:nvSpPr>
          <p:cNvPr id="336" name="TextBox 335">
            <a:extLst>
              <a:ext uri="{FF2B5EF4-FFF2-40B4-BE49-F238E27FC236}">
                <a16:creationId xmlns:a16="http://schemas.microsoft.com/office/drawing/2014/main" id="{1AA02E5E-BDED-4CC8-AD20-93D234A4ED4E}"/>
              </a:ext>
            </a:extLst>
          </p:cNvPr>
          <p:cNvSpPr txBox="1"/>
          <p:nvPr/>
        </p:nvSpPr>
        <p:spPr>
          <a:xfrm>
            <a:off x="3085121" y="6003078"/>
            <a:ext cx="7922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0.71 nM</a:t>
            </a:r>
          </a:p>
        </p:txBody>
      </p:sp>
      <p:sp>
        <p:nvSpPr>
          <p:cNvPr id="337" name="TextBox 336">
            <a:extLst>
              <a:ext uri="{FF2B5EF4-FFF2-40B4-BE49-F238E27FC236}">
                <a16:creationId xmlns:a16="http://schemas.microsoft.com/office/drawing/2014/main" id="{9E3AAE6D-3B4F-4EDE-BBE8-2CC2D8604C8E}"/>
              </a:ext>
            </a:extLst>
          </p:cNvPr>
          <p:cNvSpPr txBox="1"/>
          <p:nvPr/>
        </p:nvSpPr>
        <p:spPr>
          <a:xfrm>
            <a:off x="1664526" y="6003078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0.142 nM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AFB4A3E7-A3A3-451B-884A-F3C3D5BBCB7D}"/>
              </a:ext>
            </a:extLst>
          </p:cNvPr>
          <p:cNvSpPr txBox="1"/>
          <p:nvPr/>
        </p:nvSpPr>
        <p:spPr>
          <a:xfrm>
            <a:off x="291464" y="6003078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0.028 nM</a:t>
            </a:r>
          </a:p>
        </p:txBody>
      </p:sp>
      <p:sp>
        <p:nvSpPr>
          <p:cNvPr id="339" name="TextBox 338">
            <a:extLst>
              <a:ext uri="{FF2B5EF4-FFF2-40B4-BE49-F238E27FC236}">
                <a16:creationId xmlns:a16="http://schemas.microsoft.com/office/drawing/2014/main" id="{2F605DA9-D4CA-409C-8C14-A80058A21387}"/>
              </a:ext>
            </a:extLst>
          </p:cNvPr>
          <p:cNvSpPr txBox="1"/>
          <p:nvPr/>
        </p:nvSpPr>
        <p:spPr>
          <a:xfrm>
            <a:off x="-25739" y="5742983"/>
            <a:ext cx="1265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Nb138-2-Fc</a:t>
            </a:r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228138CF-8A10-4953-B31E-B58008D48D92}"/>
              </a:ext>
            </a:extLst>
          </p:cNvPr>
          <p:cNvSpPr txBox="1"/>
          <p:nvPr/>
        </p:nvSpPr>
        <p:spPr>
          <a:xfrm>
            <a:off x="513643" y="3683601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48" name="TextBox 347">
            <a:extLst>
              <a:ext uri="{FF2B5EF4-FFF2-40B4-BE49-F238E27FC236}">
                <a16:creationId xmlns:a16="http://schemas.microsoft.com/office/drawing/2014/main" id="{FE206F60-6884-4B7D-85FB-437138A12AD8}"/>
              </a:ext>
            </a:extLst>
          </p:cNvPr>
          <p:cNvSpPr txBox="1"/>
          <p:nvPr/>
        </p:nvSpPr>
        <p:spPr>
          <a:xfrm rot="16200000">
            <a:off x="-26533" y="3052103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50" name="TextBox 349">
            <a:extLst>
              <a:ext uri="{FF2B5EF4-FFF2-40B4-BE49-F238E27FC236}">
                <a16:creationId xmlns:a16="http://schemas.microsoft.com/office/drawing/2014/main" id="{E726B3E5-49E5-45BD-B9DB-0C63E4F64240}"/>
              </a:ext>
            </a:extLst>
          </p:cNvPr>
          <p:cNvSpPr txBox="1"/>
          <p:nvPr/>
        </p:nvSpPr>
        <p:spPr>
          <a:xfrm>
            <a:off x="3190857" y="3683601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51" name="TextBox 350">
            <a:extLst>
              <a:ext uri="{FF2B5EF4-FFF2-40B4-BE49-F238E27FC236}">
                <a16:creationId xmlns:a16="http://schemas.microsoft.com/office/drawing/2014/main" id="{F5F06217-300E-4B2E-9F08-8FE1C847C3F8}"/>
              </a:ext>
            </a:extLst>
          </p:cNvPr>
          <p:cNvSpPr txBox="1"/>
          <p:nvPr/>
        </p:nvSpPr>
        <p:spPr>
          <a:xfrm>
            <a:off x="4548279" y="3683601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0935F48A-DF0A-47D7-84C4-B359F088B710}"/>
              </a:ext>
            </a:extLst>
          </p:cNvPr>
          <p:cNvSpPr txBox="1"/>
          <p:nvPr/>
        </p:nvSpPr>
        <p:spPr>
          <a:xfrm>
            <a:off x="5828921" y="3683601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53" name="TextBox 352">
            <a:extLst>
              <a:ext uri="{FF2B5EF4-FFF2-40B4-BE49-F238E27FC236}">
                <a16:creationId xmlns:a16="http://schemas.microsoft.com/office/drawing/2014/main" id="{2D30D80F-7BB9-48E8-B6F6-B1BD9B1A7231}"/>
              </a:ext>
            </a:extLst>
          </p:cNvPr>
          <p:cNvSpPr txBox="1"/>
          <p:nvPr/>
        </p:nvSpPr>
        <p:spPr>
          <a:xfrm>
            <a:off x="550116" y="556139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54" name="TextBox 353">
            <a:extLst>
              <a:ext uri="{FF2B5EF4-FFF2-40B4-BE49-F238E27FC236}">
                <a16:creationId xmlns:a16="http://schemas.microsoft.com/office/drawing/2014/main" id="{2B513BEC-BA47-4349-96FA-4F972CE1C43D}"/>
              </a:ext>
            </a:extLst>
          </p:cNvPr>
          <p:cNvSpPr txBox="1"/>
          <p:nvPr/>
        </p:nvSpPr>
        <p:spPr>
          <a:xfrm>
            <a:off x="1939239" y="3683601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55" name="TextBox 354">
            <a:extLst>
              <a:ext uri="{FF2B5EF4-FFF2-40B4-BE49-F238E27FC236}">
                <a16:creationId xmlns:a16="http://schemas.microsoft.com/office/drawing/2014/main" id="{5F09B757-A1AF-4381-B720-810746EFF811}"/>
              </a:ext>
            </a:extLst>
          </p:cNvPr>
          <p:cNvSpPr txBox="1"/>
          <p:nvPr/>
        </p:nvSpPr>
        <p:spPr>
          <a:xfrm rot="16200000">
            <a:off x="1326175" y="3052103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521D1664-EFBB-4801-8055-F10897C40802}"/>
              </a:ext>
            </a:extLst>
          </p:cNvPr>
          <p:cNvSpPr txBox="1"/>
          <p:nvPr/>
        </p:nvSpPr>
        <p:spPr>
          <a:xfrm rot="16200000">
            <a:off x="5260106" y="3052103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E86AB5E5-34AA-45E6-A92C-0286F8B7038D}"/>
              </a:ext>
            </a:extLst>
          </p:cNvPr>
          <p:cNvSpPr txBox="1"/>
          <p:nvPr/>
        </p:nvSpPr>
        <p:spPr>
          <a:xfrm rot="16200000">
            <a:off x="3975646" y="3052103"/>
            <a:ext cx="394339" cy="138499"/>
          </a:xfrm>
          <a:prstGeom prst="rect">
            <a:avLst/>
          </a:prstGeom>
          <a:noFill/>
        </p:spPr>
        <p:txBody>
          <a:bodyPr wrap="squar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44934C2C-974D-4D02-8FA3-3B4AE037D01A}"/>
              </a:ext>
            </a:extLst>
          </p:cNvPr>
          <p:cNvSpPr txBox="1"/>
          <p:nvPr/>
        </p:nvSpPr>
        <p:spPr>
          <a:xfrm rot="16200000">
            <a:off x="2684928" y="3052103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2311CA8E-8DFD-498E-9E4B-CDCB3CCFB906}"/>
              </a:ext>
            </a:extLst>
          </p:cNvPr>
          <p:cNvSpPr txBox="1"/>
          <p:nvPr/>
        </p:nvSpPr>
        <p:spPr>
          <a:xfrm>
            <a:off x="1957002" y="556139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66BA11FD-8EB7-4442-A581-40AD3AD953CF}"/>
              </a:ext>
            </a:extLst>
          </p:cNvPr>
          <p:cNvSpPr txBox="1"/>
          <p:nvPr/>
        </p:nvSpPr>
        <p:spPr>
          <a:xfrm>
            <a:off x="3252595" y="556139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61" name="TextBox 360">
            <a:extLst>
              <a:ext uri="{FF2B5EF4-FFF2-40B4-BE49-F238E27FC236}">
                <a16:creationId xmlns:a16="http://schemas.microsoft.com/office/drawing/2014/main" id="{BCADA96C-F1BF-4DC5-A8E9-16AE53D2C08A}"/>
              </a:ext>
            </a:extLst>
          </p:cNvPr>
          <p:cNvSpPr txBox="1"/>
          <p:nvPr/>
        </p:nvSpPr>
        <p:spPr>
          <a:xfrm>
            <a:off x="4560592" y="556139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588ADD78-46EC-472D-A35B-AD9FABBE9621}"/>
              </a:ext>
            </a:extLst>
          </p:cNvPr>
          <p:cNvSpPr txBox="1"/>
          <p:nvPr/>
        </p:nvSpPr>
        <p:spPr>
          <a:xfrm>
            <a:off x="5845806" y="5561396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63" name="TextBox 362">
            <a:extLst>
              <a:ext uri="{FF2B5EF4-FFF2-40B4-BE49-F238E27FC236}">
                <a16:creationId xmlns:a16="http://schemas.microsoft.com/office/drawing/2014/main" id="{73281369-A15A-4462-8256-250675677EF5}"/>
              </a:ext>
            </a:extLst>
          </p:cNvPr>
          <p:cNvSpPr txBox="1"/>
          <p:nvPr/>
        </p:nvSpPr>
        <p:spPr>
          <a:xfrm>
            <a:off x="544361" y="7383425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:a16="http://schemas.microsoft.com/office/drawing/2014/main" id="{37873B1A-0AC7-47C5-BA7E-A4808771D369}"/>
              </a:ext>
            </a:extLst>
          </p:cNvPr>
          <p:cNvSpPr txBox="1"/>
          <p:nvPr/>
        </p:nvSpPr>
        <p:spPr>
          <a:xfrm rot="16200000">
            <a:off x="-26533" y="4954582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589DE75B-666E-42D6-9D6C-FFFD784BAB9A}"/>
              </a:ext>
            </a:extLst>
          </p:cNvPr>
          <p:cNvSpPr txBox="1"/>
          <p:nvPr/>
        </p:nvSpPr>
        <p:spPr>
          <a:xfrm rot="16200000">
            <a:off x="1326175" y="4954582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F7E690EE-D0FD-4003-8756-0821032A7958}"/>
              </a:ext>
            </a:extLst>
          </p:cNvPr>
          <p:cNvSpPr txBox="1"/>
          <p:nvPr/>
        </p:nvSpPr>
        <p:spPr>
          <a:xfrm rot="16200000">
            <a:off x="2684928" y="4954582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397B016D-5857-42F6-B1B2-7F64E39E8A36}"/>
              </a:ext>
            </a:extLst>
          </p:cNvPr>
          <p:cNvSpPr txBox="1"/>
          <p:nvPr/>
        </p:nvSpPr>
        <p:spPr>
          <a:xfrm rot="16200000">
            <a:off x="3975646" y="4954582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68" name="TextBox 367">
            <a:extLst>
              <a:ext uri="{FF2B5EF4-FFF2-40B4-BE49-F238E27FC236}">
                <a16:creationId xmlns:a16="http://schemas.microsoft.com/office/drawing/2014/main" id="{3BE3FD9E-160D-4DAE-8A65-C05C35A31024}"/>
              </a:ext>
            </a:extLst>
          </p:cNvPr>
          <p:cNvSpPr txBox="1"/>
          <p:nvPr/>
        </p:nvSpPr>
        <p:spPr>
          <a:xfrm rot="16200000">
            <a:off x="5260106" y="4954582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69" name="TextBox 368">
            <a:extLst>
              <a:ext uri="{FF2B5EF4-FFF2-40B4-BE49-F238E27FC236}">
                <a16:creationId xmlns:a16="http://schemas.microsoft.com/office/drawing/2014/main" id="{45FF22A1-2D9C-4E81-B0D0-FEB6E85987E2}"/>
              </a:ext>
            </a:extLst>
          </p:cNvPr>
          <p:cNvSpPr txBox="1"/>
          <p:nvPr/>
        </p:nvSpPr>
        <p:spPr>
          <a:xfrm rot="16200000">
            <a:off x="-26533" y="6765144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70" name="TextBox 369">
            <a:extLst>
              <a:ext uri="{FF2B5EF4-FFF2-40B4-BE49-F238E27FC236}">
                <a16:creationId xmlns:a16="http://schemas.microsoft.com/office/drawing/2014/main" id="{E59A4236-0290-44C9-8493-DA2990082AB5}"/>
              </a:ext>
            </a:extLst>
          </p:cNvPr>
          <p:cNvSpPr txBox="1"/>
          <p:nvPr/>
        </p:nvSpPr>
        <p:spPr>
          <a:xfrm rot="16200000">
            <a:off x="1326175" y="6765144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4049AF8D-9901-43C6-BA81-6B414506A185}"/>
              </a:ext>
            </a:extLst>
          </p:cNvPr>
          <p:cNvSpPr txBox="1"/>
          <p:nvPr/>
        </p:nvSpPr>
        <p:spPr>
          <a:xfrm rot="16200000">
            <a:off x="2684928" y="6765144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026A3FED-7816-46F6-A67D-7B88B5D5E7E9}"/>
              </a:ext>
            </a:extLst>
          </p:cNvPr>
          <p:cNvSpPr txBox="1"/>
          <p:nvPr/>
        </p:nvSpPr>
        <p:spPr>
          <a:xfrm rot="16200000">
            <a:off x="3975646" y="6765144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07A3F074-A20B-4DF5-AEED-DC0C9ECEF681}"/>
              </a:ext>
            </a:extLst>
          </p:cNvPr>
          <p:cNvSpPr txBox="1"/>
          <p:nvPr/>
        </p:nvSpPr>
        <p:spPr>
          <a:xfrm rot="16200000">
            <a:off x="5260106" y="6765144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2</a:t>
            </a:r>
          </a:p>
        </p:txBody>
      </p:sp>
      <p:sp>
        <p:nvSpPr>
          <p:cNvPr id="374" name="TextBox 373">
            <a:extLst>
              <a:ext uri="{FF2B5EF4-FFF2-40B4-BE49-F238E27FC236}">
                <a16:creationId xmlns:a16="http://schemas.microsoft.com/office/drawing/2014/main" id="{5D8D01BB-BDD0-47F6-882F-B9A33F8DC4BC}"/>
              </a:ext>
            </a:extLst>
          </p:cNvPr>
          <p:cNvSpPr txBox="1"/>
          <p:nvPr/>
        </p:nvSpPr>
        <p:spPr>
          <a:xfrm>
            <a:off x="1929899" y="7383425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75" name="TextBox 374">
            <a:extLst>
              <a:ext uri="{FF2B5EF4-FFF2-40B4-BE49-F238E27FC236}">
                <a16:creationId xmlns:a16="http://schemas.microsoft.com/office/drawing/2014/main" id="{B667A1D8-E96B-400A-A698-95D47D4A1DB2}"/>
              </a:ext>
            </a:extLst>
          </p:cNvPr>
          <p:cNvSpPr txBox="1"/>
          <p:nvPr/>
        </p:nvSpPr>
        <p:spPr>
          <a:xfrm>
            <a:off x="3252202" y="7383425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1D3CBCA4-BE1C-405F-8389-102BE367FCE0}"/>
              </a:ext>
            </a:extLst>
          </p:cNvPr>
          <p:cNvSpPr txBox="1"/>
          <p:nvPr/>
        </p:nvSpPr>
        <p:spPr>
          <a:xfrm>
            <a:off x="4516782" y="7383425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EAAFE920-9870-450E-BA36-AA9A64CE26A1}"/>
              </a:ext>
            </a:extLst>
          </p:cNvPr>
          <p:cNvSpPr txBox="1"/>
          <p:nvPr/>
        </p:nvSpPr>
        <p:spPr>
          <a:xfrm>
            <a:off x="5830619" y="7383425"/>
            <a:ext cx="394339" cy="138499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900" dirty="0">
                <a:solidFill>
                  <a:srgbClr val="000000"/>
                </a:solidFill>
                <a:latin typeface="Noto Sans Light"/>
              </a:rPr>
              <a:t>PHATE </a:t>
            </a:r>
            <a:r>
              <a:rPr sz="900" dirty="0">
                <a:solidFill>
                  <a:srgbClr val="000000"/>
                </a:solidFill>
                <a:latin typeface="Noto Sans Light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6297152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44CCF177-DB1F-4E1A-950C-6E105DC57651}"/>
              </a:ext>
            </a:extLst>
          </p:cNvPr>
          <p:cNvGrpSpPr/>
          <p:nvPr/>
        </p:nvGrpSpPr>
        <p:grpSpPr>
          <a:xfrm>
            <a:off x="207858" y="710707"/>
            <a:ext cx="1908343" cy="1411892"/>
            <a:chOff x="322055" y="628177"/>
            <a:chExt cx="1908343" cy="1411892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41846AF2-8D4C-47C5-95E8-E60171BA18B8}"/>
                </a:ext>
              </a:extLst>
            </p:cNvPr>
            <p:cNvGrpSpPr/>
            <p:nvPr/>
          </p:nvGrpSpPr>
          <p:grpSpPr>
            <a:xfrm>
              <a:off x="395246" y="785362"/>
              <a:ext cx="1835152" cy="1208156"/>
              <a:chOff x="441068" y="765672"/>
              <a:chExt cx="1835152" cy="1208156"/>
            </a:xfrm>
          </p:grpSpPr>
          <p:pic>
            <p:nvPicPr>
              <p:cNvPr id="5" name="Picture 4" descr="image.png">
                <a:extLst>
                  <a:ext uri="{FF2B5EF4-FFF2-40B4-BE49-F238E27FC236}">
                    <a16:creationId xmlns:a16="http://schemas.microsoft.com/office/drawing/2014/main" id="{DFC4357A-7C8B-486E-AA1A-9DDE29E518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47" t="7105" r="55156" b="7918"/>
              <a:stretch/>
            </p:blipFill>
            <p:spPr>
              <a:xfrm>
                <a:off x="441068" y="782466"/>
                <a:ext cx="1835152" cy="1191362"/>
              </a:xfrm>
              <a:prstGeom prst="rect">
                <a:avLst/>
              </a:prstGeom>
            </p:spPr>
          </p:pic>
          <p:sp>
            <p:nvSpPr>
              <p:cNvPr id="6" name="Freeform 4">
                <a:extLst>
                  <a:ext uri="{FF2B5EF4-FFF2-40B4-BE49-F238E27FC236}">
                    <a16:creationId xmlns:a16="http://schemas.microsoft.com/office/drawing/2014/main" id="{14266E8D-FFAC-4AE1-92A1-A5682EC6432C}"/>
                  </a:ext>
                </a:extLst>
              </p:cNvPr>
              <p:cNvSpPr/>
              <p:nvPr/>
            </p:nvSpPr>
            <p:spPr>
              <a:xfrm>
                <a:off x="524833" y="765672"/>
                <a:ext cx="1656579" cy="1127531"/>
              </a:xfrm>
              <a:custGeom>
                <a:avLst/>
                <a:gdLst/>
                <a:ahLst/>
                <a:cxnLst/>
                <a:rect l="l" t="t" r="r" b="b"/>
                <a:pathLst>
                  <a:path w="2318955" h="1578370">
                    <a:moveTo>
                      <a:pt x="0" y="0"/>
                    </a:moveTo>
                    <a:lnTo>
                      <a:pt x="2318955" y="0"/>
                    </a:lnTo>
                    <a:lnTo>
                      <a:pt x="2318955" y="1578370"/>
                    </a:lnTo>
                    <a:lnTo>
                      <a:pt x="0" y="1578370"/>
                    </a:lnTo>
                    <a:close/>
                  </a:path>
                </a:pathLst>
              </a:custGeom>
              <a:noFill/>
              <a:ln w="4628"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dirty="0"/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193AD50-F1BF-466C-888A-A8D82239CBE9}"/>
                </a:ext>
              </a:extLst>
            </p:cNvPr>
            <p:cNvSpPr txBox="1"/>
            <p:nvPr/>
          </p:nvSpPr>
          <p:spPr>
            <a:xfrm>
              <a:off x="1169379" y="1946967"/>
              <a:ext cx="267702" cy="9310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lang="en-GB" sz="605" dirty="0">
                  <a:solidFill>
                    <a:srgbClr val="000000"/>
                  </a:solidFill>
                  <a:latin typeface="Noto Sans Light"/>
                </a:rPr>
                <a:t>PHATE 1</a:t>
              </a:r>
              <a:endParaRPr sz="605" dirty="0">
                <a:solidFill>
                  <a:srgbClr val="000000"/>
                </a:solidFill>
                <a:latin typeface="Noto Sans Light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21DD22C-F3EE-47D1-94E2-DEB8B8603397}"/>
                </a:ext>
              </a:extLst>
            </p:cNvPr>
            <p:cNvSpPr txBox="1"/>
            <p:nvPr/>
          </p:nvSpPr>
          <p:spPr>
            <a:xfrm rot="16200000">
              <a:off x="251071" y="1304256"/>
              <a:ext cx="193462" cy="51493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605" dirty="0">
                  <a:solidFill>
                    <a:srgbClr val="000000"/>
                  </a:solidFill>
                  <a:latin typeface="Noto Sans Light"/>
                </a:rPr>
                <a:t>count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9E8DB74-C6D3-4BCD-9D39-00ED12E6AB2B}"/>
                </a:ext>
              </a:extLst>
            </p:cNvPr>
            <p:cNvSpPr txBox="1"/>
            <p:nvPr/>
          </p:nvSpPr>
          <p:spPr>
            <a:xfrm>
              <a:off x="912872" y="628177"/>
              <a:ext cx="799899" cy="123111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lang="en-US" sz="800" dirty="0">
                  <a:solidFill>
                    <a:srgbClr val="000000"/>
                  </a:solidFill>
                  <a:latin typeface="Noto Sans Light"/>
                </a:rPr>
                <a:t>Basal and Nb2-2-Fc</a:t>
              </a:r>
              <a:endParaRPr sz="800" dirty="0">
                <a:solidFill>
                  <a:srgbClr val="000000"/>
                </a:solidFill>
                <a:latin typeface="Noto Sans Light"/>
              </a:endParaRP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7D8F2A3D-FF4B-4F61-A4F5-DC3E5996F999}"/>
              </a:ext>
            </a:extLst>
          </p:cNvPr>
          <p:cNvGrpSpPr/>
          <p:nvPr/>
        </p:nvGrpSpPr>
        <p:grpSpPr>
          <a:xfrm>
            <a:off x="2051838" y="4003667"/>
            <a:ext cx="2532732" cy="965990"/>
            <a:chOff x="2822959" y="856979"/>
            <a:chExt cx="1262465" cy="706360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7AE1E8B6-DC84-4429-91B7-AA055408F951}"/>
                </a:ext>
              </a:extLst>
            </p:cNvPr>
            <p:cNvSpPr/>
            <p:nvPr/>
          </p:nvSpPr>
          <p:spPr>
            <a:xfrm>
              <a:off x="2822959" y="877373"/>
              <a:ext cx="111087" cy="60172"/>
            </a:xfrm>
            <a:prstGeom prst="rect">
              <a:avLst/>
            </a:prstGeom>
            <a:solidFill>
              <a:srgbClr val="1F77B3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FA082C0-A1BD-4A0F-B55B-100BF3AE2B65}"/>
                </a:ext>
              </a:extLst>
            </p:cNvPr>
            <p:cNvSpPr txBox="1"/>
            <p:nvPr/>
          </p:nvSpPr>
          <p:spPr>
            <a:xfrm>
              <a:off x="2957190" y="856979"/>
              <a:ext cx="1069905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1 </a:t>
              </a:r>
              <a:r>
                <a:rPr lang="en-GB" sz="800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- / CD62P- / CD63- / TLT-1- / </a:t>
              </a:r>
              <a:r>
                <a:rPr lang="en-GB" sz="800" dirty="0" err="1">
                  <a:solidFill>
                    <a:srgbClr val="000000"/>
                  </a:solidFill>
                  <a:latin typeface="Noto Sans Regular"/>
                </a:rPr>
                <a:t>AnnV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2695BA6F-CE0C-4A71-9C3F-FC8AD80122E9}"/>
                </a:ext>
              </a:extLst>
            </p:cNvPr>
            <p:cNvSpPr/>
            <p:nvPr/>
          </p:nvSpPr>
          <p:spPr>
            <a:xfrm>
              <a:off x="2822959" y="955598"/>
              <a:ext cx="111087" cy="60172"/>
            </a:xfrm>
            <a:prstGeom prst="rect">
              <a:avLst/>
            </a:prstGeom>
            <a:solidFill>
              <a:srgbClr val="FAFB6B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A0C39712-D94B-46F7-A4B0-D3A4E51C2DD4}"/>
                </a:ext>
              </a:extLst>
            </p:cNvPr>
            <p:cNvSpPr txBox="1"/>
            <p:nvPr/>
          </p:nvSpPr>
          <p:spPr>
            <a:xfrm>
              <a:off x="2957190" y="935203"/>
              <a:ext cx="1096273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4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</a:t>
              </a:r>
              <a:r>
                <a:rPr lang="en-GB" sz="800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- / CD62P-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3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TLT-1-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C0A8A875-302F-4D21-AE07-EB66A76C6815}"/>
                </a:ext>
              </a:extLst>
            </p:cNvPr>
            <p:cNvSpPr/>
            <p:nvPr/>
          </p:nvSpPr>
          <p:spPr>
            <a:xfrm>
              <a:off x="2822959" y="1033822"/>
              <a:ext cx="111087" cy="60172"/>
            </a:xfrm>
            <a:prstGeom prst="rect">
              <a:avLst/>
            </a:prstGeom>
            <a:solidFill>
              <a:srgbClr val="9C27D8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05C6E35-551A-4D83-9692-C8A7B84C8A6B}"/>
                </a:ext>
              </a:extLst>
            </p:cNvPr>
            <p:cNvSpPr txBox="1"/>
            <p:nvPr/>
          </p:nvSpPr>
          <p:spPr>
            <a:xfrm>
              <a:off x="2957190" y="1013427"/>
              <a:ext cx="1097072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3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</a:t>
              </a:r>
              <a:r>
                <a:rPr lang="en-GB" sz="800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-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CD63- / TLT-1- 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6A69C69-EC41-4B6D-959B-053FFC951AA0}"/>
                </a:ext>
              </a:extLst>
            </p:cNvPr>
            <p:cNvSpPr/>
            <p:nvPr/>
          </p:nvSpPr>
          <p:spPr>
            <a:xfrm>
              <a:off x="2822959" y="1112046"/>
              <a:ext cx="111087" cy="60172"/>
            </a:xfrm>
            <a:prstGeom prst="rect">
              <a:avLst/>
            </a:prstGeom>
            <a:solidFill>
              <a:srgbClr val="D62628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D00C165-3817-4C4D-8EEE-4875BBD175D3}"/>
                </a:ext>
              </a:extLst>
            </p:cNvPr>
            <p:cNvSpPr txBox="1"/>
            <p:nvPr/>
          </p:nvSpPr>
          <p:spPr>
            <a:xfrm>
              <a:off x="2957190" y="1091651"/>
              <a:ext cx="1098670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2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</a:t>
              </a:r>
              <a:r>
                <a:rPr lang="en-GB" sz="800" b="1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CD62P- / CD63- / TLT-1- 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A5A12B59-07FB-4CB7-BCF4-C3842332A118}"/>
                </a:ext>
              </a:extLst>
            </p:cNvPr>
            <p:cNvSpPr/>
            <p:nvPr/>
          </p:nvSpPr>
          <p:spPr>
            <a:xfrm>
              <a:off x="2822959" y="1190270"/>
              <a:ext cx="111087" cy="60172"/>
            </a:xfrm>
            <a:prstGeom prst="rect">
              <a:avLst/>
            </a:prstGeom>
            <a:solidFill>
              <a:srgbClr val="B3B0B4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B8FD9D0-A73F-418E-A33F-E0056B83DADE}"/>
                </a:ext>
              </a:extLst>
            </p:cNvPr>
            <p:cNvSpPr txBox="1"/>
            <p:nvPr/>
          </p:nvSpPr>
          <p:spPr>
            <a:xfrm>
              <a:off x="2957190" y="1169876"/>
              <a:ext cx="1109857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5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</a:t>
              </a:r>
              <a:r>
                <a:rPr lang="en-GB" sz="800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-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 CD63+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/ TLT-1- 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546DF432-8C57-440D-9D00-562F252D740A}"/>
                </a:ext>
              </a:extLst>
            </p:cNvPr>
            <p:cNvSpPr/>
            <p:nvPr/>
          </p:nvSpPr>
          <p:spPr>
            <a:xfrm>
              <a:off x="2822959" y="1268494"/>
              <a:ext cx="111087" cy="60172"/>
            </a:xfrm>
            <a:prstGeom prst="rect">
              <a:avLst/>
            </a:prstGeom>
            <a:solidFill>
              <a:srgbClr val="FEAC64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1131630-D954-4547-AC34-271B87A0989D}"/>
                </a:ext>
              </a:extLst>
            </p:cNvPr>
            <p:cNvSpPr txBox="1"/>
            <p:nvPr/>
          </p:nvSpPr>
          <p:spPr>
            <a:xfrm>
              <a:off x="2957190" y="1248100"/>
              <a:ext cx="1112253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6 </a:t>
              </a:r>
              <a:r>
                <a:rPr lang="en-GB" sz="800" b="1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CD63- / TLT-1- 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D1825B0-AAFB-4DBC-9676-65E3BF485381}"/>
                </a:ext>
              </a:extLst>
            </p:cNvPr>
            <p:cNvSpPr/>
            <p:nvPr/>
          </p:nvSpPr>
          <p:spPr>
            <a:xfrm>
              <a:off x="2822959" y="1346719"/>
              <a:ext cx="111087" cy="60172"/>
            </a:xfrm>
            <a:prstGeom prst="rect">
              <a:avLst/>
            </a:prstGeom>
            <a:solidFill>
              <a:srgbClr val="E67F26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0D830B7-593D-4465-B99B-3E104DACAF00}"/>
                </a:ext>
              </a:extLst>
            </p:cNvPr>
            <p:cNvSpPr txBox="1"/>
            <p:nvPr/>
          </p:nvSpPr>
          <p:spPr>
            <a:xfrm>
              <a:off x="2957190" y="1326324"/>
              <a:ext cx="1128234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7 </a:t>
              </a:r>
              <a:r>
                <a:rPr lang="en-GB" sz="800" b="1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CD63-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TLT-1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0A766966-BECB-4EE5-99DE-EC6E57CC4B07}"/>
                </a:ext>
              </a:extLst>
            </p:cNvPr>
            <p:cNvSpPr/>
            <p:nvPr/>
          </p:nvSpPr>
          <p:spPr>
            <a:xfrm>
              <a:off x="2822959" y="1424943"/>
              <a:ext cx="111087" cy="60172"/>
            </a:xfrm>
            <a:prstGeom prst="rect">
              <a:avLst/>
            </a:prstGeom>
            <a:solidFill>
              <a:srgbClr val="27F11B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BE8E67C-DF39-4D3C-BF2B-16ED5F10C4B7}"/>
                </a:ext>
              </a:extLst>
            </p:cNvPr>
            <p:cNvSpPr txBox="1"/>
            <p:nvPr/>
          </p:nvSpPr>
          <p:spPr>
            <a:xfrm>
              <a:off x="2957190" y="1404548"/>
              <a:ext cx="1125038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8 </a:t>
              </a:r>
              <a:r>
                <a:rPr lang="en-GB" sz="800" b="1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3+ 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TLT-1- 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31994E1-CCBE-4A12-AED7-79E930B7CEE3}"/>
                </a:ext>
              </a:extLst>
            </p:cNvPr>
            <p:cNvSpPr/>
            <p:nvPr/>
          </p:nvSpPr>
          <p:spPr>
            <a:xfrm>
              <a:off x="2822959" y="1503167"/>
              <a:ext cx="111087" cy="60172"/>
            </a:xfrm>
            <a:prstGeom prst="rect">
              <a:avLst/>
            </a:prstGeom>
            <a:solidFill>
              <a:srgbClr val="010101"/>
            </a:solidFill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sz="80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C4BC089-A624-46AD-9503-E79817F68537}"/>
                </a:ext>
              </a:extLst>
            </p:cNvPr>
            <p:cNvSpPr txBox="1"/>
            <p:nvPr/>
          </p:nvSpPr>
          <p:spPr>
            <a:xfrm>
              <a:off x="2957190" y="1482772"/>
              <a:ext cx="1113851" cy="61366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800" dirty="0">
                  <a:solidFill>
                    <a:srgbClr val="000000"/>
                  </a:solidFill>
                  <a:latin typeface="Noto Sans Regular"/>
                </a:rPr>
                <a:t>Pop. 09 </a:t>
              </a:r>
              <a:r>
                <a:rPr lang="en-GB" sz="800" b="1" dirty="0" err="1">
                  <a:solidFill>
                    <a:srgbClr val="000000"/>
                  </a:solidFill>
                  <a:latin typeface="Noto Sans Regular"/>
                </a:rPr>
                <a:t>Fg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+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2P+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 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CD63+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</a:t>
              </a:r>
              <a:r>
                <a:rPr lang="en-GB" sz="800" b="1" dirty="0">
                  <a:solidFill>
                    <a:srgbClr val="000000"/>
                  </a:solidFill>
                  <a:latin typeface="Noto Sans Regular"/>
                </a:rPr>
                <a:t>TLT-1+</a:t>
              </a:r>
              <a:r>
                <a:rPr lang="en-GB" sz="800" dirty="0">
                  <a:solidFill>
                    <a:srgbClr val="000000"/>
                  </a:solidFill>
                  <a:latin typeface="Noto Sans Regular"/>
                </a:rPr>
                <a:t>/ Ann V-</a:t>
              </a:r>
              <a:endParaRPr sz="800" dirty="0">
                <a:solidFill>
                  <a:srgbClr val="000000"/>
                </a:solidFill>
                <a:latin typeface="Noto Sans Regular"/>
              </a:endParaRPr>
            </a:p>
          </p:txBody>
        </p:sp>
      </p:grpSp>
      <p:pic>
        <p:nvPicPr>
          <p:cNvPr id="30" name="Picture 29" descr="image.png">
            <a:extLst>
              <a:ext uri="{FF2B5EF4-FFF2-40B4-BE49-F238E27FC236}">
                <a16:creationId xmlns:a16="http://schemas.microsoft.com/office/drawing/2014/main" id="{76915F4F-B134-476E-8064-83C89231304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3" t="7580" r="56279" b="10604"/>
          <a:stretch/>
        </p:blipFill>
        <p:spPr>
          <a:xfrm>
            <a:off x="2271801" y="899146"/>
            <a:ext cx="1765325" cy="1142876"/>
          </a:xfrm>
          <a:prstGeom prst="rect">
            <a:avLst/>
          </a:prstGeom>
        </p:spPr>
      </p:pic>
      <p:sp>
        <p:nvSpPr>
          <p:cNvPr id="31" name="Freeform 36">
            <a:extLst>
              <a:ext uri="{FF2B5EF4-FFF2-40B4-BE49-F238E27FC236}">
                <a16:creationId xmlns:a16="http://schemas.microsoft.com/office/drawing/2014/main" id="{FC7CE070-BA91-40A4-BC9B-25D439F8CC8F}"/>
              </a:ext>
            </a:extLst>
          </p:cNvPr>
          <p:cNvSpPr/>
          <p:nvPr/>
        </p:nvSpPr>
        <p:spPr>
          <a:xfrm>
            <a:off x="2333753" y="873456"/>
            <a:ext cx="1658678" cy="1130550"/>
          </a:xfrm>
          <a:custGeom>
            <a:avLst/>
            <a:gdLst/>
            <a:ahLst/>
            <a:cxnLst/>
            <a:rect l="l" t="t" r="r" b="b"/>
            <a:pathLst>
              <a:path w="2318955" h="1578370">
                <a:moveTo>
                  <a:pt x="0" y="0"/>
                </a:moveTo>
                <a:lnTo>
                  <a:pt x="2318955" y="0"/>
                </a:lnTo>
                <a:lnTo>
                  <a:pt x="2318955" y="1578370"/>
                </a:lnTo>
                <a:lnTo>
                  <a:pt x="0" y="1578370"/>
                </a:lnTo>
                <a:close/>
              </a:path>
            </a:pathLst>
          </a:custGeom>
          <a:noFill/>
          <a:ln w="4628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3733C44-508F-4D6B-8EE9-6BDF06891242}"/>
              </a:ext>
            </a:extLst>
          </p:cNvPr>
          <p:cNvSpPr txBox="1"/>
          <p:nvPr/>
        </p:nvSpPr>
        <p:spPr>
          <a:xfrm>
            <a:off x="3028208" y="2036956"/>
            <a:ext cx="191479" cy="66267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605" dirty="0">
                <a:solidFill>
                  <a:srgbClr val="000000"/>
                </a:solidFill>
                <a:latin typeface="Noto Sans Light"/>
              </a:rPr>
              <a:t>PHATE 1</a:t>
            </a:r>
            <a:endParaRPr sz="605" dirty="0">
              <a:solidFill>
                <a:srgbClr val="000000"/>
              </a:solidFill>
              <a:latin typeface="Noto Sans Light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B0ABE0D-33DF-4B11-90A7-0E3DD974559D}"/>
              </a:ext>
            </a:extLst>
          </p:cNvPr>
          <p:cNvSpPr txBox="1"/>
          <p:nvPr/>
        </p:nvSpPr>
        <p:spPr>
          <a:xfrm rot="16200000">
            <a:off x="2119024" y="1420911"/>
            <a:ext cx="137701" cy="3683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sz="605" dirty="0">
                <a:solidFill>
                  <a:srgbClr val="000000"/>
                </a:solidFill>
                <a:latin typeface="Noto Sans Light"/>
              </a:rPr>
              <a:t>coun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D12C9F8-C51D-41AB-8832-E1F9B2004AD7}"/>
              </a:ext>
            </a:extLst>
          </p:cNvPr>
          <p:cNvSpPr txBox="1"/>
          <p:nvPr/>
        </p:nvSpPr>
        <p:spPr>
          <a:xfrm>
            <a:off x="2719142" y="716044"/>
            <a:ext cx="843180" cy="12311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US" sz="800" dirty="0">
                <a:solidFill>
                  <a:srgbClr val="000000"/>
                </a:solidFill>
                <a:latin typeface="Noto Sans Light"/>
              </a:rPr>
              <a:t>Basal and LUAS-2-Fc</a:t>
            </a:r>
            <a:endParaRPr sz="800" dirty="0">
              <a:solidFill>
                <a:srgbClr val="000000"/>
              </a:solidFill>
              <a:latin typeface="Noto Sans Light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84382F6-C92F-4768-996C-D8C77093192E}"/>
              </a:ext>
            </a:extLst>
          </p:cNvPr>
          <p:cNvSpPr txBox="1"/>
          <p:nvPr/>
        </p:nvSpPr>
        <p:spPr>
          <a:xfrm rot="16200000">
            <a:off x="4119062" y="1386785"/>
            <a:ext cx="193462" cy="51493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sz="605" dirty="0">
                <a:solidFill>
                  <a:srgbClr val="000000"/>
                </a:solidFill>
                <a:latin typeface="Noto Sans Light"/>
              </a:rPr>
              <a:t>count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C283922-ABF0-407C-9670-7A94951F73B5}"/>
              </a:ext>
            </a:extLst>
          </p:cNvPr>
          <p:cNvSpPr txBox="1"/>
          <p:nvPr/>
        </p:nvSpPr>
        <p:spPr>
          <a:xfrm>
            <a:off x="4747284" y="706367"/>
            <a:ext cx="902491" cy="12311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US" sz="800" dirty="0">
                <a:solidFill>
                  <a:srgbClr val="000000"/>
                </a:solidFill>
                <a:latin typeface="Noto Sans Light"/>
              </a:rPr>
              <a:t>Basal and Nb138-2-Fc</a:t>
            </a:r>
            <a:endParaRPr sz="605" dirty="0">
              <a:solidFill>
                <a:srgbClr val="000000"/>
              </a:solidFill>
              <a:latin typeface="Noto Sans Light"/>
            </a:endParaRPr>
          </a:p>
        </p:txBody>
      </p:sp>
      <p:grpSp>
        <p:nvGrpSpPr>
          <p:cNvPr id="206" name="Group 205">
            <a:extLst>
              <a:ext uri="{FF2B5EF4-FFF2-40B4-BE49-F238E27FC236}">
                <a16:creationId xmlns:a16="http://schemas.microsoft.com/office/drawing/2014/main" id="{D9DB1ED6-521E-43F1-8CB8-B69E67D72877}"/>
              </a:ext>
            </a:extLst>
          </p:cNvPr>
          <p:cNvGrpSpPr/>
          <p:nvPr/>
        </p:nvGrpSpPr>
        <p:grpSpPr>
          <a:xfrm>
            <a:off x="4274741" y="866758"/>
            <a:ext cx="1835151" cy="1252463"/>
            <a:chOff x="4006952" y="849308"/>
            <a:chExt cx="1778106" cy="1250814"/>
          </a:xfrm>
        </p:grpSpPr>
        <p:pic>
          <p:nvPicPr>
            <p:cNvPr id="36" name="Picture 35" descr="image.png">
              <a:extLst>
                <a:ext uri="{FF2B5EF4-FFF2-40B4-BE49-F238E27FC236}">
                  <a16:creationId xmlns:a16="http://schemas.microsoft.com/office/drawing/2014/main" id="{ED7DF5EE-C52D-4CF4-9ED7-4C16B8EED3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55" t="5513" r="54866" b="8754"/>
            <a:stretch/>
          </p:blipFill>
          <p:spPr>
            <a:xfrm>
              <a:off x="4006952" y="849308"/>
              <a:ext cx="1778106" cy="1187060"/>
            </a:xfrm>
            <a:prstGeom prst="rect">
              <a:avLst/>
            </a:prstGeom>
          </p:spPr>
        </p:pic>
        <p:sp>
          <p:nvSpPr>
            <p:cNvPr id="37" name="Freeform 68">
              <a:extLst>
                <a:ext uri="{FF2B5EF4-FFF2-40B4-BE49-F238E27FC236}">
                  <a16:creationId xmlns:a16="http://schemas.microsoft.com/office/drawing/2014/main" id="{3FB5D16E-FAA8-4B34-B2B4-0A1BA41E3380}"/>
                </a:ext>
              </a:extLst>
            </p:cNvPr>
            <p:cNvSpPr/>
            <p:nvPr/>
          </p:nvSpPr>
          <p:spPr>
            <a:xfrm>
              <a:off x="4045745" y="857505"/>
              <a:ext cx="1633882" cy="1123438"/>
            </a:xfrm>
            <a:custGeom>
              <a:avLst/>
              <a:gdLst/>
              <a:ahLst/>
              <a:cxnLst/>
              <a:rect l="l" t="t" r="r" b="b"/>
              <a:pathLst>
                <a:path w="2318955" h="1578370">
                  <a:moveTo>
                    <a:pt x="0" y="0"/>
                  </a:moveTo>
                  <a:lnTo>
                    <a:pt x="2318955" y="0"/>
                  </a:lnTo>
                  <a:lnTo>
                    <a:pt x="2318955" y="1578370"/>
                  </a:lnTo>
                  <a:lnTo>
                    <a:pt x="0" y="1578370"/>
                  </a:lnTo>
                  <a:close/>
                </a:path>
              </a:pathLst>
            </a:custGeom>
            <a:noFill/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u="sng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6A7CC2C-D432-4047-83D3-D0B69625C2EB}"/>
                </a:ext>
              </a:extLst>
            </p:cNvPr>
            <p:cNvSpPr txBox="1"/>
            <p:nvPr/>
          </p:nvSpPr>
          <p:spPr>
            <a:xfrm>
              <a:off x="4758880" y="2007020"/>
              <a:ext cx="267702" cy="93102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lang="en-GB" sz="605" dirty="0">
                  <a:solidFill>
                    <a:srgbClr val="000000"/>
                  </a:solidFill>
                  <a:latin typeface="Noto Sans Light"/>
                </a:rPr>
                <a:t>PHATE 1</a:t>
              </a:r>
              <a:endParaRPr sz="605" dirty="0">
                <a:solidFill>
                  <a:srgbClr val="000000"/>
                </a:solidFill>
                <a:latin typeface="Noto Sans Light"/>
              </a:endParaRPr>
            </a:p>
          </p:txBody>
        </p:sp>
      </p:grpSp>
      <p:sp>
        <p:nvSpPr>
          <p:cNvPr id="64" name="TextBox 63">
            <a:extLst>
              <a:ext uri="{FF2B5EF4-FFF2-40B4-BE49-F238E27FC236}">
                <a16:creationId xmlns:a16="http://schemas.microsoft.com/office/drawing/2014/main" id="{95C73AD0-EB24-427F-9889-DD3E9D29D939}"/>
              </a:ext>
            </a:extLst>
          </p:cNvPr>
          <p:cNvSpPr txBox="1"/>
          <p:nvPr/>
        </p:nvSpPr>
        <p:spPr>
          <a:xfrm rot="16200000">
            <a:off x="17738" y="3019211"/>
            <a:ext cx="193462" cy="51493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sz="605" dirty="0">
                <a:solidFill>
                  <a:srgbClr val="000000"/>
                </a:solidFill>
                <a:latin typeface="Noto Sans Light"/>
              </a:rPr>
              <a:t>coun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FC91D41E-787B-41D7-91EE-6C6C53578A95}"/>
              </a:ext>
            </a:extLst>
          </p:cNvPr>
          <p:cNvSpPr txBox="1"/>
          <p:nvPr/>
        </p:nvSpPr>
        <p:spPr>
          <a:xfrm>
            <a:off x="807304" y="2307558"/>
            <a:ext cx="799899" cy="12311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r>
              <a:rPr lang="en-US" sz="800" dirty="0">
                <a:solidFill>
                  <a:srgbClr val="000000"/>
                </a:solidFill>
                <a:latin typeface="Noto Sans Light"/>
              </a:rPr>
              <a:t>Basal and Nb2-2-Fc</a:t>
            </a:r>
          </a:p>
        </p:txBody>
      </p:sp>
      <p:grpSp>
        <p:nvGrpSpPr>
          <p:cNvPr id="82" name="Group 81">
            <a:extLst>
              <a:ext uri="{FF2B5EF4-FFF2-40B4-BE49-F238E27FC236}">
                <a16:creationId xmlns:a16="http://schemas.microsoft.com/office/drawing/2014/main" id="{1E0CD2D5-39B5-48C0-A4F5-7600D5DC6CF2}"/>
              </a:ext>
            </a:extLst>
          </p:cNvPr>
          <p:cNvGrpSpPr/>
          <p:nvPr/>
        </p:nvGrpSpPr>
        <p:grpSpPr>
          <a:xfrm>
            <a:off x="203774" y="2430669"/>
            <a:ext cx="1927913" cy="1256128"/>
            <a:chOff x="450597" y="2644947"/>
            <a:chExt cx="1927913" cy="1256128"/>
          </a:xfrm>
        </p:grpSpPr>
        <p:pic>
          <p:nvPicPr>
            <p:cNvPr id="61" name="Picture 60" descr="image.png">
              <a:extLst>
                <a:ext uri="{FF2B5EF4-FFF2-40B4-BE49-F238E27FC236}">
                  <a16:creationId xmlns:a16="http://schemas.microsoft.com/office/drawing/2014/main" id="{E0AAB73C-D1F5-4407-843C-752C8ED43B9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929" t="4112" r="55370" b="8019"/>
            <a:stretch/>
          </p:blipFill>
          <p:spPr>
            <a:xfrm>
              <a:off x="586344" y="2644947"/>
              <a:ext cx="1792166" cy="1256128"/>
            </a:xfrm>
            <a:prstGeom prst="rect">
              <a:avLst/>
            </a:prstGeom>
          </p:spPr>
        </p:pic>
        <p:sp>
          <p:nvSpPr>
            <p:cNvPr id="62" name="Freeform 3">
              <a:extLst>
                <a:ext uri="{FF2B5EF4-FFF2-40B4-BE49-F238E27FC236}">
                  <a16:creationId xmlns:a16="http://schemas.microsoft.com/office/drawing/2014/main" id="{4F1B3A2F-C115-46FF-BDB2-2A5D788EBE1D}"/>
                </a:ext>
              </a:extLst>
            </p:cNvPr>
            <p:cNvSpPr/>
            <p:nvPr/>
          </p:nvSpPr>
          <p:spPr>
            <a:xfrm>
              <a:off x="609493" y="2685511"/>
              <a:ext cx="1689168" cy="1149712"/>
            </a:xfrm>
            <a:custGeom>
              <a:avLst/>
              <a:gdLst/>
              <a:ahLst/>
              <a:cxnLst/>
              <a:rect l="l" t="t" r="r" b="b"/>
              <a:pathLst>
                <a:path w="2318955" h="1578370">
                  <a:moveTo>
                    <a:pt x="0" y="0"/>
                  </a:moveTo>
                  <a:lnTo>
                    <a:pt x="2318955" y="0"/>
                  </a:lnTo>
                  <a:lnTo>
                    <a:pt x="2318955" y="1578370"/>
                  </a:lnTo>
                  <a:lnTo>
                    <a:pt x="0" y="1578370"/>
                  </a:lnTo>
                  <a:close/>
                </a:path>
              </a:pathLst>
            </a:custGeom>
            <a:noFill/>
            <a:ln w="4628"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/>
            </a:p>
          </p:txBody>
        </p:sp>
        <p:pic>
          <p:nvPicPr>
            <p:cNvPr id="73" name="Picture 72" descr="image.png">
              <a:extLst>
                <a:ext uri="{FF2B5EF4-FFF2-40B4-BE49-F238E27FC236}">
                  <a16:creationId xmlns:a16="http://schemas.microsoft.com/office/drawing/2014/main" id="{C1D15058-63FA-41DF-8200-A81253EDCD38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2857" y="2687749"/>
              <a:ext cx="101148" cy="1142973"/>
            </a:xfrm>
            <a:prstGeom prst="rect">
              <a:avLst/>
            </a:prstGeom>
          </p:spPr>
        </p:pic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94C0C3B5-D733-4840-B168-96C3EFC8AE38}"/>
                </a:ext>
              </a:extLst>
            </p:cNvPr>
            <p:cNvGrpSpPr/>
            <p:nvPr/>
          </p:nvGrpSpPr>
          <p:grpSpPr>
            <a:xfrm>
              <a:off x="450597" y="2651390"/>
              <a:ext cx="77019" cy="1174834"/>
              <a:chOff x="277201" y="819733"/>
              <a:chExt cx="105735" cy="1612867"/>
            </a:xfrm>
          </p:grpSpPr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69D7056D-B5CC-481D-9269-737E68A573A2}"/>
                  </a:ext>
                </a:extLst>
              </p:cNvPr>
              <p:cNvSpPr txBox="1"/>
              <p:nvPr/>
            </p:nvSpPr>
            <p:spPr>
              <a:xfrm>
                <a:off x="314230" y="2388846"/>
                <a:ext cx="68706" cy="43754"/>
              </a:xfrm>
              <a:prstGeom prst="rect">
                <a:avLst/>
              </a:prstGeom>
              <a:noFill/>
            </p:spPr>
            <p:txBody>
              <a:bodyPr wrap="none" lIns="0" tIns="0" rIns="0" bIns="0" anchor="t">
                <a:spAutoFit/>
              </a:bodyPr>
              <a:lstStyle/>
              <a:p>
                <a:pPr algn="l"/>
                <a:r>
                  <a:rPr sz="469">
                    <a:solidFill>
                      <a:srgbClr val="000000"/>
                    </a:solidFill>
                    <a:latin typeface="Noto Sans SemCond Light"/>
                  </a:rPr>
                  <a:t>0.0</a:t>
                </a: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C37CFF1D-02C4-4773-97CD-38E8F3369995}"/>
                  </a:ext>
                </a:extLst>
              </p:cNvPr>
              <p:cNvSpPr txBox="1"/>
              <p:nvPr/>
            </p:nvSpPr>
            <p:spPr>
              <a:xfrm>
                <a:off x="295716" y="2000039"/>
                <a:ext cx="85051" cy="43754"/>
              </a:xfrm>
              <a:prstGeom prst="rect">
                <a:avLst/>
              </a:prstGeom>
              <a:noFill/>
            </p:spPr>
            <p:txBody>
              <a:bodyPr wrap="none" lIns="0" tIns="0" rIns="0" bIns="0" anchor="t">
                <a:spAutoFit/>
              </a:bodyPr>
              <a:lstStyle/>
              <a:p>
                <a:pPr algn="l"/>
                <a:r>
                  <a:rPr sz="469">
                    <a:solidFill>
                      <a:srgbClr val="000000"/>
                    </a:solidFill>
                    <a:latin typeface="Noto Sans SemCond Light"/>
                  </a:rPr>
                  <a:t>510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06D711A0-132E-44F0-ADBC-86B0CE71AE53}"/>
                  </a:ext>
                </a:extLst>
              </p:cNvPr>
              <p:cNvSpPr txBox="1"/>
              <p:nvPr/>
            </p:nvSpPr>
            <p:spPr>
              <a:xfrm>
                <a:off x="281829" y="1606603"/>
                <a:ext cx="101034" cy="43754"/>
              </a:xfrm>
              <a:prstGeom prst="rect">
                <a:avLst/>
              </a:prstGeom>
              <a:noFill/>
            </p:spPr>
            <p:txBody>
              <a:bodyPr wrap="none" lIns="0" tIns="0" rIns="0" bIns="0" anchor="t">
                <a:spAutoFit/>
              </a:bodyPr>
              <a:lstStyle/>
              <a:p>
                <a:pPr algn="l"/>
                <a:r>
                  <a:rPr sz="469" dirty="0">
                    <a:solidFill>
                      <a:srgbClr val="000000"/>
                    </a:solidFill>
                    <a:latin typeface="Noto Sans SemCond Light"/>
                  </a:rPr>
                  <a:t>1.0K</a:t>
                </a: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F2AD55F-82EE-4C00-991F-0EE8AD7C0981}"/>
                  </a:ext>
                </a:extLst>
              </p:cNvPr>
              <p:cNvSpPr txBox="1"/>
              <p:nvPr/>
            </p:nvSpPr>
            <p:spPr>
              <a:xfrm>
                <a:off x="281829" y="1213819"/>
                <a:ext cx="101034" cy="43104"/>
              </a:xfrm>
              <a:prstGeom prst="rect">
                <a:avLst/>
              </a:prstGeom>
              <a:noFill/>
            </p:spPr>
            <p:txBody>
              <a:bodyPr wrap="none" lIns="0" tIns="0" rIns="0" bIns="0" anchor="t">
                <a:spAutoFit/>
              </a:bodyPr>
              <a:lstStyle/>
              <a:p>
                <a:pPr algn="l"/>
                <a:r>
                  <a:rPr sz="469" dirty="0">
                    <a:solidFill>
                      <a:srgbClr val="000000"/>
                    </a:solidFill>
                    <a:latin typeface="Noto Sans SemCond Light"/>
                  </a:rPr>
                  <a:t>1.5K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ED0E6F92-0852-4E17-B9E8-AE2180A785C2}"/>
                  </a:ext>
                </a:extLst>
              </p:cNvPr>
              <p:cNvSpPr txBox="1"/>
              <p:nvPr/>
            </p:nvSpPr>
            <p:spPr>
              <a:xfrm>
                <a:off x="277201" y="819733"/>
                <a:ext cx="103349" cy="43754"/>
              </a:xfrm>
              <a:prstGeom prst="rect">
                <a:avLst/>
              </a:prstGeom>
              <a:noFill/>
            </p:spPr>
            <p:txBody>
              <a:bodyPr wrap="none" lIns="0" tIns="0" rIns="0" bIns="0" anchor="t">
                <a:spAutoFit/>
              </a:bodyPr>
              <a:lstStyle/>
              <a:p>
                <a:pPr algn="l"/>
                <a:r>
                  <a:rPr sz="469" dirty="0">
                    <a:solidFill>
                      <a:srgbClr val="000000"/>
                    </a:solidFill>
                    <a:latin typeface="Noto Sans SemCond Light"/>
                  </a:rPr>
                  <a:t>2.0K</a:t>
                </a:r>
              </a:p>
            </p:txBody>
          </p:sp>
        </p:grpSp>
      </p:grpSp>
      <p:sp>
        <p:nvSpPr>
          <p:cNvPr id="80" name="TextBox 79">
            <a:extLst>
              <a:ext uri="{FF2B5EF4-FFF2-40B4-BE49-F238E27FC236}">
                <a16:creationId xmlns:a16="http://schemas.microsoft.com/office/drawing/2014/main" id="{05CF8715-6D5D-4D7A-924E-D9608BF3A154}"/>
              </a:ext>
            </a:extLst>
          </p:cNvPr>
          <p:cNvSpPr txBox="1"/>
          <p:nvPr/>
        </p:nvSpPr>
        <p:spPr>
          <a:xfrm>
            <a:off x="1035277" y="3654659"/>
            <a:ext cx="267702" cy="93102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605" dirty="0">
                <a:solidFill>
                  <a:srgbClr val="000000"/>
                </a:solidFill>
                <a:latin typeface="Noto Sans Light"/>
              </a:rPr>
              <a:t>PHATE 1</a:t>
            </a:r>
            <a:endParaRPr sz="605" dirty="0">
              <a:solidFill>
                <a:srgbClr val="000000"/>
              </a:solidFill>
              <a:latin typeface="Noto Sans Light"/>
            </a:endParaRP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A117BD47-F87A-4E24-B369-A84C6B971276}"/>
              </a:ext>
            </a:extLst>
          </p:cNvPr>
          <p:cNvSpPr txBox="1"/>
          <p:nvPr/>
        </p:nvSpPr>
        <p:spPr>
          <a:xfrm rot="16200000">
            <a:off x="2038714" y="2989049"/>
            <a:ext cx="179536" cy="93102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sz="605" dirty="0">
                <a:solidFill>
                  <a:srgbClr val="000000"/>
                </a:solidFill>
                <a:latin typeface="Noto Sans Light"/>
              </a:rPr>
              <a:t>count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890F220-9A9D-4641-BD0C-3E436867C43A}"/>
              </a:ext>
            </a:extLst>
          </p:cNvPr>
          <p:cNvSpPr txBox="1"/>
          <p:nvPr/>
        </p:nvSpPr>
        <p:spPr>
          <a:xfrm>
            <a:off x="2786691" y="2320026"/>
            <a:ext cx="843180" cy="12311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r>
              <a:rPr lang="en-US" sz="800" dirty="0">
                <a:solidFill>
                  <a:srgbClr val="000000"/>
                </a:solidFill>
                <a:latin typeface="Noto Sans Light"/>
              </a:rPr>
              <a:t>Basal and LUAS-2-Fc</a:t>
            </a:r>
          </a:p>
        </p:txBody>
      </p:sp>
      <p:pic>
        <p:nvPicPr>
          <p:cNvPr id="84" name="Picture 83" descr="image.png">
            <a:extLst>
              <a:ext uri="{FF2B5EF4-FFF2-40B4-BE49-F238E27FC236}">
                <a16:creationId xmlns:a16="http://schemas.microsoft.com/office/drawing/2014/main" id="{B5AAF220-5121-4C4F-A5B4-06989DDFF6A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616" t="6250" r="56583" b="8881"/>
          <a:stretch/>
        </p:blipFill>
        <p:spPr>
          <a:xfrm>
            <a:off x="2259646" y="2466307"/>
            <a:ext cx="1799509" cy="1215244"/>
          </a:xfrm>
          <a:prstGeom prst="rect">
            <a:avLst/>
          </a:prstGeom>
        </p:spPr>
      </p:pic>
      <p:sp>
        <p:nvSpPr>
          <p:cNvPr id="85" name="Freeform 42">
            <a:extLst>
              <a:ext uri="{FF2B5EF4-FFF2-40B4-BE49-F238E27FC236}">
                <a16:creationId xmlns:a16="http://schemas.microsoft.com/office/drawing/2014/main" id="{97682021-A277-4EA5-9B4E-21FB561A5D25}"/>
              </a:ext>
            </a:extLst>
          </p:cNvPr>
          <p:cNvSpPr/>
          <p:nvPr/>
        </p:nvSpPr>
        <p:spPr>
          <a:xfrm>
            <a:off x="2335062" y="2466307"/>
            <a:ext cx="1691936" cy="1151596"/>
          </a:xfrm>
          <a:custGeom>
            <a:avLst/>
            <a:gdLst/>
            <a:ahLst/>
            <a:cxnLst/>
            <a:rect l="l" t="t" r="r" b="b"/>
            <a:pathLst>
              <a:path w="2318955" h="1578370">
                <a:moveTo>
                  <a:pt x="0" y="0"/>
                </a:moveTo>
                <a:lnTo>
                  <a:pt x="2318955" y="0"/>
                </a:lnTo>
                <a:lnTo>
                  <a:pt x="2318955" y="1578370"/>
                </a:lnTo>
                <a:lnTo>
                  <a:pt x="0" y="1578370"/>
                </a:lnTo>
                <a:close/>
              </a:path>
            </a:pathLst>
          </a:custGeom>
          <a:noFill/>
          <a:ln w="4628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pic>
        <p:nvPicPr>
          <p:cNvPr id="91" name="Picture 90" descr="image.png">
            <a:extLst>
              <a:ext uri="{FF2B5EF4-FFF2-40B4-BE49-F238E27FC236}">
                <a16:creationId xmlns:a16="http://schemas.microsoft.com/office/drawing/2014/main" id="{49BF961F-0B9B-4371-856D-098FC2ECEBB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36215" y="2467995"/>
            <a:ext cx="101313" cy="1144842"/>
          </a:xfrm>
          <a:prstGeom prst="rect">
            <a:avLst/>
          </a:prstGeom>
        </p:spPr>
      </p:pic>
      <p:grpSp>
        <p:nvGrpSpPr>
          <p:cNvPr id="92" name="Group 91">
            <a:extLst>
              <a:ext uri="{FF2B5EF4-FFF2-40B4-BE49-F238E27FC236}">
                <a16:creationId xmlns:a16="http://schemas.microsoft.com/office/drawing/2014/main" id="{B606B993-E030-4D2D-972B-0CD5346B9890}"/>
              </a:ext>
            </a:extLst>
          </p:cNvPr>
          <p:cNvGrpSpPr/>
          <p:nvPr/>
        </p:nvGrpSpPr>
        <p:grpSpPr>
          <a:xfrm>
            <a:off x="2169458" y="2424644"/>
            <a:ext cx="81987" cy="1197519"/>
            <a:chOff x="277201" y="2817459"/>
            <a:chExt cx="112371" cy="1641312"/>
          </a:xfrm>
        </p:grpSpPr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3EFFC468-F531-481F-9D23-51D1FF8643BF}"/>
                </a:ext>
              </a:extLst>
            </p:cNvPr>
            <p:cNvSpPr txBox="1"/>
            <p:nvPr/>
          </p:nvSpPr>
          <p:spPr>
            <a:xfrm>
              <a:off x="314230" y="4386572"/>
              <a:ext cx="75342" cy="72199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>
                  <a:solidFill>
                    <a:srgbClr val="000000"/>
                  </a:solidFill>
                  <a:latin typeface="Noto Sans SemCond Light"/>
                </a:rPr>
                <a:t>0.0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A95A55BD-6247-4D64-9CA1-5DA1ADD5F33B}"/>
                </a:ext>
              </a:extLst>
            </p:cNvPr>
            <p:cNvSpPr txBox="1"/>
            <p:nvPr/>
          </p:nvSpPr>
          <p:spPr>
            <a:xfrm>
              <a:off x="295716" y="3997692"/>
              <a:ext cx="91372" cy="72199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>
                  <a:solidFill>
                    <a:srgbClr val="000000"/>
                  </a:solidFill>
                  <a:latin typeface="Noto Sans SemCond Light"/>
                </a:rPr>
                <a:t>586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A41B6EB-255D-4C66-B85C-EC13D1B5AEAB}"/>
                </a:ext>
              </a:extLst>
            </p:cNvPr>
            <p:cNvSpPr txBox="1"/>
            <p:nvPr/>
          </p:nvSpPr>
          <p:spPr>
            <a:xfrm>
              <a:off x="281829" y="3604329"/>
              <a:ext cx="105798" cy="72199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>
                  <a:solidFill>
                    <a:srgbClr val="000000"/>
                  </a:solidFill>
                  <a:latin typeface="Noto Sans SemCond Light"/>
                </a:rPr>
                <a:t>1.2K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498386A7-1515-42C8-8F67-953BCC950F67}"/>
                </a:ext>
              </a:extLst>
            </p:cNvPr>
            <p:cNvSpPr txBox="1"/>
            <p:nvPr/>
          </p:nvSpPr>
          <p:spPr>
            <a:xfrm>
              <a:off x="281829" y="3210894"/>
              <a:ext cx="105798" cy="72199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 dirty="0">
                  <a:solidFill>
                    <a:srgbClr val="000000"/>
                  </a:solidFill>
                  <a:latin typeface="Noto Sans SemCond Light"/>
                </a:rPr>
                <a:t>1.8K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1164B836-7520-409C-A827-AB0597092A13}"/>
                </a:ext>
              </a:extLst>
            </p:cNvPr>
            <p:cNvSpPr txBox="1"/>
            <p:nvPr/>
          </p:nvSpPr>
          <p:spPr>
            <a:xfrm>
              <a:off x="277201" y="2817459"/>
              <a:ext cx="105798" cy="72199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 dirty="0">
                  <a:solidFill>
                    <a:srgbClr val="000000"/>
                  </a:solidFill>
                  <a:latin typeface="Noto Sans SemCond Light"/>
                </a:rPr>
                <a:t>2.3K</a:t>
              </a:r>
            </a:p>
          </p:txBody>
        </p:sp>
      </p:grpSp>
      <p:sp>
        <p:nvSpPr>
          <p:cNvPr id="161" name="TextBox 160">
            <a:extLst>
              <a:ext uri="{FF2B5EF4-FFF2-40B4-BE49-F238E27FC236}">
                <a16:creationId xmlns:a16="http://schemas.microsoft.com/office/drawing/2014/main" id="{A5C0BDC3-FA36-47BB-A318-2BB2D8C5D841}"/>
              </a:ext>
            </a:extLst>
          </p:cNvPr>
          <p:cNvSpPr txBox="1"/>
          <p:nvPr/>
        </p:nvSpPr>
        <p:spPr>
          <a:xfrm>
            <a:off x="3008252" y="3659687"/>
            <a:ext cx="267702" cy="93102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605" dirty="0">
                <a:solidFill>
                  <a:srgbClr val="000000"/>
                </a:solidFill>
                <a:latin typeface="Noto Sans Light"/>
              </a:rPr>
              <a:t>PHATE 1</a:t>
            </a:r>
            <a:endParaRPr sz="605" dirty="0">
              <a:solidFill>
                <a:srgbClr val="000000"/>
              </a:solidFill>
              <a:latin typeface="Noto Sans Light"/>
            </a:endParaRP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2A28EC59-6540-4602-BD60-03FBCCCF0D02}"/>
              </a:ext>
            </a:extLst>
          </p:cNvPr>
          <p:cNvSpPr txBox="1"/>
          <p:nvPr/>
        </p:nvSpPr>
        <p:spPr>
          <a:xfrm>
            <a:off x="4690096" y="2338527"/>
            <a:ext cx="928139" cy="12311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r>
              <a:rPr lang="en-US" sz="800" dirty="0">
                <a:solidFill>
                  <a:srgbClr val="000000"/>
                </a:solidFill>
                <a:latin typeface="Noto Sans Light"/>
              </a:rPr>
              <a:t>Basal and Nb138-2-Fc</a:t>
            </a:r>
          </a:p>
        </p:txBody>
      </p:sp>
      <p:pic>
        <p:nvPicPr>
          <p:cNvPr id="166" name="Picture 165" descr="image.png">
            <a:extLst>
              <a:ext uri="{FF2B5EF4-FFF2-40B4-BE49-F238E27FC236}">
                <a16:creationId xmlns:a16="http://schemas.microsoft.com/office/drawing/2014/main" id="{AB0C7D57-303E-4D77-8092-FC0703A71CA1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3326" t="5685" r="56879" b="10232"/>
          <a:stretch/>
        </p:blipFill>
        <p:spPr>
          <a:xfrm>
            <a:off x="4272854" y="2462339"/>
            <a:ext cx="1728224" cy="1185496"/>
          </a:xfrm>
          <a:prstGeom prst="rect">
            <a:avLst/>
          </a:prstGeom>
        </p:spPr>
      </p:pic>
      <p:sp>
        <p:nvSpPr>
          <p:cNvPr id="167" name="Freeform 81">
            <a:extLst>
              <a:ext uri="{FF2B5EF4-FFF2-40B4-BE49-F238E27FC236}">
                <a16:creationId xmlns:a16="http://schemas.microsoft.com/office/drawing/2014/main" id="{5B5693A7-3F6D-48E6-9623-18D295A17E05}"/>
              </a:ext>
            </a:extLst>
          </p:cNvPr>
          <p:cNvSpPr/>
          <p:nvPr/>
        </p:nvSpPr>
        <p:spPr>
          <a:xfrm>
            <a:off x="4316291" y="2470308"/>
            <a:ext cx="1665952" cy="1133911"/>
          </a:xfrm>
          <a:custGeom>
            <a:avLst/>
            <a:gdLst/>
            <a:ahLst/>
            <a:cxnLst/>
            <a:rect l="l" t="t" r="r" b="b"/>
            <a:pathLst>
              <a:path w="2318955" h="1578370">
                <a:moveTo>
                  <a:pt x="0" y="0"/>
                </a:moveTo>
                <a:lnTo>
                  <a:pt x="2318955" y="0"/>
                </a:lnTo>
                <a:lnTo>
                  <a:pt x="2318955" y="1578370"/>
                </a:lnTo>
                <a:lnTo>
                  <a:pt x="0" y="1578370"/>
                </a:lnTo>
                <a:close/>
              </a:path>
            </a:pathLst>
          </a:custGeom>
          <a:noFill/>
          <a:ln w="4628">
            <a:solidFill>
              <a:srgbClr val="00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/>
          </a:p>
        </p:txBody>
      </p:sp>
      <p:pic>
        <p:nvPicPr>
          <p:cNvPr id="173" name="Picture 172" descr="image.png">
            <a:extLst>
              <a:ext uri="{FF2B5EF4-FFF2-40B4-BE49-F238E27FC236}">
                <a16:creationId xmlns:a16="http://schemas.microsoft.com/office/drawing/2014/main" id="{90A86EA0-7AC7-4A17-8B62-2DA0F84245C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14870" y="2471970"/>
            <a:ext cx="99757" cy="1127260"/>
          </a:xfrm>
          <a:prstGeom prst="rect">
            <a:avLst/>
          </a:prstGeom>
        </p:spPr>
      </p:pic>
      <p:grpSp>
        <p:nvGrpSpPr>
          <p:cNvPr id="174" name="Group 173">
            <a:extLst>
              <a:ext uri="{FF2B5EF4-FFF2-40B4-BE49-F238E27FC236}">
                <a16:creationId xmlns:a16="http://schemas.microsoft.com/office/drawing/2014/main" id="{E41C1660-62EE-4350-8F24-ABCD27404BB4}"/>
              </a:ext>
            </a:extLst>
          </p:cNvPr>
          <p:cNvGrpSpPr/>
          <p:nvPr/>
        </p:nvGrpSpPr>
        <p:grpSpPr>
          <a:xfrm>
            <a:off x="4172477" y="2441317"/>
            <a:ext cx="73052" cy="1158747"/>
            <a:chOff x="281829" y="4815112"/>
            <a:chExt cx="101686" cy="1612940"/>
          </a:xfrm>
        </p:grpSpPr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id="{59326437-87CC-46F0-B85E-598359813664}"/>
                </a:ext>
              </a:extLst>
            </p:cNvPr>
            <p:cNvSpPr txBox="1"/>
            <p:nvPr/>
          </p:nvSpPr>
          <p:spPr>
            <a:xfrm>
              <a:off x="314230" y="6384298"/>
              <a:ext cx="68706" cy="43754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>
                  <a:solidFill>
                    <a:srgbClr val="000000"/>
                  </a:solidFill>
                  <a:latin typeface="Noto Sans SemCond Light"/>
                </a:rPr>
                <a:t>0.0</a:t>
              </a:r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3466F1B9-3888-4514-A94A-40CD6DD745D8}"/>
                </a:ext>
              </a:extLst>
            </p:cNvPr>
            <p:cNvSpPr txBox="1"/>
            <p:nvPr/>
          </p:nvSpPr>
          <p:spPr>
            <a:xfrm>
              <a:off x="304973" y="5996431"/>
              <a:ext cx="78542" cy="42814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>
                  <a:solidFill>
                    <a:srgbClr val="000000"/>
                  </a:solidFill>
                  <a:latin typeface="Noto Sans SemCond Light"/>
                </a:rPr>
                <a:t>411</a:t>
              </a:r>
            </a:p>
          </p:txBody>
        </p: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id="{7D07786F-F04D-4D17-8C81-CBC431E1C76E}"/>
                </a:ext>
              </a:extLst>
            </p:cNvPr>
            <p:cNvSpPr txBox="1"/>
            <p:nvPr/>
          </p:nvSpPr>
          <p:spPr>
            <a:xfrm>
              <a:off x="295716" y="5602055"/>
              <a:ext cx="85340" cy="43754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 dirty="0">
                  <a:solidFill>
                    <a:srgbClr val="000000"/>
                  </a:solidFill>
                  <a:latin typeface="Noto Sans SemCond Light"/>
                </a:rPr>
                <a:t>822</a:t>
              </a:r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24BF0DF5-8434-4CCF-8D3A-BF677DD11F47}"/>
                </a:ext>
              </a:extLst>
            </p:cNvPr>
            <p:cNvSpPr txBox="1"/>
            <p:nvPr/>
          </p:nvSpPr>
          <p:spPr>
            <a:xfrm>
              <a:off x="281829" y="5208620"/>
              <a:ext cx="101034" cy="43754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 dirty="0">
                  <a:solidFill>
                    <a:srgbClr val="000000"/>
                  </a:solidFill>
                  <a:latin typeface="Noto Sans SemCond Light"/>
                </a:rPr>
                <a:t>1.2K</a:t>
              </a: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id="{BED917B2-B100-4980-A16B-6185E9EEBB12}"/>
                </a:ext>
              </a:extLst>
            </p:cNvPr>
            <p:cNvSpPr txBox="1"/>
            <p:nvPr/>
          </p:nvSpPr>
          <p:spPr>
            <a:xfrm>
              <a:off x="281829" y="4815112"/>
              <a:ext cx="101034" cy="43827"/>
            </a:xfrm>
            <a:prstGeom prst="rect">
              <a:avLst/>
            </a:prstGeom>
            <a:noFill/>
          </p:spPr>
          <p:txBody>
            <a:bodyPr wrap="none" lIns="0" tIns="0" rIns="0" bIns="0" anchor="t">
              <a:spAutoFit/>
            </a:bodyPr>
            <a:lstStyle/>
            <a:p>
              <a:pPr algn="l"/>
              <a:r>
                <a:rPr sz="469" dirty="0">
                  <a:solidFill>
                    <a:srgbClr val="000000"/>
                  </a:solidFill>
                  <a:latin typeface="Noto Sans SemCond Light"/>
                </a:rPr>
                <a:t>1.6K</a:t>
              </a:r>
            </a:p>
          </p:txBody>
        </p:sp>
      </p:grpSp>
      <p:sp>
        <p:nvSpPr>
          <p:cNvPr id="204" name="TextBox 203">
            <a:extLst>
              <a:ext uri="{FF2B5EF4-FFF2-40B4-BE49-F238E27FC236}">
                <a16:creationId xmlns:a16="http://schemas.microsoft.com/office/drawing/2014/main" id="{83C4B18C-60ED-4F16-A52C-EA9BF6D57758}"/>
              </a:ext>
            </a:extLst>
          </p:cNvPr>
          <p:cNvSpPr txBox="1"/>
          <p:nvPr/>
        </p:nvSpPr>
        <p:spPr>
          <a:xfrm>
            <a:off x="5085404" y="3661483"/>
            <a:ext cx="267702" cy="93102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lang="en-GB" sz="605" dirty="0">
                <a:solidFill>
                  <a:srgbClr val="000000"/>
                </a:solidFill>
                <a:latin typeface="Noto Sans Light"/>
              </a:rPr>
              <a:t>PHATE 1</a:t>
            </a:r>
            <a:endParaRPr sz="605" dirty="0">
              <a:solidFill>
                <a:srgbClr val="000000"/>
              </a:solidFill>
              <a:latin typeface="Noto Sans Light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D6A0BD6A-EB63-4C91-BAAE-58FC18308E65}"/>
              </a:ext>
            </a:extLst>
          </p:cNvPr>
          <p:cNvSpPr txBox="1"/>
          <p:nvPr/>
        </p:nvSpPr>
        <p:spPr>
          <a:xfrm rot="16200000">
            <a:off x="4027836" y="3033014"/>
            <a:ext cx="137701" cy="36831"/>
          </a:xfrm>
          <a:prstGeom prst="rect">
            <a:avLst/>
          </a:prstGeom>
          <a:noFill/>
        </p:spPr>
        <p:txBody>
          <a:bodyPr wrap="none" lIns="0" tIns="0" rIns="0" bIns="0" anchor="t">
            <a:spAutoFit/>
          </a:bodyPr>
          <a:lstStyle/>
          <a:p>
            <a:pPr algn="l"/>
            <a:r>
              <a:rPr sz="605" dirty="0">
                <a:solidFill>
                  <a:srgbClr val="000000"/>
                </a:solidFill>
                <a:latin typeface="Noto Sans Light"/>
              </a:rPr>
              <a:t>count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90C01DE0-D020-4F7C-B661-295A2F52B659}"/>
              </a:ext>
            </a:extLst>
          </p:cNvPr>
          <p:cNvSpPr txBox="1"/>
          <p:nvPr/>
        </p:nvSpPr>
        <p:spPr>
          <a:xfrm>
            <a:off x="248237" y="5176554"/>
            <a:ext cx="613522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6: Trajectory analysis of the multispectral flow cytometry data from platelets stimulated with tetramer nanobodies to GPVI (Nb2-2-Fc), CLEC-2 (LUAS-2-Fc) and PEAR-1 (Nb138-2-Fc). </a:t>
            </a:r>
          </a:p>
          <a:p>
            <a:r>
              <a:rPr lang="en-GB" sz="1200" dirty="0"/>
              <a:t>The single cell mapping algorithm PHATE was used to visualize the progression of platelet activation marker exposure. Top row: Data plotted PHATE vs count, with count scaled differently for each population to aid visualisation of order of populations. Bottom row: Data plotted PHATE vs count, with one scale for count to allow visualisation of population sizes. N=5. </a:t>
            </a:r>
            <a:endParaRPr lang="en-IE" sz="1200" b="1" dirty="0"/>
          </a:p>
        </p:txBody>
      </p:sp>
    </p:spTree>
    <p:extLst>
      <p:ext uri="{BB962C8B-B14F-4D97-AF65-F5344CB8AC3E}">
        <p14:creationId xmlns:p14="http://schemas.microsoft.com/office/powerpoint/2010/main" val="3776733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34</TotalTime>
  <Words>963</Words>
  <Application>Microsoft Office PowerPoint</Application>
  <PresentationFormat>A4 Paper (210x297 mm)</PresentationFormat>
  <Paragraphs>198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Arial</vt:lpstr>
      <vt:lpstr>Calibri</vt:lpstr>
      <vt:lpstr>Calibri Light</vt:lpstr>
      <vt:lpstr>Noto Sans Light</vt:lpstr>
      <vt:lpstr>Noto Sans Regular</vt:lpstr>
      <vt:lpstr>Noto Sans SemCond Light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Lamerton</dc:creator>
  <cp:lastModifiedBy>Rachel Lamerton</cp:lastModifiedBy>
  <cp:revision>21</cp:revision>
  <dcterms:created xsi:type="dcterms:W3CDTF">2025-03-27T08:20:34Z</dcterms:created>
  <dcterms:modified xsi:type="dcterms:W3CDTF">2025-08-25T10:55:43Z</dcterms:modified>
</cp:coreProperties>
</file>